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324" r:id="rId2"/>
  </p:sldIdLst>
  <p:sldSz cx="6858000" cy="9906000" type="A4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" userDrawn="1">
          <p15:clr>
            <a:srgbClr val="A4A3A4"/>
          </p15:clr>
        </p15:guide>
        <p15:guide id="2" pos="3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48235"/>
    <a:srgbClr val="517D33"/>
    <a:srgbClr val="6DA945"/>
    <a:srgbClr val="5B9BD5"/>
    <a:srgbClr val="385723"/>
    <a:srgbClr val="283F19"/>
    <a:srgbClr val="FFF048"/>
    <a:srgbClr val="C00000"/>
    <a:srgbClr val="CCF5CC"/>
    <a:srgbClr val="9DC3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67" autoAdjust="0"/>
    <p:restoredTop sz="96433" autoAdjust="0"/>
  </p:normalViewPr>
  <p:slideViewPr>
    <p:cSldViewPr snapToGrid="0">
      <p:cViewPr varScale="1">
        <p:scale>
          <a:sx n="88" d="100"/>
          <a:sy n="88" d="100"/>
        </p:scale>
        <p:origin x="2766" y="84"/>
      </p:cViewPr>
      <p:guideLst>
        <p:guide orient="horz" pos="104"/>
        <p:guide pos="3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9013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1440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7096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0347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4664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5597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0231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0647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1300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8018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38400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2093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ZoneTexte 320"/>
          <p:cNvSpPr txBox="1"/>
          <p:nvPr/>
        </p:nvSpPr>
        <p:spPr>
          <a:xfrm>
            <a:off x="2676814" y="3045515"/>
            <a:ext cx="3759362" cy="3616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700"/>
              </a:lnSpc>
            </a:pPr>
            <a:r>
              <a:rPr lang="fr-FR" sz="700" dirty="0" err="1" smtClean="0"/>
              <a:t>Integer</a:t>
            </a:r>
            <a:r>
              <a:rPr lang="fr-FR" sz="700" dirty="0" smtClean="0"/>
              <a:t> plasma </a:t>
            </a:r>
            <a:r>
              <a:rPr lang="fr-FR" sz="700" dirty="0"/>
              <a:t>membrane </a:t>
            </a:r>
            <a:r>
              <a:rPr lang="fr-FR" sz="700" dirty="0" smtClean="0"/>
              <a:t>                                       </a:t>
            </a:r>
            <a:r>
              <a:rPr lang="fr-FR" sz="700" dirty="0" err="1" smtClean="0"/>
              <a:t>Parasitophorous</a:t>
            </a:r>
            <a:r>
              <a:rPr lang="fr-FR" sz="700" dirty="0" smtClean="0"/>
              <a:t> </a:t>
            </a:r>
            <a:r>
              <a:rPr lang="fr-FR" sz="700" dirty="0"/>
              <a:t>vacuole </a:t>
            </a:r>
            <a:r>
              <a:rPr lang="fr-FR" sz="700" dirty="0" smtClean="0"/>
              <a:t>(PV) membrane              </a:t>
            </a:r>
          </a:p>
          <a:p>
            <a:pPr>
              <a:lnSpc>
                <a:spcPts val="700"/>
              </a:lnSpc>
            </a:pPr>
            <a:endParaRPr lang="fr-FR" sz="700" dirty="0"/>
          </a:p>
          <a:p>
            <a:pPr>
              <a:lnSpc>
                <a:spcPts val="700"/>
              </a:lnSpc>
            </a:pPr>
            <a:r>
              <a:rPr lang="fr-FR" sz="700" dirty="0" err="1" smtClean="0"/>
              <a:t>Altered</a:t>
            </a:r>
            <a:r>
              <a:rPr lang="fr-FR" sz="700" dirty="0" smtClean="0"/>
              <a:t> plasma </a:t>
            </a:r>
            <a:r>
              <a:rPr lang="fr-FR" sz="700" dirty="0"/>
              <a:t>membrane         </a:t>
            </a:r>
            <a:r>
              <a:rPr lang="fr-FR" sz="700" dirty="0" smtClean="0"/>
              <a:t>                                </a:t>
            </a:r>
            <a:r>
              <a:rPr lang="fr-FR" sz="700" dirty="0" err="1" smtClean="0"/>
              <a:t>Altered</a:t>
            </a:r>
            <a:r>
              <a:rPr lang="fr-FR" sz="700" dirty="0" smtClean="0"/>
              <a:t> PV membrane</a:t>
            </a:r>
            <a:endParaRPr lang="fr-FR" sz="700" dirty="0"/>
          </a:p>
        </p:txBody>
      </p:sp>
      <p:grpSp>
        <p:nvGrpSpPr>
          <p:cNvPr id="322" name="Groupe 321"/>
          <p:cNvGrpSpPr/>
          <p:nvPr/>
        </p:nvGrpSpPr>
        <p:grpSpPr>
          <a:xfrm>
            <a:off x="2103201" y="2201090"/>
            <a:ext cx="473810" cy="578975"/>
            <a:chOff x="3145660" y="2099121"/>
            <a:chExt cx="637337" cy="680028"/>
          </a:xfrm>
        </p:grpSpPr>
        <p:grpSp>
          <p:nvGrpSpPr>
            <p:cNvPr id="323" name="Groupe 322"/>
            <p:cNvGrpSpPr/>
            <p:nvPr/>
          </p:nvGrpSpPr>
          <p:grpSpPr>
            <a:xfrm rot="5708885">
              <a:off x="3124315" y="2120466"/>
              <a:ext cx="680028" cy="637337"/>
              <a:chOff x="3558318" y="3349382"/>
              <a:chExt cx="972055" cy="896320"/>
            </a:xfrm>
          </p:grpSpPr>
          <p:grpSp>
            <p:nvGrpSpPr>
              <p:cNvPr id="330" name="Groupe 329"/>
              <p:cNvGrpSpPr/>
              <p:nvPr/>
            </p:nvGrpSpPr>
            <p:grpSpPr>
              <a:xfrm>
                <a:off x="3558318" y="3418518"/>
                <a:ext cx="972055" cy="827184"/>
                <a:chOff x="3609196" y="1373992"/>
                <a:chExt cx="1284023" cy="1151146"/>
              </a:xfrm>
            </p:grpSpPr>
            <p:sp>
              <p:nvSpPr>
                <p:cNvPr id="333" name="Forme libre 332"/>
                <p:cNvSpPr/>
                <p:nvPr/>
              </p:nvSpPr>
              <p:spPr>
                <a:xfrm>
                  <a:off x="3609196" y="1373992"/>
                  <a:ext cx="1284023" cy="1151146"/>
                </a:xfrm>
                <a:custGeom>
                  <a:avLst/>
                  <a:gdLst>
                    <a:gd name="connsiteX0" fmla="*/ 1245464 w 1694550"/>
                    <a:gd name="connsiteY0" fmla="*/ 229341 h 1996683"/>
                    <a:gd name="connsiteX1" fmla="*/ 737464 w 1694550"/>
                    <a:gd name="connsiteY1" fmla="*/ 3563 h 1996683"/>
                    <a:gd name="connsiteX2" fmla="*/ 410086 w 1694550"/>
                    <a:gd name="connsiteY2" fmla="*/ 116452 h 1996683"/>
                    <a:gd name="connsiteX3" fmla="*/ 342353 w 1694550"/>
                    <a:gd name="connsiteY3" fmla="*/ 443830 h 1996683"/>
                    <a:gd name="connsiteX4" fmla="*/ 14975 w 1694550"/>
                    <a:gd name="connsiteY4" fmla="*/ 726052 h 1996683"/>
                    <a:gd name="connsiteX5" fmla="*/ 161730 w 1694550"/>
                    <a:gd name="connsiteY5" fmla="*/ 1301786 h 1996683"/>
                    <a:gd name="connsiteX6" fmla="*/ 14975 w 1694550"/>
                    <a:gd name="connsiteY6" fmla="*/ 1640452 h 1996683"/>
                    <a:gd name="connsiteX7" fmla="*/ 601997 w 1694550"/>
                    <a:gd name="connsiteY7" fmla="*/ 1617875 h 1996683"/>
                    <a:gd name="connsiteX8" fmla="*/ 624575 w 1694550"/>
                    <a:gd name="connsiteY8" fmla="*/ 1922675 h 1996683"/>
                    <a:gd name="connsiteX9" fmla="*/ 997108 w 1694550"/>
                    <a:gd name="connsiteY9" fmla="*/ 1967830 h 1996683"/>
                    <a:gd name="connsiteX10" fmla="*/ 1200308 w 1694550"/>
                    <a:gd name="connsiteY10" fmla="*/ 1550141 h 1996683"/>
                    <a:gd name="connsiteX11" fmla="*/ 1335775 w 1694550"/>
                    <a:gd name="connsiteY11" fmla="*/ 1369519 h 1996683"/>
                    <a:gd name="connsiteX12" fmla="*/ 1685730 w 1694550"/>
                    <a:gd name="connsiteY12" fmla="*/ 1132452 h 1996683"/>
                    <a:gd name="connsiteX13" fmla="*/ 1595419 w 1694550"/>
                    <a:gd name="connsiteY13" fmla="*/ 771208 h 1996683"/>
                    <a:gd name="connsiteX14" fmla="*/ 1663153 w 1694550"/>
                    <a:gd name="connsiteY14" fmla="*/ 398675 h 1996683"/>
                    <a:gd name="connsiteX15" fmla="*/ 1245464 w 1694550"/>
                    <a:gd name="connsiteY15" fmla="*/ 229341 h 1996683"/>
                    <a:gd name="connsiteX0" fmla="*/ 1245464 w 1694550"/>
                    <a:gd name="connsiteY0" fmla="*/ 124321 h 1891663"/>
                    <a:gd name="connsiteX1" fmla="*/ 782620 w 1694550"/>
                    <a:gd name="connsiteY1" fmla="*/ 79165 h 1891663"/>
                    <a:gd name="connsiteX2" fmla="*/ 410086 w 1694550"/>
                    <a:gd name="connsiteY2" fmla="*/ 11432 h 1891663"/>
                    <a:gd name="connsiteX3" fmla="*/ 342353 w 1694550"/>
                    <a:gd name="connsiteY3" fmla="*/ 338810 h 1891663"/>
                    <a:gd name="connsiteX4" fmla="*/ 14975 w 1694550"/>
                    <a:gd name="connsiteY4" fmla="*/ 621032 h 1891663"/>
                    <a:gd name="connsiteX5" fmla="*/ 161730 w 1694550"/>
                    <a:gd name="connsiteY5" fmla="*/ 1196766 h 1891663"/>
                    <a:gd name="connsiteX6" fmla="*/ 14975 w 1694550"/>
                    <a:gd name="connsiteY6" fmla="*/ 1535432 h 1891663"/>
                    <a:gd name="connsiteX7" fmla="*/ 601997 w 1694550"/>
                    <a:gd name="connsiteY7" fmla="*/ 1512855 h 1891663"/>
                    <a:gd name="connsiteX8" fmla="*/ 624575 w 1694550"/>
                    <a:gd name="connsiteY8" fmla="*/ 1817655 h 1891663"/>
                    <a:gd name="connsiteX9" fmla="*/ 997108 w 1694550"/>
                    <a:gd name="connsiteY9" fmla="*/ 1862810 h 1891663"/>
                    <a:gd name="connsiteX10" fmla="*/ 1200308 w 1694550"/>
                    <a:gd name="connsiteY10" fmla="*/ 1445121 h 1891663"/>
                    <a:gd name="connsiteX11" fmla="*/ 1335775 w 1694550"/>
                    <a:gd name="connsiteY11" fmla="*/ 1264499 h 1891663"/>
                    <a:gd name="connsiteX12" fmla="*/ 1685730 w 1694550"/>
                    <a:gd name="connsiteY12" fmla="*/ 1027432 h 1891663"/>
                    <a:gd name="connsiteX13" fmla="*/ 1595419 w 1694550"/>
                    <a:gd name="connsiteY13" fmla="*/ 666188 h 1891663"/>
                    <a:gd name="connsiteX14" fmla="*/ 1663153 w 1694550"/>
                    <a:gd name="connsiteY14" fmla="*/ 293655 h 1891663"/>
                    <a:gd name="connsiteX15" fmla="*/ 1245464 w 1694550"/>
                    <a:gd name="connsiteY15" fmla="*/ 124321 h 1891663"/>
                    <a:gd name="connsiteX0" fmla="*/ 782620 w 1694550"/>
                    <a:gd name="connsiteY0" fmla="*/ 79165 h 1891663"/>
                    <a:gd name="connsiteX1" fmla="*/ 410086 w 1694550"/>
                    <a:gd name="connsiteY1" fmla="*/ 11432 h 1891663"/>
                    <a:gd name="connsiteX2" fmla="*/ 342353 w 1694550"/>
                    <a:gd name="connsiteY2" fmla="*/ 338810 h 1891663"/>
                    <a:gd name="connsiteX3" fmla="*/ 14975 w 1694550"/>
                    <a:gd name="connsiteY3" fmla="*/ 621032 h 1891663"/>
                    <a:gd name="connsiteX4" fmla="*/ 161730 w 1694550"/>
                    <a:gd name="connsiteY4" fmla="*/ 1196766 h 1891663"/>
                    <a:gd name="connsiteX5" fmla="*/ 14975 w 1694550"/>
                    <a:gd name="connsiteY5" fmla="*/ 1535432 h 1891663"/>
                    <a:gd name="connsiteX6" fmla="*/ 601997 w 1694550"/>
                    <a:gd name="connsiteY6" fmla="*/ 1512855 h 1891663"/>
                    <a:gd name="connsiteX7" fmla="*/ 624575 w 1694550"/>
                    <a:gd name="connsiteY7" fmla="*/ 1817655 h 1891663"/>
                    <a:gd name="connsiteX8" fmla="*/ 997108 w 1694550"/>
                    <a:gd name="connsiteY8" fmla="*/ 1862810 h 1891663"/>
                    <a:gd name="connsiteX9" fmla="*/ 1200308 w 1694550"/>
                    <a:gd name="connsiteY9" fmla="*/ 1445121 h 1891663"/>
                    <a:gd name="connsiteX10" fmla="*/ 1335775 w 1694550"/>
                    <a:gd name="connsiteY10" fmla="*/ 1264499 h 1891663"/>
                    <a:gd name="connsiteX11" fmla="*/ 1685730 w 1694550"/>
                    <a:gd name="connsiteY11" fmla="*/ 1027432 h 1891663"/>
                    <a:gd name="connsiteX12" fmla="*/ 1595419 w 1694550"/>
                    <a:gd name="connsiteY12" fmla="*/ 666188 h 1891663"/>
                    <a:gd name="connsiteX13" fmla="*/ 1663153 w 1694550"/>
                    <a:gd name="connsiteY13" fmla="*/ 293655 h 1891663"/>
                    <a:gd name="connsiteX14" fmla="*/ 1245464 w 1694550"/>
                    <a:gd name="connsiteY14" fmla="*/ 124321 h 1891663"/>
                    <a:gd name="connsiteX15" fmla="*/ 874060 w 1694550"/>
                    <a:gd name="connsiteY15" fmla="*/ 170605 h 1891663"/>
                    <a:gd name="connsiteX0" fmla="*/ 816486 w 1694550"/>
                    <a:gd name="connsiteY0" fmla="*/ 150556 h 1884032"/>
                    <a:gd name="connsiteX1" fmla="*/ 410086 w 1694550"/>
                    <a:gd name="connsiteY1" fmla="*/ 3801 h 1884032"/>
                    <a:gd name="connsiteX2" fmla="*/ 342353 w 1694550"/>
                    <a:gd name="connsiteY2" fmla="*/ 331179 h 1884032"/>
                    <a:gd name="connsiteX3" fmla="*/ 14975 w 1694550"/>
                    <a:gd name="connsiteY3" fmla="*/ 613401 h 1884032"/>
                    <a:gd name="connsiteX4" fmla="*/ 161730 w 1694550"/>
                    <a:gd name="connsiteY4" fmla="*/ 1189135 h 1884032"/>
                    <a:gd name="connsiteX5" fmla="*/ 14975 w 1694550"/>
                    <a:gd name="connsiteY5" fmla="*/ 1527801 h 1884032"/>
                    <a:gd name="connsiteX6" fmla="*/ 601997 w 1694550"/>
                    <a:gd name="connsiteY6" fmla="*/ 1505224 h 1884032"/>
                    <a:gd name="connsiteX7" fmla="*/ 624575 w 1694550"/>
                    <a:gd name="connsiteY7" fmla="*/ 1810024 h 1884032"/>
                    <a:gd name="connsiteX8" fmla="*/ 997108 w 1694550"/>
                    <a:gd name="connsiteY8" fmla="*/ 1855179 h 1884032"/>
                    <a:gd name="connsiteX9" fmla="*/ 1200308 w 1694550"/>
                    <a:gd name="connsiteY9" fmla="*/ 1437490 h 1884032"/>
                    <a:gd name="connsiteX10" fmla="*/ 1335775 w 1694550"/>
                    <a:gd name="connsiteY10" fmla="*/ 1256868 h 1884032"/>
                    <a:gd name="connsiteX11" fmla="*/ 1685730 w 1694550"/>
                    <a:gd name="connsiteY11" fmla="*/ 1019801 h 1884032"/>
                    <a:gd name="connsiteX12" fmla="*/ 1595419 w 1694550"/>
                    <a:gd name="connsiteY12" fmla="*/ 658557 h 1884032"/>
                    <a:gd name="connsiteX13" fmla="*/ 1663153 w 1694550"/>
                    <a:gd name="connsiteY13" fmla="*/ 286024 h 1884032"/>
                    <a:gd name="connsiteX14" fmla="*/ 1245464 w 1694550"/>
                    <a:gd name="connsiteY14" fmla="*/ 116690 h 1884032"/>
                    <a:gd name="connsiteX15" fmla="*/ 874060 w 1694550"/>
                    <a:gd name="connsiteY15" fmla="*/ 162974 h 1884032"/>
                    <a:gd name="connsiteX0" fmla="*/ 816486 w 1694550"/>
                    <a:gd name="connsiteY0" fmla="*/ 150556 h 1884032"/>
                    <a:gd name="connsiteX1" fmla="*/ 410086 w 1694550"/>
                    <a:gd name="connsiteY1" fmla="*/ 3801 h 1884032"/>
                    <a:gd name="connsiteX2" fmla="*/ 342353 w 1694550"/>
                    <a:gd name="connsiteY2" fmla="*/ 331179 h 1884032"/>
                    <a:gd name="connsiteX3" fmla="*/ 14975 w 1694550"/>
                    <a:gd name="connsiteY3" fmla="*/ 613401 h 1884032"/>
                    <a:gd name="connsiteX4" fmla="*/ 161730 w 1694550"/>
                    <a:gd name="connsiteY4" fmla="*/ 1189135 h 1884032"/>
                    <a:gd name="connsiteX5" fmla="*/ 14975 w 1694550"/>
                    <a:gd name="connsiteY5" fmla="*/ 1527801 h 1884032"/>
                    <a:gd name="connsiteX6" fmla="*/ 601997 w 1694550"/>
                    <a:gd name="connsiteY6" fmla="*/ 1505224 h 1884032"/>
                    <a:gd name="connsiteX7" fmla="*/ 624575 w 1694550"/>
                    <a:gd name="connsiteY7" fmla="*/ 1810024 h 1884032"/>
                    <a:gd name="connsiteX8" fmla="*/ 997108 w 1694550"/>
                    <a:gd name="connsiteY8" fmla="*/ 1855179 h 1884032"/>
                    <a:gd name="connsiteX9" fmla="*/ 1200308 w 1694550"/>
                    <a:gd name="connsiteY9" fmla="*/ 1437490 h 1884032"/>
                    <a:gd name="connsiteX10" fmla="*/ 1335775 w 1694550"/>
                    <a:gd name="connsiteY10" fmla="*/ 1256868 h 1884032"/>
                    <a:gd name="connsiteX11" fmla="*/ 1685730 w 1694550"/>
                    <a:gd name="connsiteY11" fmla="*/ 1019801 h 1884032"/>
                    <a:gd name="connsiteX12" fmla="*/ 1595419 w 1694550"/>
                    <a:gd name="connsiteY12" fmla="*/ 658557 h 1884032"/>
                    <a:gd name="connsiteX13" fmla="*/ 1663153 w 1694550"/>
                    <a:gd name="connsiteY13" fmla="*/ 286024 h 1884032"/>
                    <a:gd name="connsiteX14" fmla="*/ 1245464 w 1694550"/>
                    <a:gd name="connsiteY14" fmla="*/ 116690 h 1884032"/>
                    <a:gd name="connsiteX15" fmla="*/ 964371 w 1694550"/>
                    <a:gd name="connsiteY15" fmla="*/ 309729 h 1884032"/>
                    <a:gd name="connsiteX0" fmla="*/ 748753 w 1694550"/>
                    <a:gd name="connsiteY0" fmla="*/ 282376 h 1880385"/>
                    <a:gd name="connsiteX1" fmla="*/ 410086 w 1694550"/>
                    <a:gd name="connsiteY1" fmla="*/ 154 h 1880385"/>
                    <a:gd name="connsiteX2" fmla="*/ 342353 w 1694550"/>
                    <a:gd name="connsiteY2" fmla="*/ 327532 h 1880385"/>
                    <a:gd name="connsiteX3" fmla="*/ 14975 w 1694550"/>
                    <a:gd name="connsiteY3" fmla="*/ 609754 h 1880385"/>
                    <a:gd name="connsiteX4" fmla="*/ 161730 w 1694550"/>
                    <a:gd name="connsiteY4" fmla="*/ 1185488 h 1880385"/>
                    <a:gd name="connsiteX5" fmla="*/ 14975 w 1694550"/>
                    <a:gd name="connsiteY5" fmla="*/ 1524154 h 1880385"/>
                    <a:gd name="connsiteX6" fmla="*/ 601997 w 1694550"/>
                    <a:gd name="connsiteY6" fmla="*/ 1501577 h 1880385"/>
                    <a:gd name="connsiteX7" fmla="*/ 624575 w 1694550"/>
                    <a:gd name="connsiteY7" fmla="*/ 1806377 h 1880385"/>
                    <a:gd name="connsiteX8" fmla="*/ 997108 w 1694550"/>
                    <a:gd name="connsiteY8" fmla="*/ 1851532 h 1880385"/>
                    <a:gd name="connsiteX9" fmla="*/ 1200308 w 1694550"/>
                    <a:gd name="connsiteY9" fmla="*/ 1433843 h 1880385"/>
                    <a:gd name="connsiteX10" fmla="*/ 1335775 w 1694550"/>
                    <a:gd name="connsiteY10" fmla="*/ 1253221 h 1880385"/>
                    <a:gd name="connsiteX11" fmla="*/ 1685730 w 1694550"/>
                    <a:gd name="connsiteY11" fmla="*/ 1016154 h 1880385"/>
                    <a:gd name="connsiteX12" fmla="*/ 1595419 w 1694550"/>
                    <a:gd name="connsiteY12" fmla="*/ 654910 h 1880385"/>
                    <a:gd name="connsiteX13" fmla="*/ 1663153 w 1694550"/>
                    <a:gd name="connsiteY13" fmla="*/ 282377 h 1880385"/>
                    <a:gd name="connsiteX14" fmla="*/ 1245464 w 1694550"/>
                    <a:gd name="connsiteY14" fmla="*/ 113043 h 1880385"/>
                    <a:gd name="connsiteX15" fmla="*/ 964371 w 1694550"/>
                    <a:gd name="connsiteY15" fmla="*/ 306082 h 1880385"/>
                    <a:gd name="connsiteX0" fmla="*/ 748753 w 1694550"/>
                    <a:gd name="connsiteY0" fmla="*/ 338679 h 1880243"/>
                    <a:gd name="connsiteX1" fmla="*/ 410086 w 1694550"/>
                    <a:gd name="connsiteY1" fmla="*/ 12 h 1880243"/>
                    <a:gd name="connsiteX2" fmla="*/ 342353 w 1694550"/>
                    <a:gd name="connsiteY2" fmla="*/ 327390 h 1880243"/>
                    <a:gd name="connsiteX3" fmla="*/ 14975 w 1694550"/>
                    <a:gd name="connsiteY3" fmla="*/ 609612 h 1880243"/>
                    <a:gd name="connsiteX4" fmla="*/ 161730 w 1694550"/>
                    <a:gd name="connsiteY4" fmla="*/ 1185346 h 1880243"/>
                    <a:gd name="connsiteX5" fmla="*/ 14975 w 1694550"/>
                    <a:gd name="connsiteY5" fmla="*/ 1524012 h 1880243"/>
                    <a:gd name="connsiteX6" fmla="*/ 601997 w 1694550"/>
                    <a:gd name="connsiteY6" fmla="*/ 1501435 h 1880243"/>
                    <a:gd name="connsiteX7" fmla="*/ 624575 w 1694550"/>
                    <a:gd name="connsiteY7" fmla="*/ 1806235 h 1880243"/>
                    <a:gd name="connsiteX8" fmla="*/ 997108 w 1694550"/>
                    <a:gd name="connsiteY8" fmla="*/ 1851390 h 1880243"/>
                    <a:gd name="connsiteX9" fmla="*/ 1200308 w 1694550"/>
                    <a:gd name="connsiteY9" fmla="*/ 1433701 h 1880243"/>
                    <a:gd name="connsiteX10" fmla="*/ 1335775 w 1694550"/>
                    <a:gd name="connsiteY10" fmla="*/ 1253079 h 1880243"/>
                    <a:gd name="connsiteX11" fmla="*/ 1685730 w 1694550"/>
                    <a:gd name="connsiteY11" fmla="*/ 1016012 h 1880243"/>
                    <a:gd name="connsiteX12" fmla="*/ 1595419 w 1694550"/>
                    <a:gd name="connsiteY12" fmla="*/ 654768 h 1880243"/>
                    <a:gd name="connsiteX13" fmla="*/ 1663153 w 1694550"/>
                    <a:gd name="connsiteY13" fmla="*/ 282235 h 1880243"/>
                    <a:gd name="connsiteX14" fmla="*/ 1245464 w 1694550"/>
                    <a:gd name="connsiteY14" fmla="*/ 112901 h 1880243"/>
                    <a:gd name="connsiteX15" fmla="*/ 964371 w 1694550"/>
                    <a:gd name="connsiteY15" fmla="*/ 305940 h 1880243"/>
                    <a:gd name="connsiteX0" fmla="*/ 748753 w 1694550"/>
                    <a:gd name="connsiteY0" fmla="*/ 225909 h 1767473"/>
                    <a:gd name="connsiteX1" fmla="*/ 493212 w 1694550"/>
                    <a:gd name="connsiteY1" fmla="*/ 150401 h 1767473"/>
                    <a:gd name="connsiteX2" fmla="*/ 342353 w 1694550"/>
                    <a:gd name="connsiteY2" fmla="*/ 214620 h 1767473"/>
                    <a:gd name="connsiteX3" fmla="*/ 14975 w 1694550"/>
                    <a:gd name="connsiteY3" fmla="*/ 496842 h 1767473"/>
                    <a:gd name="connsiteX4" fmla="*/ 161730 w 1694550"/>
                    <a:gd name="connsiteY4" fmla="*/ 1072576 h 1767473"/>
                    <a:gd name="connsiteX5" fmla="*/ 14975 w 1694550"/>
                    <a:gd name="connsiteY5" fmla="*/ 1411242 h 1767473"/>
                    <a:gd name="connsiteX6" fmla="*/ 601997 w 1694550"/>
                    <a:gd name="connsiteY6" fmla="*/ 1388665 h 1767473"/>
                    <a:gd name="connsiteX7" fmla="*/ 624575 w 1694550"/>
                    <a:gd name="connsiteY7" fmla="*/ 1693465 h 1767473"/>
                    <a:gd name="connsiteX8" fmla="*/ 997108 w 1694550"/>
                    <a:gd name="connsiteY8" fmla="*/ 1738620 h 1767473"/>
                    <a:gd name="connsiteX9" fmla="*/ 1200308 w 1694550"/>
                    <a:gd name="connsiteY9" fmla="*/ 1320931 h 1767473"/>
                    <a:gd name="connsiteX10" fmla="*/ 1335775 w 1694550"/>
                    <a:gd name="connsiteY10" fmla="*/ 1140309 h 1767473"/>
                    <a:gd name="connsiteX11" fmla="*/ 1685730 w 1694550"/>
                    <a:gd name="connsiteY11" fmla="*/ 903242 h 1767473"/>
                    <a:gd name="connsiteX12" fmla="*/ 1595419 w 1694550"/>
                    <a:gd name="connsiteY12" fmla="*/ 541998 h 1767473"/>
                    <a:gd name="connsiteX13" fmla="*/ 1663153 w 1694550"/>
                    <a:gd name="connsiteY13" fmla="*/ 169465 h 1767473"/>
                    <a:gd name="connsiteX14" fmla="*/ 1245464 w 1694550"/>
                    <a:gd name="connsiteY14" fmla="*/ 131 h 1767473"/>
                    <a:gd name="connsiteX15" fmla="*/ 964371 w 1694550"/>
                    <a:gd name="connsiteY15" fmla="*/ 193170 h 1767473"/>
                    <a:gd name="connsiteX0" fmla="*/ 738443 w 1684240"/>
                    <a:gd name="connsiteY0" fmla="*/ 225909 h 1767473"/>
                    <a:gd name="connsiteX1" fmla="*/ 482902 w 1684240"/>
                    <a:gd name="connsiteY1" fmla="*/ 150401 h 1767473"/>
                    <a:gd name="connsiteX2" fmla="*/ 332043 w 1684240"/>
                    <a:gd name="connsiteY2" fmla="*/ 214620 h 1767473"/>
                    <a:gd name="connsiteX3" fmla="*/ 4665 w 1684240"/>
                    <a:gd name="connsiteY3" fmla="*/ 496842 h 1767473"/>
                    <a:gd name="connsiteX4" fmla="*/ 151420 w 1684240"/>
                    <a:gd name="connsiteY4" fmla="*/ 1072576 h 1767473"/>
                    <a:gd name="connsiteX5" fmla="*/ 325300 w 1684240"/>
                    <a:gd name="connsiteY5" fmla="*/ 1248334 h 1767473"/>
                    <a:gd name="connsiteX6" fmla="*/ 591687 w 1684240"/>
                    <a:gd name="connsiteY6" fmla="*/ 1388665 h 1767473"/>
                    <a:gd name="connsiteX7" fmla="*/ 614265 w 1684240"/>
                    <a:gd name="connsiteY7" fmla="*/ 1693465 h 1767473"/>
                    <a:gd name="connsiteX8" fmla="*/ 986798 w 1684240"/>
                    <a:gd name="connsiteY8" fmla="*/ 1738620 h 1767473"/>
                    <a:gd name="connsiteX9" fmla="*/ 1189998 w 1684240"/>
                    <a:gd name="connsiteY9" fmla="*/ 1320931 h 1767473"/>
                    <a:gd name="connsiteX10" fmla="*/ 1325465 w 1684240"/>
                    <a:gd name="connsiteY10" fmla="*/ 1140309 h 1767473"/>
                    <a:gd name="connsiteX11" fmla="*/ 1675420 w 1684240"/>
                    <a:gd name="connsiteY11" fmla="*/ 903242 h 1767473"/>
                    <a:gd name="connsiteX12" fmla="*/ 1585109 w 1684240"/>
                    <a:gd name="connsiteY12" fmla="*/ 541998 h 1767473"/>
                    <a:gd name="connsiteX13" fmla="*/ 1652843 w 1684240"/>
                    <a:gd name="connsiteY13" fmla="*/ 169465 h 1767473"/>
                    <a:gd name="connsiteX14" fmla="*/ 1235154 w 1684240"/>
                    <a:gd name="connsiteY14" fmla="*/ 131 h 1767473"/>
                    <a:gd name="connsiteX15" fmla="*/ 954061 w 1684240"/>
                    <a:gd name="connsiteY15" fmla="*/ 193170 h 1767473"/>
                    <a:gd name="connsiteX0" fmla="*/ 738443 w 1684240"/>
                    <a:gd name="connsiteY0" fmla="*/ 225909 h 1746659"/>
                    <a:gd name="connsiteX1" fmla="*/ 482902 w 1684240"/>
                    <a:gd name="connsiteY1" fmla="*/ 150401 h 1746659"/>
                    <a:gd name="connsiteX2" fmla="*/ 332043 w 1684240"/>
                    <a:gd name="connsiteY2" fmla="*/ 214620 h 1746659"/>
                    <a:gd name="connsiteX3" fmla="*/ 4665 w 1684240"/>
                    <a:gd name="connsiteY3" fmla="*/ 496842 h 1746659"/>
                    <a:gd name="connsiteX4" fmla="*/ 151420 w 1684240"/>
                    <a:gd name="connsiteY4" fmla="*/ 1072576 h 1746659"/>
                    <a:gd name="connsiteX5" fmla="*/ 325300 w 1684240"/>
                    <a:gd name="connsiteY5" fmla="*/ 1248334 h 1746659"/>
                    <a:gd name="connsiteX6" fmla="*/ 591687 w 1684240"/>
                    <a:gd name="connsiteY6" fmla="*/ 1388665 h 1746659"/>
                    <a:gd name="connsiteX7" fmla="*/ 804269 w 1684240"/>
                    <a:gd name="connsiteY7" fmla="*/ 1580681 h 1746659"/>
                    <a:gd name="connsiteX8" fmla="*/ 986798 w 1684240"/>
                    <a:gd name="connsiteY8" fmla="*/ 1738620 h 1746659"/>
                    <a:gd name="connsiteX9" fmla="*/ 1189998 w 1684240"/>
                    <a:gd name="connsiteY9" fmla="*/ 1320931 h 1746659"/>
                    <a:gd name="connsiteX10" fmla="*/ 1325465 w 1684240"/>
                    <a:gd name="connsiteY10" fmla="*/ 1140309 h 1746659"/>
                    <a:gd name="connsiteX11" fmla="*/ 1675420 w 1684240"/>
                    <a:gd name="connsiteY11" fmla="*/ 903242 h 1746659"/>
                    <a:gd name="connsiteX12" fmla="*/ 1585109 w 1684240"/>
                    <a:gd name="connsiteY12" fmla="*/ 541998 h 1746659"/>
                    <a:gd name="connsiteX13" fmla="*/ 1652843 w 1684240"/>
                    <a:gd name="connsiteY13" fmla="*/ 169465 h 1746659"/>
                    <a:gd name="connsiteX14" fmla="*/ 1235154 w 1684240"/>
                    <a:gd name="connsiteY14" fmla="*/ 131 h 1746659"/>
                    <a:gd name="connsiteX15" fmla="*/ 954061 w 1684240"/>
                    <a:gd name="connsiteY15" fmla="*/ 193170 h 1746659"/>
                    <a:gd name="connsiteX0" fmla="*/ 738443 w 1684240"/>
                    <a:gd name="connsiteY0" fmla="*/ 225909 h 1590718"/>
                    <a:gd name="connsiteX1" fmla="*/ 482902 w 1684240"/>
                    <a:gd name="connsiteY1" fmla="*/ 150401 h 1590718"/>
                    <a:gd name="connsiteX2" fmla="*/ 332043 w 1684240"/>
                    <a:gd name="connsiteY2" fmla="*/ 214620 h 1590718"/>
                    <a:gd name="connsiteX3" fmla="*/ 4665 w 1684240"/>
                    <a:gd name="connsiteY3" fmla="*/ 496842 h 1590718"/>
                    <a:gd name="connsiteX4" fmla="*/ 151420 w 1684240"/>
                    <a:gd name="connsiteY4" fmla="*/ 1072576 h 1590718"/>
                    <a:gd name="connsiteX5" fmla="*/ 325300 w 1684240"/>
                    <a:gd name="connsiteY5" fmla="*/ 1248334 h 1590718"/>
                    <a:gd name="connsiteX6" fmla="*/ 591687 w 1684240"/>
                    <a:gd name="connsiteY6" fmla="*/ 1388665 h 1590718"/>
                    <a:gd name="connsiteX7" fmla="*/ 804269 w 1684240"/>
                    <a:gd name="connsiteY7" fmla="*/ 1580681 h 1590718"/>
                    <a:gd name="connsiteX8" fmla="*/ 927421 w 1684240"/>
                    <a:gd name="connsiteY8" fmla="*/ 1538118 h 1590718"/>
                    <a:gd name="connsiteX9" fmla="*/ 1189998 w 1684240"/>
                    <a:gd name="connsiteY9" fmla="*/ 1320931 h 1590718"/>
                    <a:gd name="connsiteX10" fmla="*/ 1325465 w 1684240"/>
                    <a:gd name="connsiteY10" fmla="*/ 1140309 h 1590718"/>
                    <a:gd name="connsiteX11" fmla="*/ 1675420 w 1684240"/>
                    <a:gd name="connsiteY11" fmla="*/ 903242 h 1590718"/>
                    <a:gd name="connsiteX12" fmla="*/ 1585109 w 1684240"/>
                    <a:gd name="connsiteY12" fmla="*/ 541998 h 1590718"/>
                    <a:gd name="connsiteX13" fmla="*/ 1652843 w 1684240"/>
                    <a:gd name="connsiteY13" fmla="*/ 169465 h 1590718"/>
                    <a:gd name="connsiteX14" fmla="*/ 1235154 w 1684240"/>
                    <a:gd name="connsiteY14" fmla="*/ 131 h 1590718"/>
                    <a:gd name="connsiteX15" fmla="*/ 954061 w 1684240"/>
                    <a:gd name="connsiteY15" fmla="*/ 193170 h 1590718"/>
                    <a:gd name="connsiteX0" fmla="*/ 774070 w 1684240"/>
                    <a:gd name="connsiteY0" fmla="*/ 113127 h 1590717"/>
                    <a:gd name="connsiteX1" fmla="*/ 482902 w 1684240"/>
                    <a:gd name="connsiteY1" fmla="*/ 150401 h 1590717"/>
                    <a:gd name="connsiteX2" fmla="*/ 332043 w 1684240"/>
                    <a:gd name="connsiteY2" fmla="*/ 214620 h 1590717"/>
                    <a:gd name="connsiteX3" fmla="*/ 4665 w 1684240"/>
                    <a:gd name="connsiteY3" fmla="*/ 496842 h 1590717"/>
                    <a:gd name="connsiteX4" fmla="*/ 151420 w 1684240"/>
                    <a:gd name="connsiteY4" fmla="*/ 1072576 h 1590717"/>
                    <a:gd name="connsiteX5" fmla="*/ 325300 w 1684240"/>
                    <a:gd name="connsiteY5" fmla="*/ 1248334 h 1590717"/>
                    <a:gd name="connsiteX6" fmla="*/ 591687 w 1684240"/>
                    <a:gd name="connsiteY6" fmla="*/ 1388665 h 1590717"/>
                    <a:gd name="connsiteX7" fmla="*/ 804269 w 1684240"/>
                    <a:gd name="connsiteY7" fmla="*/ 1580681 h 1590717"/>
                    <a:gd name="connsiteX8" fmla="*/ 927421 w 1684240"/>
                    <a:gd name="connsiteY8" fmla="*/ 1538118 h 1590717"/>
                    <a:gd name="connsiteX9" fmla="*/ 1189998 w 1684240"/>
                    <a:gd name="connsiteY9" fmla="*/ 1320931 h 1590717"/>
                    <a:gd name="connsiteX10" fmla="*/ 1325465 w 1684240"/>
                    <a:gd name="connsiteY10" fmla="*/ 1140309 h 1590717"/>
                    <a:gd name="connsiteX11" fmla="*/ 1675420 w 1684240"/>
                    <a:gd name="connsiteY11" fmla="*/ 903242 h 1590717"/>
                    <a:gd name="connsiteX12" fmla="*/ 1585109 w 1684240"/>
                    <a:gd name="connsiteY12" fmla="*/ 541998 h 1590717"/>
                    <a:gd name="connsiteX13" fmla="*/ 1652843 w 1684240"/>
                    <a:gd name="connsiteY13" fmla="*/ 169465 h 1590717"/>
                    <a:gd name="connsiteX14" fmla="*/ 1235154 w 1684240"/>
                    <a:gd name="connsiteY14" fmla="*/ 131 h 1590717"/>
                    <a:gd name="connsiteX15" fmla="*/ 954061 w 1684240"/>
                    <a:gd name="connsiteY15" fmla="*/ 193170 h 1590717"/>
                    <a:gd name="connsiteX0" fmla="*/ 698166 w 1684240"/>
                    <a:gd name="connsiteY0" fmla="*/ 107821 h 1590717"/>
                    <a:gd name="connsiteX1" fmla="*/ 482902 w 1684240"/>
                    <a:gd name="connsiteY1" fmla="*/ 150401 h 1590717"/>
                    <a:gd name="connsiteX2" fmla="*/ 332043 w 1684240"/>
                    <a:gd name="connsiteY2" fmla="*/ 214620 h 1590717"/>
                    <a:gd name="connsiteX3" fmla="*/ 4665 w 1684240"/>
                    <a:gd name="connsiteY3" fmla="*/ 496842 h 1590717"/>
                    <a:gd name="connsiteX4" fmla="*/ 151420 w 1684240"/>
                    <a:gd name="connsiteY4" fmla="*/ 1072576 h 1590717"/>
                    <a:gd name="connsiteX5" fmla="*/ 325300 w 1684240"/>
                    <a:gd name="connsiteY5" fmla="*/ 1248334 h 1590717"/>
                    <a:gd name="connsiteX6" fmla="*/ 591687 w 1684240"/>
                    <a:gd name="connsiteY6" fmla="*/ 1388665 h 1590717"/>
                    <a:gd name="connsiteX7" fmla="*/ 804269 w 1684240"/>
                    <a:gd name="connsiteY7" fmla="*/ 1580681 h 1590717"/>
                    <a:gd name="connsiteX8" fmla="*/ 927421 w 1684240"/>
                    <a:gd name="connsiteY8" fmla="*/ 1538118 h 1590717"/>
                    <a:gd name="connsiteX9" fmla="*/ 1189998 w 1684240"/>
                    <a:gd name="connsiteY9" fmla="*/ 1320931 h 1590717"/>
                    <a:gd name="connsiteX10" fmla="*/ 1325465 w 1684240"/>
                    <a:gd name="connsiteY10" fmla="*/ 1140309 h 1590717"/>
                    <a:gd name="connsiteX11" fmla="*/ 1675420 w 1684240"/>
                    <a:gd name="connsiteY11" fmla="*/ 903242 h 1590717"/>
                    <a:gd name="connsiteX12" fmla="*/ 1585109 w 1684240"/>
                    <a:gd name="connsiteY12" fmla="*/ 541998 h 1590717"/>
                    <a:gd name="connsiteX13" fmla="*/ 1652843 w 1684240"/>
                    <a:gd name="connsiteY13" fmla="*/ 169465 h 1590717"/>
                    <a:gd name="connsiteX14" fmla="*/ 1235154 w 1684240"/>
                    <a:gd name="connsiteY14" fmla="*/ 131 h 1590717"/>
                    <a:gd name="connsiteX15" fmla="*/ 954061 w 1684240"/>
                    <a:gd name="connsiteY15" fmla="*/ 193170 h 1590717"/>
                    <a:gd name="connsiteX0" fmla="*/ 698166 w 1684240"/>
                    <a:gd name="connsiteY0" fmla="*/ 107821 h 1590717"/>
                    <a:gd name="connsiteX1" fmla="*/ 533745 w 1684240"/>
                    <a:gd name="connsiteY1" fmla="*/ 61404 h 1590717"/>
                    <a:gd name="connsiteX2" fmla="*/ 332043 w 1684240"/>
                    <a:gd name="connsiteY2" fmla="*/ 214620 h 1590717"/>
                    <a:gd name="connsiteX3" fmla="*/ 4665 w 1684240"/>
                    <a:gd name="connsiteY3" fmla="*/ 496842 h 1590717"/>
                    <a:gd name="connsiteX4" fmla="*/ 151420 w 1684240"/>
                    <a:gd name="connsiteY4" fmla="*/ 1072576 h 1590717"/>
                    <a:gd name="connsiteX5" fmla="*/ 325300 w 1684240"/>
                    <a:gd name="connsiteY5" fmla="*/ 1248334 h 1590717"/>
                    <a:gd name="connsiteX6" fmla="*/ 591687 w 1684240"/>
                    <a:gd name="connsiteY6" fmla="*/ 1388665 h 1590717"/>
                    <a:gd name="connsiteX7" fmla="*/ 804269 w 1684240"/>
                    <a:gd name="connsiteY7" fmla="*/ 1580681 h 1590717"/>
                    <a:gd name="connsiteX8" fmla="*/ 927421 w 1684240"/>
                    <a:gd name="connsiteY8" fmla="*/ 1538118 h 1590717"/>
                    <a:gd name="connsiteX9" fmla="*/ 1189998 w 1684240"/>
                    <a:gd name="connsiteY9" fmla="*/ 1320931 h 1590717"/>
                    <a:gd name="connsiteX10" fmla="*/ 1325465 w 1684240"/>
                    <a:gd name="connsiteY10" fmla="*/ 1140309 h 1590717"/>
                    <a:gd name="connsiteX11" fmla="*/ 1675420 w 1684240"/>
                    <a:gd name="connsiteY11" fmla="*/ 903242 h 1590717"/>
                    <a:gd name="connsiteX12" fmla="*/ 1585109 w 1684240"/>
                    <a:gd name="connsiteY12" fmla="*/ 541998 h 1590717"/>
                    <a:gd name="connsiteX13" fmla="*/ 1652843 w 1684240"/>
                    <a:gd name="connsiteY13" fmla="*/ 169465 h 1590717"/>
                    <a:gd name="connsiteX14" fmla="*/ 1235154 w 1684240"/>
                    <a:gd name="connsiteY14" fmla="*/ 131 h 1590717"/>
                    <a:gd name="connsiteX15" fmla="*/ 954061 w 1684240"/>
                    <a:gd name="connsiteY15" fmla="*/ 193170 h 1590717"/>
                    <a:gd name="connsiteX0" fmla="*/ 698166 w 1684240"/>
                    <a:gd name="connsiteY0" fmla="*/ 107821 h 1590717"/>
                    <a:gd name="connsiteX1" fmla="*/ 533745 w 1684240"/>
                    <a:gd name="connsiteY1" fmla="*/ 61404 h 1590717"/>
                    <a:gd name="connsiteX2" fmla="*/ 332043 w 1684240"/>
                    <a:gd name="connsiteY2" fmla="*/ 214620 h 1590717"/>
                    <a:gd name="connsiteX3" fmla="*/ 4665 w 1684240"/>
                    <a:gd name="connsiteY3" fmla="*/ 496842 h 1590717"/>
                    <a:gd name="connsiteX4" fmla="*/ 151420 w 1684240"/>
                    <a:gd name="connsiteY4" fmla="*/ 1072576 h 1590717"/>
                    <a:gd name="connsiteX5" fmla="*/ 325300 w 1684240"/>
                    <a:gd name="connsiteY5" fmla="*/ 1248334 h 1590717"/>
                    <a:gd name="connsiteX6" fmla="*/ 591687 w 1684240"/>
                    <a:gd name="connsiteY6" fmla="*/ 1388665 h 1590717"/>
                    <a:gd name="connsiteX7" fmla="*/ 804269 w 1684240"/>
                    <a:gd name="connsiteY7" fmla="*/ 1580681 h 1590717"/>
                    <a:gd name="connsiteX8" fmla="*/ 927421 w 1684240"/>
                    <a:gd name="connsiteY8" fmla="*/ 1538118 h 1590717"/>
                    <a:gd name="connsiteX9" fmla="*/ 1189998 w 1684240"/>
                    <a:gd name="connsiteY9" fmla="*/ 1320931 h 1590717"/>
                    <a:gd name="connsiteX10" fmla="*/ 1325465 w 1684240"/>
                    <a:gd name="connsiteY10" fmla="*/ 1140309 h 1590717"/>
                    <a:gd name="connsiteX11" fmla="*/ 1675420 w 1684240"/>
                    <a:gd name="connsiteY11" fmla="*/ 903242 h 1590717"/>
                    <a:gd name="connsiteX12" fmla="*/ 1585109 w 1684240"/>
                    <a:gd name="connsiteY12" fmla="*/ 541998 h 1590717"/>
                    <a:gd name="connsiteX13" fmla="*/ 1652843 w 1684240"/>
                    <a:gd name="connsiteY13" fmla="*/ 169465 h 1590717"/>
                    <a:gd name="connsiteX14" fmla="*/ 1235154 w 1684240"/>
                    <a:gd name="connsiteY14" fmla="*/ 131 h 1590717"/>
                    <a:gd name="connsiteX15" fmla="*/ 954061 w 1684240"/>
                    <a:gd name="connsiteY15" fmla="*/ 193170 h 1590717"/>
                    <a:gd name="connsiteX0" fmla="*/ 698687 w 1684240"/>
                    <a:gd name="connsiteY0" fmla="*/ 114225 h 1590717"/>
                    <a:gd name="connsiteX1" fmla="*/ 533745 w 1684240"/>
                    <a:gd name="connsiteY1" fmla="*/ 61404 h 1590717"/>
                    <a:gd name="connsiteX2" fmla="*/ 332043 w 1684240"/>
                    <a:gd name="connsiteY2" fmla="*/ 214620 h 1590717"/>
                    <a:gd name="connsiteX3" fmla="*/ 4665 w 1684240"/>
                    <a:gd name="connsiteY3" fmla="*/ 496842 h 1590717"/>
                    <a:gd name="connsiteX4" fmla="*/ 151420 w 1684240"/>
                    <a:gd name="connsiteY4" fmla="*/ 1072576 h 1590717"/>
                    <a:gd name="connsiteX5" fmla="*/ 325300 w 1684240"/>
                    <a:gd name="connsiteY5" fmla="*/ 1248334 h 1590717"/>
                    <a:gd name="connsiteX6" fmla="*/ 591687 w 1684240"/>
                    <a:gd name="connsiteY6" fmla="*/ 1388665 h 1590717"/>
                    <a:gd name="connsiteX7" fmla="*/ 804269 w 1684240"/>
                    <a:gd name="connsiteY7" fmla="*/ 1580681 h 1590717"/>
                    <a:gd name="connsiteX8" fmla="*/ 927421 w 1684240"/>
                    <a:gd name="connsiteY8" fmla="*/ 1538118 h 1590717"/>
                    <a:gd name="connsiteX9" fmla="*/ 1189998 w 1684240"/>
                    <a:gd name="connsiteY9" fmla="*/ 1320931 h 1590717"/>
                    <a:gd name="connsiteX10" fmla="*/ 1325465 w 1684240"/>
                    <a:gd name="connsiteY10" fmla="*/ 1140309 h 1590717"/>
                    <a:gd name="connsiteX11" fmla="*/ 1675420 w 1684240"/>
                    <a:gd name="connsiteY11" fmla="*/ 903242 h 1590717"/>
                    <a:gd name="connsiteX12" fmla="*/ 1585109 w 1684240"/>
                    <a:gd name="connsiteY12" fmla="*/ 541998 h 1590717"/>
                    <a:gd name="connsiteX13" fmla="*/ 1652843 w 1684240"/>
                    <a:gd name="connsiteY13" fmla="*/ 169465 h 1590717"/>
                    <a:gd name="connsiteX14" fmla="*/ 1235154 w 1684240"/>
                    <a:gd name="connsiteY14" fmla="*/ 131 h 1590717"/>
                    <a:gd name="connsiteX15" fmla="*/ 954061 w 1684240"/>
                    <a:gd name="connsiteY15" fmla="*/ 193170 h 1590717"/>
                    <a:gd name="connsiteX0" fmla="*/ 698687 w 1684240"/>
                    <a:gd name="connsiteY0" fmla="*/ 116872 h 1593364"/>
                    <a:gd name="connsiteX1" fmla="*/ 533745 w 1684240"/>
                    <a:gd name="connsiteY1" fmla="*/ 64051 h 1593364"/>
                    <a:gd name="connsiteX2" fmla="*/ 332043 w 1684240"/>
                    <a:gd name="connsiteY2" fmla="*/ 217267 h 1593364"/>
                    <a:gd name="connsiteX3" fmla="*/ 4665 w 1684240"/>
                    <a:gd name="connsiteY3" fmla="*/ 499489 h 1593364"/>
                    <a:gd name="connsiteX4" fmla="*/ 151420 w 1684240"/>
                    <a:gd name="connsiteY4" fmla="*/ 1075223 h 1593364"/>
                    <a:gd name="connsiteX5" fmla="*/ 325300 w 1684240"/>
                    <a:gd name="connsiteY5" fmla="*/ 1250981 h 1593364"/>
                    <a:gd name="connsiteX6" fmla="*/ 591687 w 1684240"/>
                    <a:gd name="connsiteY6" fmla="*/ 1391312 h 1593364"/>
                    <a:gd name="connsiteX7" fmla="*/ 804269 w 1684240"/>
                    <a:gd name="connsiteY7" fmla="*/ 1583328 h 1593364"/>
                    <a:gd name="connsiteX8" fmla="*/ 927421 w 1684240"/>
                    <a:gd name="connsiteY8" fmla="*/ 1540765 h 1593364"/>
                    <a:gd name="connsiteX9" fmla="*/ 1189998 w 1684240"/>
                    <a:gd name="connsiteY9" fmla="*/ 1323578 h 1593364"/>
                    <a:gd name="connsiteX10" fmla="*/ 1325465 w 1684240"/>
                    <a:gd name="connsiteY10" fmla="*/ 1142956 h 1593364"/>
                    <a:gd name="connsiteX11" fmla="*/ 1675420 w 1684240"/>
                    <a:gd name="connsiteY11" fmla="*/ 905889 h 1593364"/>
                    <a:gd name="connsiteX12" fmla="*/ 1585109 w 1684240"/>
                    <a:gd name="connsiteY12" fmla="*/ 544645 h 1593364"/>
                    <a:gd name="connsiteX13" fmla="*/ 1652843 w 1684240"/>
                    <a:gd name="connsiteY13" fmla="*/ 172112 h 1593364"/>
                    <a:gd name="connsiteX14" fmla="*/ 1235154 w 1684240"/>
                    <a:gd name="connsiteY14" fmla="*/ 2778 h 1593364"/>
                    <a:gd name="connsiteX15" fmla="*/ 974174 w 1684240"/>
                    <a:gd name="connsiteY15" fmla="*/ 69173 h 1593364"/>
                    <a:gd name="connsiteX16" fmla="*/ 954061 w 1684240"/>
                    <a:gd name="connsiteY16" fmla="*/ 195817 h 1593364"/>
                    <a:gd name="connsiteX0" fmla="*/ 698687 w 1684240"/>
                    <a:gd name="connsiteY0" fmla="*/ 116872 h 1593364"/>
                    <a:gd name="connsiteX1" fmla="*/ 607055 w 1684240"/>
                    <a:gd name="connsiteY1" fmla="*/ 37344 h 1593364"/>
                    <a:gd name="connsiteX2" fmla="*/ 332043 w 1684240"/>
                    <a:gd name="connsiteY2" fmla="*/ 217267 h 1593364"/>
                    <a:gd name="connsiteX3" fmla="*/ 4665 w 1684240"/>
                    <a:gd name="connsiteY3" fmla="*/ 499489 h 1593364"/>
                    <a:gd name="connsiteX4" fmla="*/ 151420 w 1684240"/>
                    <a:gd name="connsiteY4" fmla="*/ 1075223 h 1593364"/>
                    <a:gd name="connsiteX5" fmla="*/ 325300 w 1684240"/>
                    <a:gd name="connsiteY5" fmla="*/ 1250981 h 1593364"/>
                    <a:gd name="connsiteX6" fmla="*/ 591687 w 1684240"/>
                    <a:gd name="connsiteY6" fmla="*/ 1391312 h 1593364"/>
                    <a:gd name="connsiteX7" fmla="*/ 804269 w 1684240"/>
                    <a:gd name="connsiteY7" fmla="*/ 1583328 h 1593364"/>
                    <a:gd name="connsiteX8" fmla="*/ 927421 w 1684240"/>
                    <a:gd name="connsiteY8" fmla="*/ 1540765 h 1593364"/>
                    <a:gd name="connsiteX9" fmla="*/ 1189998 w 1684240"/>
                    <a:gd name="connsiteY9" fmla="*/ 1323578 h 1593364"/>
                    <a:gd name="connsiteX10" fmla="*/ 1325465 w 1684240"/>
                    <a:gd name="connsiteY10" fmla="*/ 1142956 h 1593364"/>
                    <a:gd name="connsiteX11" fmla="*/ 1675420 w 1684240"/>
                    <a:gd name="connsiteY11" fmla="*/ 905889 h 1593364"/>
                    <a:gd name="connsiteX12" fmla="*/ 1585109 w 1684240"/>
                    <a:gd name="connsiteY12" fmla="*/ 544645 h 1593364"/>
                    <a:gd name="connsiteX13" fmla="*/ 1652843 w 1684240"/>
                    <a:gd name="connsiteY13" fmla="*/ 172112 h 1593364"/>
                    <a:gd name="connsiteX14" fmla="*/ 1235154 w 1684240"/>
                    <a:gd name="connsiteY14" fmla="*/ 2778 h 1593364"/>
                    <a:gd name="connsiteX15" fmla="*/ 974174 w 1684240"/>
                    <a:gd name="connsiteY15" fmla="*/ 69173 h 1593364"/>
                    <a:gd name="connsiteX16" fmla="*/ 954061 w 1684240"/>
                    <a:gd name="connsiteY16" fmla="*/ 195817 h 1593364"/>
                    <a:gd name="connsiteX0" fmla="*/ 698687 w 1684240"/>
                    <a:gd name="connsiteY0" fmla="*/ 116872 h 1593364"/>
                    <a:gd name="connsiteX1" fmla="*/ 722390 w 1684240"/>
                    <a:gd name="connsiteY1" fmla="*/ 42755 h 1593364"/>
                    <a:gd name="connsiteX2" fmla="*/ 607055 w 1684240"/>
                    <a:gd name="connsiteY2" fmla="*/ 37344 h 1593364"/>
                    <a:gd name="connsiteX3" fmla="*/ 332043 w 1684240"/>
                    <a:gd name="connsiteY3" fmla="*/ 217267 h 1593364"/>
                    <a:gd name="connsiteX4" fmla="*/ 4665 w 1684240"/>
                    <a:gd name="connsiteY4" fmla="*/ 499489 h 1593364"/>
                    <a:gd name="connsiteX5" fmla="*/ 151420 w 1684240"/>
                    <a:gd name="connsiteY5" fmla="*/ 1075223 h 1593364"/>
                    <a:gd name="connsiteX6" fmla="*/ 325300 w 1684240"/>
                    <a:gd name="connsiteY6" fmla="*/ 1250981 h 1593364"/>
                    <a:gd name="connsiteX7" fmla="*/ 591687 w 1684240"/>
                    <a:gd name="connsiteY7" fmla="*/ 1391312 h 1593364"/>
                    <a:gd name="connsiteX8" fmla="*/ 804269 w 1684240"/>
                    <a:gd name="connsiteY8" fmla="*/ 1583328 h 1593364"/>
                    <a:gd name="connsiteX9" fmla="*/ 927421 w 1684240"/>
                    <a:gd name="connsiteY9" fmla="*/ 1540765 h 1593364"/>
                    <a:gd name="connsiteX10" fmla="*/ 1189998 w 1684240"/>
                    <a:gd name="connsiteY10" fmla="*/ 1323578 h 1593364"/>
                    <a:gd name="connsiteX11" fmla="*/ 1325465 w 1684240"/>
                    <a:gd name="connsiteY11" fmla="*/ 1142956 h 1593364"/>
                    <a:gd name="connsiteX12" fmla="*/ 1675420 w 1684240"/>
                    <a:gd name="connsiteY12" fmla="*/ 905889 h 1593364"/>
                    <a:gd name="connsiteX13" fmla="*/ 1585109 w 1684240"/>
                    <a:gd name="connsiteY13" fmla="*/ 544645 h 1593364"/>
                    <a:gd name="connsiteX14" fmla="*/ 1652843 w 1684240"/>
                    <a:gd name="connsiteY14" fmla="*/ 172112 h 1593364"/>
                    <a:gd name="connsiteX15" fmla="*/ 1235154 w 1684240"/>
                    <a:gd name="connsiteY15" fmla="*/ 2778 h 1593364"/>
                    <a:gd name="connsiteX16" fmla="*/ 974174 w 1684240"/>
                    <a:gd name="connsiteY16" fmla="*/ 69173 h 1593364"/>
                    <a:gd name="connsiteX17" fmla="*/ 954061 w 1684240"/>
                    <a:gd name="connsiteY17" fmla="*/ 195817 h 159336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</a:cxnLst>
                  <a:rect l="l" t="t" r="r" b="b"/>
                  <a:pathLst>
                    <a:path w="1684240" h="1593364">
                      <a:moveTo>
                        <a:pt x="698687" y="116872"/>
                      </a:moveTo>
                      <a:cubicBezTo>
                        <a:pt x="691811" y="114210"/>
                        <a:pt x="737662" y="56010"/>
                        <a:pt x="722390" y="42755"/>
                      </a:cubicBezTo>
                      <a:cubicBezTo>
                        <a:pt x="707118" y="29500"/>
                        <a:pt x="672113" y="8259"/>
                        <a:pt x="607055" y="37344"/>
                      </a:cubicBezTo>
                      <a:cubicBezTo>
                        <a:pt x="541997" y="66429"/>
                        <a:pt x="432441" y="140243"/>
                        <a:pt x="332043" y="217267"/>
                      </a:cubicBezTo>
                      <a:cubicBezTo>
                        <a:pt x="231645" y="294291"/>
                        <a:pt x="34769" y="356496"/>
                        <a:pt x="4665" y="499489"/>
                      </a:cubicBezTo>
                      <a:cubicBezTo>
                        <a:pt x="-25439" y="642482"/>
                        <a:pt x="97981" y="949974"/>
                        <a:pt x="151420" y="1075223"/>
                      </a:cubicBezTo>
                      <a:cubicBezTo>
                        <a:pt x="204859" y="1200472"/>
                        <a:pt x="251922" y="1198299"/>
                        <a:pt x="325300" y="1250981"/>
                      </a:cubicBezTo>
                      <a:cubicBezTo>
                        <a:pt x="398678" y="1303663"/>
                        <a:pt x="511859" y="1335921"/>
                        <a:pt x="591687" y="1391312"/>
                      </a:cubicBezTo>
                      <a:cubicBezTo>
                        <a:pt x="671515" y="1446703"/>
                        <a:pt x="748313" y="1558419"/>
                        <a:pt x="804269" y="1583328"/>
                      </a:cubicBezTo>
                      <a:cubicBezTo>
                        <a:pt x="860225" y="1608237"/>
                        <a:pt x="863133" y="1584057"/>
                        <a:pt x="927421" y="1540765"/>
                      </a:cubicBezTo>
                      <a:cubicBezTo>
                        <a:pt x="991709" y="1497473"/>
                        <a:pt x="1123657" y="1389879"/>
                        <a:pt x="1189998" y="1323578"/>
                      </a:cubicBezTo>
                      <a:cubicBezTo>
                        <a:pt x="1256339" y="1257277"/>
                        <a:pt x="1244561" y="1212571"/>
                        <a:pt x="1325465" y="1142956"/>
                      </a:cubicBezTo>
                      <a:cubicBezTo>
                        <a:pt x="1406369" y="1073341"/>
                        <a:pt x="1632146" y="1005607"/>
                        <a:pt x="1675420" y="905889"/>
                      </a:cubicBezTo>
                      <a:cubicBezTo>
                        <a:pt x="1718694" y="806171"/>
                        <a:pt x="1588872" y="666941"/>
                        <a:pt x="1585109" y="544645"/>
                      </a:cubicBezTo>
                      <a:cubicBezTo>
                        <a:pt x="1581346" y="422349"/>
                        <a:pt x="1705524" y="258660"/>
                        <a:pt x="1652843" y="172112"/>
                      </a:cubicBezTo>
                      <a:cubicBezTo>
                        <a:pt x="1600162" y="85564"/>
                        <a:pt x="1337448" y="17791"/>
                        <a:pt x="1235154" y="2778"/>
                      </a:cubicBezTo>
                      <a:cubicBezTo>
                        <a:pt x="1132860" y="-12235"/>
                        <a:pt x="1021023" y="37000"/>
                        <a:pt x="974174" y="69173"/>
                      </a:cubicBezTo>
                      <a:cubicBezTo>
                        <a:pt x="927325" y="101346"/>
                        <a:pt x="968231" y="176853"/>
                        <a:pt x="954061" y="195817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6350">
                  <a:solidFill>
                    <a:schemeClr val="bg1">
                      <a:lumMod val="65000"/>
                    </a:schemeClr>
                  </a:solidFill>
                  <a:prstDash val="soli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334" name="Forme libre 333"/>
                <p:cNvSpPr/>
                <p:nvPr/>
              </p:nvSpPr>
              <p:spPr>
                <a:xfrm>
                  <a:off x="3946052" y="1457025"/>
                  <a:ext cx="557681" cy="446037"/>
                </a:xfrm>
                <a:custGeom>
                  <a:avLst/>
                  <a:gdLst>
                    <a:gd name="connsiteX0" fmla="*/ 599693 w 1256584"/>
                    <a:gd name="connsiteY0" fmla="*/ 3208 h 826201"/>
                    <a:gd name="connsiteX1" fmla="*/ 80404 w 1256584"/>
                    <a:gd name="connsiteY1" fmla="*/ 138675 h 826201"/>
                    <a:gd name="connsiteX2" fmla="*/ 80404 w 1256584"/>
                    <a:gd name="connsiteY2" fmla="*/ 612808 h 826201"/>
                    <a:gd name="connsiteX3" fmla="*/ 836760 w 1256584"/>
                    <a:gd name="connsiteY3" fmla="*/ 816008 h 826201"/>
                    <a:gd name="connsiteX4" fmla="*/ 1209293 w 1256584"/>
                    <a:gd name="connsiteY4" fmla="*/ 736986 h 826201"/>
                    <a:gd name="connsiteX5" fmla="*/ 1186715 w 1256584"/>
                    <a:gd name="connsiteY5" fmla="*/ 240275 h 826201"/>
                    <a:gd name="connsiteX6" fmla="*/ 599693 w 1256584"/>
                    <a:gd name="connsiteY6" fmla="*/ 3208 h 826201"/>
                    <a:gd name="connsiteX0" fmla="*/ 599693 w 1256584"/>
                    <a:gd name="connsiteY0" fmla="*/ 3208 h 826201"/>
                    <a:gd name="connsiteX1" fmla="*/ 80404 w 1256584"/>
                    <a:gd name="connsiteY1" fmla="*/ 138675 h 826201"/>
                    <a:gd name="connsiteX2" fmla="*/ 80404 w 1256584"/>
                    <a:gd name="connsiteY2" fmla="*/ 612808 h 826201"/>
                    <a:gd name="connsiteX3" fmla="*/ 836760 w 1256584"/>
                    <a:gd name="connsiteY3" fmla="*/ 816008 h 826201"/>
                    <a:gd name="connsiteX4" fmla="*/ 1209293 w 1256584"/>
                    <a:gd name="connsiteY4" fmla="*/ 736986 h 826201"/>
                    <a:gd name="connsiteX5" fmla="*/ 1186715 w 1256584"/>
                    <a:gd name="connsiteY5" fmla="*/ 240275 h 826201"/>
                    <a:gd name="connsiteX6" fmla="*/ 747724 w 1256584"/>
                    <a:gd name="connsiteY6" fmla="*/ 152847 h 826201"/>
                    <a:gd name="connsiteX0" fmla="*/ 459650 w 1249388"/>
                    <a:gd name="connsiteY0" fmla="*/ 1488 h 920403"/>
                    <a:gd name="connsiteX1" fmla="*/ 73208 w 1249388"/>
                    <a:gd name="connsiteY1" fmla="*/ 232877 h 920403"/>
                    <a:gd name="connsiteX2" fmla="*/ 73208 w 1249388"/>
                    <a:gd name="connsiteY2" fmla="*/ 707010 h 920403"/>
                    <a:gd name="connsiteX3" fmla="*/ 829564 w 1249388"/>
                    <a:gd name="connsiteY3" fmla="*/ 910210 h 920403"/>
                    <a:gd name="connsiteX4" fmla="*/ 1202097 w 1249388"/>
                    <a:gd name="connsiteY4" fmla="*/ 831188 h 920403"/>
                    <a:gd name="connsiteX5" fmla="*/ 1179519 w 1249388"/>
                    <a:gd name="connsiteY5" fmla="*/ 334477 h 920403"/>
                    <a:gd name="connsiteX6" fmla="*/ 740528 w 1249388"/>
                    <a:gd name="connsiteY6" fmla="*/ 247049 h 920403"/>
                    <a:gd name="connsiteX0" fmla="*/ 459650 w 1247912"/>
                    <a:gd name="connsiteY0" fmla="*/ 1488 h 920403"/>
                    <a:gd name="connsiteX1" fmla="*/ 73208 w 1247912"/>
                    <a:gd name="connsiteY1" fmla="*/ 232877 h 920403"/>
                    <a:gd name="connsiteX2" fmla="*/ 73208 w 1247912"/>
                    <a:gd name="connsiteY2" fmla="*/ 707010 h 920403"/>
                    <a:gd name="connsiteX3" fmla="*/ 829564 w 1247912"/>
                    <a:gd name="connsiteY3" fmla="*/ 910210 h 920403"/>
                    <a:gd name="connsiteX4" fmla="*/ 1202097 w 1247912"/>
                    <a:gd name="connsiteY4" fmla="*/ 831188 h 920403"/>
                    <a:gd name="connsiteX5" fmla="*/ 1179519 w 1247912"/>
                    <a:gd name="connsiteY5" fmla="*/ 334477 h 920403"/>
                    <a:gd name="connsiteX6" fmla="*/ 639311 w 1247912"/>
                    <a:gd name="connsiteY6" fmla="*/ 119153 h 920403"/>
                    <a:gd name="connsiteX0" fmla="*/ 459650 w 1247912"/>
                    <a:gd name="connsiteY0" fmla="*/ 1488 h 920403"/>
                    <a:gd name="connsiteX1" fmla="*/ 73208 w 1247912"/>
                    <a:gd name="connsiteY1" fmla="*/ 232877 h 920403"/>
                    <a:gd name="connsiteX2" fmla="*/ 73208 w 1247912"/>
                    <a:gd name="connsiteY2" fmla="*/ 707010 h 920403"/>
                    <a:gd name="connsiteX3" fmla="*/ 829564 w 1247912"/>
                    <a:gd name="connsiteY3" fmla="*/ 910210 h 920403"/>
                    <a:gd name="connsiteX4" fmla="*/ 1202097 w 1247912"/>
                    <a:gd name="connsiteY4" fmla="*/ 831188 h 920403"/>
                    <a:gd name="connsiteX5" fmla="*/ 1179519 w 1247912"/>
                    <a:gd name="connsiteY5" fmla="*/ 334477 h 920403"/>
                    <a:gd name="connsiteX6" fmla="*/ 639311 w 1247912"/>
                    <a:gd name="connsiteY6" fmla="*/ 74389 h 920403"/>
                    <a:gd name="connsiteX0" fmla="*/ 459650 w 1236362"/>
                    <a:gd name="connsiteY0" fmla="*/ 1488 h 920403"/>
                    <a:gd name="connsiteX1" fmla="*/ 73208 w 1236362"/>
                    <a:gd name="connsiteY1" fmla="*/ 232877 h 920403"/>
                    <a:gd name="connsiteX2" fmla="*/ 73208 w 1236362"/>
                    <a:gd name="connsiteY2" fmla="*/ 707010 h 920403"/>
                    <a:gd name="connsiteX3" fmla="*/ 829564 w 1236362"/>
                    <a:gd name="connsiteY3" fmla="*/ 910210 h 920403"/>
                    <a:gd name="connsiteX4" fmla="*/ 1202097 w 1236362"/>
                    <a:gd name="connsiteY4" fmla="*/ 831188 h 920403"/>
                    <a:gd name="connsiteX5" fmla="*/ 1179519 w 1236362"/>
                    <a:gd name="connsiteY5" fmla="*/ 334477 h 920403"/>
                    <a:gd name="connsiteX6" fmla="*/ 847843 w 1236362"/>
                    <a:gd name="connsiteY6" fmla="*/ 119265 h 920403"/>
                    <a:gd name="connsiteX0" fmla="*/ 459650 w 1228859"/>
                    <a:gd name="connsiteY0" fmla="*/ 1488 h 920403"/>
                    <a:gd name="connsiteX1" fmla="*/ 73208 w 1228859"/>
                    <a:gd name="connsiteY1" fmla="*/ 232877 h 920403"/>
                    <a:gd name="connsiteX2" fmla="*/ 73208 w 1228859"/>
                    <a:gd name="connsiteY2" fmla="*/ 707010 h 920403"/>
                    <a:gd name="connsiteX3" fmla="*/ 829564 w 1228859"/>
                    <a:gd name="connsiteY3" fmla="*/ 910210 h 920403"/>
                    <a:gd name="connsiteX4" fmla="*/ 1202097 w 1228859"/>
                    <a:gd name="connsiteY4" fmla="*/ 831188 h 920403"/>
                    <a:gd name="connsiteX5" fmla="*/ 1179519 w 1228859"/>
                    <a:gd name="connsiteY5" fmla="*/ 334477 h 920403"/>
                    <a:gd name="connsiteX6" fmla="*/ 931616 w 1228859"/>
                    <a:gd name="connsiteY6" fmla="*/ 193768 h 920403"/>
                    <a:gd name="connsiteX7" fmla="*/ 847843 w 1228859"/>
                    <a:gd name="connsiteY7" fmla="*/ 119265 h 920403"/>
                    <a:gd name="connsiteX0" fmla="*/ 459650 w 1228859"/>
                    <a:gd name="connsiteY0" fmla="*/ 1488 h 920403"/>
                    <a:gd name="connsiteX1" fmla="*/ 73208 w 1228859"/>
                    <a:gd name="connsiteY1" fmla="*/ 232877 h 920403"/>
                    <a:gd name="connsiteX2" fmla="*/ 73208 w 1228859"/>
                    <a:gd name="connsiteY2" fmla="*/ 707010 h 920403"/>
                    <a:gd name="connsiteX3" fmla="*/ 829564 w 1228859"/>
                    <a:gd name="connsiteY3" fmla="*/ 910210 h 920403"/>
                    <a:gd name="connsiteX4" fmla="*/ 1202097 w 1228859"/>
                    <a:gd name="connsiteY4" fmla="*/ 831188 h 920403"/>
                    <a:gd name="connsiteX5" fmla="*/ 1179519 w 1228859"/>
                    <a:gd name="connsiteY5" fmla="*/ 334477 h 920403"/>
                    <a:gd name="connsiteX6" fmla="*/ 931616 w 1228859"/>
                    <a:gd name="connsiteY6" fmla="*/ 193768 h 920403"/>
                    <a:gd name="connsiteX7" fmla="*/ 847843 w 1228859"/>
                    <a:gd name="connsiteY7" fmla="*/ 119265 h 9204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</a:cxnLst>
                  <a:rect l="l" t="t" r="r" b="b"/>
                  <a:pathLst>
                    <a:path w="1228859" h="920403">
                      <a:moveTo>
                        <a:pt x="459650" y="1488"/>
                      </a:moveTo>
                      <a:cubicBezTo>
                        <a:pt x="275265" y="-15445"/>
                        <a:pt x="137615" y="115290"/>
                        <a:pt x="73208" y="232877"/>
                      </a:cubicBezTo>
                      <a:cubicBezTo>
                        <a:pt x="8801" y="350464"/>
                        <a:pt x="-52851" y="594121"/>
                        <a:pt x="73208" y="707010"/>
                      </a:cubicBezTo>
                      <a:cubicBezTo>
                        <a:pt x="199267" y="819899"/>
                        <a:pt x="641416" y="889514"/>
                        <a:pt x="829564" y="910210"/>
                      </a:cubicBezTo>
                      <a:cubicBezTo>
                        <a:pt x="1017712" y="930906"/>
                        <a:pt x="1143771" y="927143"/>
                        <a:pt x="1202097" y="831188"/>
                      </a:cubicBezTo>
                      <a:cubicBezTo>
                        <a:pt x="1260423" y="735233"/>
                        <a:pt x="1209633" y="450582"/>
                        <a:pt x="1179519" y="334477"/>
                      </a:cubicBezTo>
                      <a:cubicBezTo>
                        <a:pt x="1149405" y="218372"/>
                        <a:pt x="986895" y="229637"/>
                        <a:pt x="931616" y="193768"/>
                      </a:cubicBezTo>
                      <a:cubicBezTo>
                        <a:pt x="876337" y="157899"/>
                        <a:pt x="876772" y="121813"/>
                        <a:pt x="847843" y="119265"/>
                      </a:cubicBezTo>
                    </a:path>
                  </a:pathLst>
                </a:custGeom>
                <a:solidFill>
                  <a:schemeClr val="bg1"/>
                </a:solidFill>
                <a:ln w="9525">
                  <a:solidFill>
                    <a:srgbClr val="548235">
                      <a:alpha val="50196"/>
                    </a:srgbClr>
                  </a:solidFill>
                  <a:prstDash val="soli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sp>
            <p:nvSpPr>
              <p:cNvPr id="331" name="Arc 330"/>
              <p:cNvSpPr/>
              <p:nvPr/>
            </p:nvSpPr>
            <p:spPr>
              <a:xfrm rot="1015576">
                <a:off x="3727072" y="3349382"/>
                <a:ext cx="292005" cy="181756"/>
              </a:xfrm>
              <a:prstGeom prst="arc">
                <a:avLst/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  <a:head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32" name="Arc 331"/>
              <p:cNvSpPr/>
              <p:nvPr/>
            </p:nvSpPr>
            <p:spPr>
              <a:xfrm rot="10918235" flipV="1">
                <a:off x="4092994" y="3364997"/>
                <a:ext cx="320411" cy="220067"/>
              </a:xfrm>
              <a:prstGeom prst="arc">
                <a:avLst/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  <a:head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324" name="Image 32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77307" y="2427633"/>
              <a:ext cx="91742" cy="119901"/>
            </a:xfrm>
            <a:prstGeom prst="rect">
              <a:avLst/>
            </a:prstGeom>
          </p:spPr>
        </p:pic>
        <p:pic>
          <p:nvPicPr>
            <p:cNvPr id="325" name="Image 32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20454063">
              <a:off x="3527715" y="2463396"/>
              <a:ext cx="91742" cy="119901"/>
            </a:xfrm>
            <a:prstGeom prst="rect">
              <a:avLst/>
            </a:prstGeom>
          </p:spPr>
        </p:pic>
        <p:pic>
          <p:nvPicPr>
            <p:cNvPr id="326" name="Image 32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6413979">
              <a:off x="3600159" y="2346348"/>
              <a:ext cx="91742" cy="119901"/>
            </a:xfrm>
            <a:prstGeom prst="rect">
              <a:avLst/>
            </a:prstGeom>
          </p:spPr>
        </p:pic>
        <p:pic>
          <p:nvPicPr>
            <p:cNvPr id="327" name="Image 32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5130222">
              <a:off x="3571617" y="2294027"/>
              <a:ext cx="91742" cy="119901"/>
            </a:xfrm>
            <a:prstGeom prst="rect">
              <a:avLst/>
            </a:prstGeom>
          </p:spPr>
        </p:pic>
        <p:pic>
          <p:nvPicPr>
            <p:cNvPr id="328" name="Image 32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7210582">
              <a:off x="3479033" y="2374008"/>
              <a:ext cx="91742" cy="119901"/>
            </a:xfrm>
            <a:prstGeom prst="rect">
              <a:avLst/>
            </a:prstGeom>
          </p:spPr>
        </p:pic>
        <p:pic>
          <p:nvPicPr>
            <p:cNvPr id="329" name="Image 32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2151359">
              <a:off x="3459107" y="2463117"/>
              <a:ext cx="91742" cy="119901"/>
            </a:xfrm>
            <a:prstGeom prst="rect">
              <a:avLst/>
            </a:prstGeom>
          </p:spPr>
        </p:pic>
      </p:grpSp>
      <p:pic>
        <p:nvPicPr>
          <p:cNvPr id="335" name="Image 33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50139">
            <a:off x="891552" y="3121599"/>
            <a:ext cx="178629" cy="233456"/>
          </a:xfrm>
          <a:prstGeom prst="rect">
            <a:avLst/>
          </a:prstGeom>
        </p:spPr>
      </p:pic>
      <p:sp>
        <p:nvSpPr>
          <p:cNvPr id="336" name="ZoneTexte 335"/>
          <p:cNvSpPr txBox="1"/>
          <p:nvPr/>
        </p:nvSpPr>
        <p:spPr>
          <a:xfrm>
            <a:off x="1090760" y="3036156"/>
            <a:ext cx="771365" cy="3616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700"/>
              </a:lnSpc>
            </a:pPr>
            <a:r>
              <a:rPr lang="fr-FR" sz="700" dirty="0" err="1" smtClean="0"/>
              <a:t>Flagellar</a:t>
            </a:r>
            <a:r>
              <a:rPr lang="fr-FR" sz="700" dirty="0" smtClean="0"/>
              <a:t> </a:t>
            </a:r>
            <a:r>
              <a:rPr lang="fr-FR" sz="700" dirty="0" err="1" smtClean="0"/>
              <a:t>pocket</a:t>
            </a:r>
            <a:endParaRPr lang="fr-FR" sz="700" dirty="0" smtClean="0"/>
          </a:p>
          <a:p>
            <a:pPr>
              <a:lnSpc>
                <a:spcPts val="700"/>
              </a:lnSpc>
            </a:pPr>
            <a:endParaRPr lang="fr-FR" sz="100" dirty="0"/>
          </a:p>
          <a:p>
            <a:pPr>
              <a:lnSpc>
                <a:spcPts val="700"/>
              </a:lnSpc>
            </a:pPr>
            <a:r>
              <a:rPr lang="fr-FR" sz="700" dirty="0" err="1" smtClean="0"/>
              <a:t>Attachment</a:t>
            </a:r>
            <a:r>
              <a:rPr lang="fr-FR" sz="700" dirty="0" smtClean="0"/>
              <a:t> site</a:t>
            </a:r>
            <a:endParaRPr lang="fr-FR" sz="700" dirty="0"/>
          </a:p>
        </p:txBody>
      </p:sp>
      <p:cxnSp>
        <p:nvCxnSpPr>
          <p:cNvPr id="337" name="Connecteur droit 336"/>
          <p:cNvCxnSpPr/>
          <p:nvPr/>
        </p:nvCxnSpPr>
        <p:spPr>
          <a:xfrm>
            <a:off x="993195" y="3130254"/>
            <a:ext cx="13968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8" name="Connecteur droit 337"/>
          <p:cNvCxnSpPr/>
          <p:nvPr/>
        </p:nvCxnSpPr>
        <p:spPr>
          <a:xfrm>
            <a:off x="974181" y="3329916"/>
            <a:ext cx="13968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9" name="Connecteur droit 338"/>
          <p:cNvCxnSpPr/>
          <p:nvPr/>
        </p:nvCxnSpPr>
        <p:spPr>
          <a:xfrm>
            <a:off x="2545353" y="3135449"/>
            <a:ext cx="180000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0" name="Connecteur droit 339"/>
          <p:cNvCxnSpPr/>
          <p:nvPr/>
        </p:nvCxnSpPr>
        <p:spPr>
          <a:xfrm>
            <a:off x="4308682" y="3142310"/>
            <a:ext cx="180000" cy="0"/>
          </a:xfrm>
          <a:prstGeom prst="line">
            <a:avLst/>
          </a:prstGeom>
          <a:ln w="12700">
            <a:solidFill>
              <a:srgbClr val="548235">
                <a:alpha val="50196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1" name="Rectangle 340"/>
          <p:cNvSpPr/>
          <p:nvPr/>
        </p:nvSpPr>
        <p:spPr>
          <a:xfrm>
            <a:off x="650449" y="2980545"/>
            <a:ext cx="5715785" cy="475247"/>
          </a:xfrm>
          <a:prstGeom prst="rect">
            <a:avLst/>
          </a:prstGeom>
          <a:noFill/>
          <a:ln w="9525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42" name="Flèche droite 341"/>
          <p:cNvSpPr/>
          <p:nvPr/>
        </p:nvSpPr>
        <p:spPr>
          <a:xfrm>
            <a:off x="2607361" y="1468936"/>
            <a:ext cx="648000" cy="91894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343" name="Groupe 342"/>
          <p:cNvGrpSpPr/>
          <p:nvPr/>
        </p:nvGrpSpPr>
        <p:grpSpPr>
          <a:xfrm rot="649295">
            <a:off x="4420358" y="1240022"/>
            <a:ext cx="513020" cy="535641"/>
            <a:chOff x="4805087" y="1040469"/>
            <a:chExt cx="690080" cy="629131"/>
          </a:xfrm>
        </p:grpSpPr>
        <p:sp>
          <p:nvSpPr>
            <p:cNvPr id="344" name="Forme libre 343"/>
            <p:cNvSpPr/>
            <p:nvPr/>
          </p:nvSpPr>
          <p:spPr>
            <a:xfrm rot="4286376">
              <a:off x="4835561" y="1009995"/>
              <a:ext cx="629131" cy="690080"/>
            </a:xfrm>
            <a:custGeom>
              <a:avLst/>
              <a:gdLst>
                <a:gd name="connsiteX0" fmla="*/ 1245464 w 1694550"/>
                <a:gd name="connsiteY0" fmla="*/ 229341 h 1996683"/>
                <a:gd name="connsiteX1" fmla="*/ 737464 w 1694550"/>
                <a:gd name="connsiteY1" fmla="*/ 3563 h 1996683"/>
                <a:gd name="connsiteX2" fmla="*/ 410086 w 1694550"/>
                <a:gd name="connsiteY2" fmla="*/ 116452 h 1996683"/>
                <a:gd name="connsiteX3" fmla="*/ 342353 w 1694550"/>
                <a:gd name="connsiteY3" fmla="*/ 443830 h 1996683"/>
                <a:gd name="connsiteX4" fmla="*/ 14975 w 1694550"/>
                <a:gd name="connsiteY4" fmla="*/ 726052 h 1996683"/>
                <a:gd name="connsiteX5" fmla="*/ 161730 w 1694550"/>
                <a:gd name="connsiteY5" fmla="*/ 1301786 h 1996683"/>
                <a:gd name="connsiteX6" fmla="*/ 14975 w 1694550"/>
                <a:gd name="connsiteY6" fmla="*/ 1640452 h 1996683"/>
                <a:gd name="connsiteX7" fmla="*/ 601997 w 1694550"/>
                <a:gd name="connsiteY7" fmla="*/ 1617875 h 1996683"/>
                <a:gd name="connsiteX8" fmla="*/ 624575 w 1694550"/>
                <a:gd name="connsiteY8" fmla="*/ 1922675 h 1996683"/>
                <a:gd name="connsiteX9" fmla="*/ 997108 w 1694550"/>
                <a:gd name="connsiteY9" fmla="*/ 1967830 h 1996683"/>
                <a:gd name="connsiteX10" fmla="*/ 1200308 w 1694550"/>
                <a:gd name="connsiteY10" fmla="*/ 1550141 h 1996683"/>
                <a:gd name="connsiteX11" fmla="*/ 1335775 w 1694550"/>
                <a:gd name="connsiteY11" fmla="*/ 1369519 h 1996683"/>
                <a:gd name="connsiteX12" fmla="*/ 1685730 w 1694550"/>
                <a:gd name="connsiteY12" fmla="*/ 1132452 h 1996683"/>
                <a:gd name="connsiteX13" fmla="*/ 1595419 w 1694550"/>
                <a:gd name="connsiteY13" fmla="*/ 771208 h 1996683"/>
                <a:gd name="connsiteX14" fmla="*/ 1663153 w 1694550"/>
                <a:gd name="connsiteY14" fmla="*/ 398675 h 1996683"/>
                <a:gd name="connsiteX15" fmla="*/ 1245464 w 1694550"/>
                <a:gd name="connsiteY15" fmla="*/ 229341 h 1996683"/>
                <a:gd name="connsiteX0" fmla="*/ 1245464 w 1694550"/>
                <a:gd name="connsiteY0" fmla="*/ 229341 h 1968707"/>
                <a:gd name="connsiteX1" fmla="*/ 737464 w 1694550"/>
                <a:gd name="connsiteY1" fmla="*/ 3563 h 1968707"/>
                <a:gd name="connsiteX2" fmla="*/ 410086 w 1694550"/>
                <a:gd name="connsiteY2" fmla="*/ 116452 h 1968707"/>
                <a:gd name="connsiteX3" fmla="*/ 342353 w 1694550"/>
                <a:gd name="connsiteY3" fmla="*/ 443830 h 1968707"/>
                <a:gd name="connsiteX4" fmla="*/ 14975 w 1694550"/>
                <a:gd name="connsiteY4" fmla="*/ 726052 h 1968707"/>
                <a:gd name="connsiteX5" fmla="*/ 161730 w 1694550"/>
                <a:gd name="connsiteY5" fmla="*/ 1301786 h 1968707"/>
                <a:gd name="connsiteX6" fmla="*/ 14975 w 1694550"/>
                <a:gd name="connsiteY6" fmla="*/ 1640452 h 1968707"/>
                <a:gd name="connsiteX7" fmla="*/ 601997 w 1694550"/>
                <a:gd name="connsiteY7" fmla="*/ 1617875 h 1968707"/>
                <a:gd name="connsiteX8" fmla="*/ 775965 w 1694550"/>
                <a:gd name="connsiteY8" fmla="*/ 1428305 h 1968707"/>
                <a:gd name="connsiteX9" fmla="*/ 997108 w 1694550"/>
                <a:gd name="connsiteY9" fmla="*/ 1967830 h 1968707"/>
                <a:gd name="connsiteX10" fmla="*/ 1200308 w 1694550"/>
                <a:gd name="connsiteY10" fmla="*/ 1550141 h 1968707"/>
                <a:gd name="connsiteX11" fmla="*/ 1335775 w 1694550"/>
                <a:gd name="connsiteY11" fmla="*/ 1369519 h 1968707"/>
                <a:gd name="connsiteX12" fmla="*/ 1685730 w 1694550"/>
                <a:gd name="connsiteY12" fmla="*/ 1132452 h 1968707"/>
                <a:gd name="connsiteX13" fmla="*/ 1595419 w 1694550"/>
                <a:gd name="connsiteY13" fmla="*/ 771208 h 1968707"/>
                <a:gd name="connsiteX14" fmla="*/ 1663153 w 1694550"/>
                <a:gd name="connsiteY14" fmla="*/ 398675 h 1968707"/>
                <a:gd name="connsiteX15" fmla="*/ 1245464 w 1694550"/>
                <a:gd name="connsiteY15" fmla="*/ 229341 h 1968707"/>
                <a:gd name="connsiteX0" fmla="*/ 1234998 w 1684084"/>
                <a:gd name="connsiteY0" fmla="*/ 229341 h 1968707"/>
                <a:gd name="connsiteX1" fmla="*/ 726998 w 1684084"/>
                <a:gd name="connsiteY1" fmla="*/ 3563 h 1968707"/>
                <a:gd name="connsiteX2" fmla="*/ 399620 w 1684084"/>
                <a:gd name="connsiteY2" fmla="*/ 116452 h 1968707"/>
                <a:gd name="connsiteX3" fmla="*/ 331887 w 1684084"/>
                <a:gd name="connsiteY3" fmla="*/ 443830 h 1968707"/>
                <a:gd name="connsiteX4" fmla="*/ 4509 w 1684084"/>
                <a:gd name="connsiteY4" fmla="*/ 726052 h 1968707"/>
                <a:gd name="connsiteX5" fmla="*/ 151264 w 1684084"/>
                <a:gd name="connsiteY5" fmla="*/ 1301786 h 1968707"/>
                <a:gd name="connsiteX6" fmla="*/ 293162 w 1684084"/>
                <a:gd name="connsiteY6" fmla="*/ 1448749 h 1968707"/>
                <a:gd name="connsiteX7" fmla="*/ 591531 w 1684084"/>
                <a:gd name="connsiteY7" fmla="*/ 1617875 h 1968707"/>
                <a:gd name="connsiteX8" fmla="*/ 765499 w 1684084"/>
                <a:gd name="connsiteY8" fmla="*/ 1428305 h 1968707"/>
                <a:gd name="connsiteX9" fmla="*/ 986642 w 1684084"/>
                <a:gd name="connsiteY9" fmla="*/ 1967830 h 1968707"/>
                <a:gd name="connsiteX10" fmla="*/ 1189842 w 1684084"/>
                <a:gd name="connsiteY10" fmla="*/ 1550141 h 1968707"/>
                <a:gd name="connsiteX11" fmla="*/ 1325309 w 1684084"/>
                <a:gd name="connsiteY11" fmla="*/ 1369519 h 1968707"/>
                <a:gd name="connsiteX12" fmla="*/ 1675264 w 1684084"/>
                <a:gd name="connsiteY12" fmla="*/ 1132452 h 1968707"/>
                <a:gd name="connsiteX13" fmla="*/ 1584953 w 1684084"/>
                <a:gd name="connsiteY13" fmla="*/ 771208 h 1968707"/>
                <a:gd name="connsiteX14" fmla="*/ 1652687 w 1684084"/>
                <a:gd name="connsiteY14" fmla="*/ 398675 h 1968707"/>
                <a:gd name="connsiteX15" fmla="*/ 1234998 w 1684084"/>
                <a:gd name="connsiteY15" fmla="*/ 229341 h 1968707"/>
                <a:gd name="connsiteX0" fmla="*/ 1084448 w 1533534"/>
                <a:gd name="connsiteY0" fmla="*/ 229341 h 1968707"/>
                <a:gd name="connsiteX1" fmla="*/ 576448 w 1533534"/>
                <a:gd name="connsiteY1" fmla="*/ 3563 h 1968707"/>
                <a:gd name="connsiteX2" fmla="*/ 249070 w 1533534"/>
                <a:gd name="connsiteY2" fmla="*/ 116452 h 1968707"/>
                <a:gd name="connsiteX3" fmla="*/ 181337 w 1533534"/>
                <a:gd name="connsiteY3" fmla="*/ 443830 h 1968707"/>
                <a:gd name="connsiteX4" fmla="*/ 91673 w 1533534"/>
                <a:gd name="connsiteY4" fmla="*/ 939634 h 1968707"/>
                <a:gd name="connsiteX5" fmla="*/ 714 w 1533534"/>
                <a:gd name="connsiteY5" fmla="*/ 1301786 h 1968707"/>
                <a:gd name="connsiteX6" fmla="*/ 142612 w 1533534"/>
                <a:gd name="connsiteY6" fmla="*/ 1448749 h 1968707"/>
                <a:gd name="connsiteX7" fmla="*/ 440981 w 1533534"/>
                <a:gd name="connsiteY7" fmla="*/ 1617875 h 1968707"/>
                <a:gd name="connsiteX8" fmla="*/ 614949 w 1533534"/>
                <a:gd name="connsiteY8" fmla="*/ 1428305 h 1968707"/>
                <a:gd name="connsiteX9" fmla="*/ 836092 w 1533534"/>
                <a:gd name="connsiteY9" fmla="*/ 1967830 h 1968707"/>
                <a:gd name="connsiteX10" fmla="*/ 1039292 w 1533534"/>
                <a:gd name="connsiteY10" fmla="*/ 1550141 h 1968707"/>
                <a:gd name="connsiteX11" fmla="*/ 1174759 w 1533534"/>
                <a:gd name="connsiteY11" fmla="*/ 1369519 h 1968707"/>
                <a:gd name="connsiteX12" fmla="*/ 1524714 w 1533534"/>
                <a:gd name="connsiteY12" fmla="*/ 1132452 h 1968707"/>
                <a:gd name="connsiteX13" fmla="*/ 1434403 w 1533534"/>
                <a:gd name="connsiteY13" fmla="*/ 771208 h 1968707"/>
                <a:gd name="connsiteX14" fmla="*/ 1502137 w 1533534"/>
                <a:gd name="connsiteY14" fmla="*/ 398675 h 1968707"/>
                <a:gd name="connsiteX15" fmla="*/ 1084448 w 1533534"/>
                <a:gd name="connsiteY15" fmla="*/ 229341 h 1968707"/>
                <a:gd name="connsiteX0" fmla="*/ 1084448 w 1533534"/>
                <a:gd name="connsiteY0" fmla="*/ 229341 h 1617945"/>
                <a:gd name="connsiteX1" fmla="*/ 576448 w 1533534"/>
                <a:gd name="connsiteY1" fmla="*/ 3563 h 1617945"/>
                <a:gd name="connsiteX2" fmla="*/ 249070 w 1533534"/>
                <a:gd name="connsiteY2" fmla="*/ 116452 h 1617945"/>
                <a:gd name="connsiteX3" fmla="*/ 181337 w 1533534"/>
                <a:gd name="connsiteY3" fmla="*/ 443830 h 1617945"/>
                <a:gd name="connsiteX4" fmla="*/ 91673 w 1533534"/>
                <a:gd name="connsiteY4" fmla="*/ 939634 h 1617945"/>
                <a:gd name="connsiteX5" fmla="*/ 714 w 1533534"/>
                <a:gd name="connsiteY5" fmla="*/ 1301786 h 1617945"/>
                <a:gd name="connsiteX6" fmla="*/ 142612 w 1533534"/>
                <a:gd name="connsiteY6" fmla="*/ 1448749 h 1617945"/>
                <a:gd name="connsiteX7" fmla="*/ 440981 w 1533534"/>
                <a:gd name="connsiteY7" fmla="*/ 1617875 h 1617945"/>
                <a:gd name="connsiteX8" fmla="*/ 614949 w 1533534"/>
                <a:gd name="connsiteY8" fmla="*/ 1428305 h 1617945"/>
                <a:gd name="connsiteX9" fmla="*/ 880934 w 1533534"/>
                <a:gd name="connsiteY9" fmla="*/ 1480073 h 1617945"/>
                <a:gd name="connsiteX10" fmla="*/ 1039292 w 1533534"/>
                <a:gd name="connsiteY10" fmla="*/ 1550141 h 1617945"/>
                <a:gd name="connsiteX11" fmla="*/ 1174759 w 1533534"/>
                <a:gd name="connsiteY11" fmla="*/ 1369519 h 1617945"/>
                <a:gd name="connsiteX12" fmla="*/ 1524714 w 1533534"/>
                <a:gd name="connsiteY12" fmla="*/ 1132452 h 1617945"/>
                <a:gd name="connsiteX13" fmla="*/ 1434403 w 1533534"/>
                <a:gd name="connsiteY13" fmla="*/ 771208 h 1617945"/>
                <a:gd name="connsiteX14" fmla="*/ 1502137 w 1533534"/>
                <a:gd name="connsiteY14" fmla="*/ 398675 h 1617945"/>
                <a:gd name="connsiteX15" fmla="*/ 1084448 w 1533534"/>
                <a:gd name="connsiteY15" fmla="*/ 229341 h 1617945"/>
                <a:gd name="connsiteX0" fmla="*/ 1084448 w 1540741"/>
                <a:gd name="connsiteY0" fmla="*/ 229341 h 1617945"/>
                <a:gd name="connsiteX1" fmla="*/ 576448 w 1540741"/>
                <a:gd name="connsiteY1" fmla="*/ 3563 h 1617945"/>
                <a:gd name="connsiteX2" fmla="*/ 249070 w 1540741"/>
                <a:gd name="connsiteY2" fmla="*/ 116452 h 1617945"/>
                <a:gd name="connsiteX3" fmla="*/ 181337 w 1540741"/>
                <a:gd name="connsiteY3" fmla="*/ 443830 h 1617945"/>
                <a:gd name="connsiteX4" fmla="*/ 91673 w 1540741"/>
                <a:gd name="connsiteY4" fmla="*/ 939634 h 1617945"/>
                <a:gd name="connsiteX5" fmla="*/ 714 w 1540741"/>
                <a:gd name="connsiteY5" fmla="*/ 1301786 h 1617945"/>
                <a:gd name="connsiteX6" fmla="*/ 142612 w 1540741"/>
                <a:gd name="connsiteY6" fmla="*/ 1448749 h 1617945"/>
                <a:gd name="connsiteX7" fmla="*/ 440981 w 1540741"/>
                <a:gd name="connsiteY7" fmla="*/ 1617875 h 1617945"/>
                <a:gd name="connsiteX8" fmla="*/ 614949 w 1540741"/>
                <a:gd name="connsiteY8" fmla="*/ 1428305 h 1617945"/>
                <a:gd name="connsiteX9" fmla="*/ 880934 w 1540741"/>
                <a:gd name="connsiteY9" fmla="*/ 1480073 h 1617945"/>
                <a:gd name="connsiteX10" fmla="*/ 1039292 w 1540741"/>
                <a:gd name="connsiteY10" fmla="*/ 1550141 h 1617945"/>
                <a:gd name="connsiteX11" fmla="*/ 1174759 w 1540741"/>
                <a:gd name="connsiteY11" fmla="*/ 1369519 h 1617945"/>
                <a:gd name="connsiteX12" fmla="*/ 1046997 w 1540741"/>
                <a:gd name="connsiteY12" fmla="*/ 1265761 h 1617945"/>
                <a:gd name="connsiteX13" fmla="*/ 1524714 w 1540741"/>
                <a:gd name="connsiteY13" fmla="*/ 1132452 h 1617945"/>
                <a:gd name="connsiteX14" fmla="*/ 1434403 w 1540741"/>
                <a:gd name="connsiteY14" fmla="*/ 771208 h 1617945"/>
                <a:gd name="connsiteX15" fmla="*/ 1502137 w 1540741"/>
                <a:gd name="connsiteY15" fmla="*/ 398675 h 1617945"/>
                <a:gd name="connsiteX16" fmla="*/ 1084448 w 1540741"/>
                <a:gd name="connsiteY16" fmla="*/ 229341 h 1617945"/>
                <a:gd name="connsiteX0" fmla="*/ 1084448 w 1515179"/>
                <a:gd name="connsiteY0" fmla="*/ 229341 h 1617945"/>
                <a:gd name="connsiteX1" fmla="*/ 576448 w 1515179"/>
                <a:gd name="connsiteY1" fmla="*/ 3563 h 1617945"/>
                <a:gd name="connsiteX2" fmla="*/ 249070 w 1515179"/>
                <a:gd name="connsiteY2" fmla="*/ 116452 h 1617945"/>
                <a:gd name="connsiteX3" fmla="*/ 181337 w 1515179"/>
                <a:gd name="connsiteY3" fmla="*/ 443830 h 1617945"/>
                <a:gd name="connsiteX4" fmla="*/ 91673 w 1515179"/>
                <a:gd name="connsiteY4" fmla="*/ 939634 h 1617945"/>
                <a:gd name="connsiteX5" fmla="*/ 714 w 1515179"/>
                <a:gd name="connsiteY5" fmla="*/ 1301786 h 1617945"/>
                <a:gd name="connsiteX6" fmla="*/ 142612 w 1515179"/>
                <a:gd name="connsiteY6" fmla="*/ 1448749 h 1617945"/>
                <a:gd name="connsiteX7" fmla="*/ 440981 w 1515179"/>
                <a:gd name="connsiteY7" fmla="*/ 1617875 h 1617945"/>
                <a:gd name="connsiteX8" fmla="*/ 614949 w 1515179"/>
                <a:gd name="connsiteY8" fmla="*/ 1428305 h 1617945"/>
                <a:gd name="connsiteX9" fmla="*/ 880934 w 1515179"/>
                <a:gd name="connsiteY9" fmla="*/ 1480073 h 1617945"/>
                <a:gd name="connsiteX10" fmla="*/ 1039292 w 1515179"/>
                <a:gd name="connsiteY10" fmla="*/ 1550141 h 1617945"/>
                <a:gd name="connsiteX11" fmla="*/ 1174759 w 1515179"/>
                <a:gd name="connsiteY11" fmla="*/ 1369519 h 1617945"/>
                <a:gd name="connsiteX12" fmla="*/ 1046997 w 1515179"/>
                <a:gd name="connsiteY12" fmla="*/ 1265761 h 1617945"/>
                <a:gd name="connsiteX13" fmla="*/ 1324231 w 1515179"/>
                <a:gd name="connsiteY13" fmla="*/ 1104484 h 1617945"/>
                <a:gd name="connsiteX14" fmla="*/ 1434403 w 1515179"/>
                <a:gd name="connsiteY14" fmla="*/ 771208 h 1617945"/>
                <a:gd name="connsiteX15" fmla="*/ 1502137 w 1515179"/>
                <a:gd name="connsiteY15" fmla="*/ 398675 h 1617945"/>
                <a:gd name="connsiteX16" fmla="*/ 1084448 w 1515179"/>
                <a:gd name="connsiteY16" fmla="*/ 229341 h 1617945"/>
                <a:gd name="connsiteX0" fmla="*/ 1084448 w 1503107"/>
                <a:gd name="connsiteY0" fmla="*/ 229341 h 1617945"/>
                <a:gd name="connsiteX1" fmla="*/ 576448 w 1503107"/>
                <a:gd name="connsiteY1" fmla="*/ 3563 h 1617945"/>
                <a:gd name="connsiteX2" fmla="*/ 249070 w 1503107"/>
                <a:gd name="connsiteY2" fmla="*/ 116452 h 1617945"/>
                <a:gd name="connsiteX3" fmla="*/ 181337 w 1503107"/>
                <a:gd name="connsiteY3" fmla="*/ 443830 h 1617945"/>
                <a:gd name="connsiteX4" fmla="*/ 91673 w 1503107"/>
                <a:gd name="connsiteY4" fmla="*/ 939634 h 1617945"/>
                <a:gd name="connsiteX5" fmla="*/ 714 w 1503107"/>
                <a:gd name="connsiteY5" fmla="*/ 1301786 h 1617945"/>
                <a:gd name="connsiteX6" fmla="*/ 142612 w 1503107"/>
                <a:gd name="connsiteY6" fmla="*/ 1448749 h 1617945"/>
                <a:gd name="connsiteX7" fmla="*/ 440981 w 1503107"/>
                <a:gd name="connsiteY7" fmla="*/ 1617875 h 1617945"/>
                <a:gd name="connsiteX8" fmla="*/ 614949 w 1503107"/>
                <a:gd name="connsiteY8" fmla="*/ 1428305 h 1617945"/>
                <a:gd name="connsiteX9" fmla="*/ 880934 w 1503107"/>
                <a:gd name="connsiteY9" fmla="*/ 1480073 h 1617945"/>
                <a:gd name="connsiteX10" fmla="*/ 1039292 w 1503107"/>
                <a:gd name="connsiteY10" fmla="*/ 1550141 h 1617945"/>
                <a:gd name="connsiteX11" fmla="*/ 1174759 w 1503107"/>
                <a:gd name="connsiteY11" fmla="*/ 1369519 h 1617945"/>
                <a:gd name="connsiteX12" fmla="*/ 1046997 w 1503107"/>
                <a:gd name="connsiteY12" fmla="*/ 1265761 h 1617945"/>
                <a:gd name="connsiteX13" fmla="*/ 1324231 w 1503107"/>
                <a:gd name="connsiteY13" fmla="*/ 1104484 h 1617945"/>
                <a:gd name="connsiteX14" fmla="*/ 1208830 w 1503107"/>
                <a:gd name="connsiteY14" fmla="*/ 756925 h 1617945"/>
                <a:gd name="connsiteX15" fmla="*/ 1502137 w 1503107"/>
                <a:gd name="connsiteY15" fmla="*/ 398675 h 1617945"/>
                <a:gd name="connsiteX16" fmla="*/ 1084448 w 1503107"/>
                <a:gd name="connsiteY16" fmla="*/ 229341 h 1617945"/>
                <a:gd name="connsiteX0" fmla="*/ 1084448 w 1508668"/>
                <a:gd name="connsiteY0" fmla="*/ 229341 h 1617945"/>
                <a:gd name="connsiteX1" fmla="*/ 576448 w 1508668"/>
                <a:gd name="connsiteY1" fmla="*/ 3563 h 1617945"/>
                <a:gd name="connsiteX2" fmla="*/ 249070 w 1508668"/>
                <a:gd name="connsiteY2" fmla="*/ 116452 h 1617945"/>
                <a:gd name="connsiteX3" fmla="*/ 181337 w 1508668"/>
                <a:gd name="connsiteY3" fmla="*/ 443830 h 1617945"/>
                <a:gd name="connsiteX4" fmla="*/ 91673 w 1508668"/>
                <a:gd name="connsiteY4" fmla="*/ 939634 h 1617945"/>
                <a:gd name="connsiteX5" fmla="*/ 714 w 1508668"/>
                <a:gd name="connsiteY5" fmla="*/ 1301786 h 1617945"/>
                <a:gd name="connsiteX6" fmla="*/ 142612 w 1508668"/>
                <a:gd name="connsiteY6" fmla="*/ 1448749 h 1617945"/>
                <a:gd name="connsiteX7" fmla="*/ 440981 w 1508668"/>
                <a:gd name="connsiteY7" fmla="*/ 1617875 h 1617945"/>
                <a:gd name="connsiteX8" fmla="*/ 614949 w 1508668"/>
                <a:gd name="connsiteY8" fmla="*/ 1428305 h 1617945"/>
                <a:gd name="connsiteX9" fmla="*/ 880934 w 1508668"/>
                <a:gd name="connsiteY9" fmla="*/ 1480073 h 1617945"/>
                <a:gd name="connsiteX10" fmla="*/ 1039292 w 1508668"/>
                <a:gd name="connsiteY10" fmla="*/ 1550141 h 1617945"/>
                <a:gd name="connsiteX11" fmla="*/ 1174759 w 1508668"/>
                <a:gd name="connsiteY11" fmla="*/ 1369519 h 1617945"/>
                <a:gd name="connsiteX12" fmla="*/ 1046997 w 1508668"/>
                <a:gd name="connsiteY12" fmla="*/ 1265761 h 1617945"/>
                <a:gd name="connsiteX13" fmla="*/ 1324231 w 1508668"/>
                <a:gd name="connsiteY13" fmla="*/ 1104484 h 1617945"/>
                <a:gd name="connsiteX14" fmla="*/ 1208830 w 1508668"/>
                <a:gd name="connsiteY14" fmla="*/ 756925 h 1617945"/>
                <a:gd name="connsiteX15" fmla="*/ 1330580 w 1508668"/>
                <a:gd name="connsiteY15" fmla="*/ 476239 h 1617945"/>
                <a:gd name="connsiteX16" fmla="*/ 1502137 w 1508668"/>
                <a:gd name="connsiteY16" fmla="*/ 398675 h 1617945"/>
                <a:gd name="connsiteX17" fmla="*/ 1084448 w 1508668"/>
                <a:gd name="connsiteY17" fmla="*/ 229341 h 1617945"/>
                <a:gd name="connsiteX0" fmla="*/ 1084448 w 1341772"/>
                <a:gd name="connsiteY0" fmla="*/ 229341 h 1617945"/>
                <a:gd name="connsiteX1" fmla="*/ 576448 w 1341772"/>
                <a:gd name="connsiteY1" fmla="*/ 3563 h 1617945"/>
                <a:gd name="connsiteX2" fmla="*/ 249070 w 1341772"/>
                <a:gd name="connsiteY2" fmla="*/ 116452 h 1617945"/>
                <a:gd name="connsiteX3" fmla="*/ 181337 w 1341772"/>
                <a:gd name="connsiteY3" fmla="*/ 443830 h 1617945"/>
                <a:gd name="connsiteX4" fmla="*/ 91673 w 1341772"/>
                <a:gd name="connsiteY4" fmla="*/ 939634 h 1617945"/>
                <a:gd name="connsiteX5" fmla="*/ 714 w 1341772"/>
                <a:gd name="connsiteY5" fmla="*/ 1301786 h 1617945"/>
                <a:gd name="connsiteX6" fmla="*/ 142612 w 1341772"/>
                <a:gd name="connsiteY6" fmla="*/ 1448749 h 1617945"/>
                <a:gd name="connsiteX7" fmla="*/ 440981 w 1341772"/>
                <a:gd name="connsiteY7" fmla="*/ 1617875 h 1617945"/>
                <a:gd name="connsiteX8" fmla="*/ 614949 w 1341772"/>
                <a:gd name="connsiteY8" fmla="*/ 1428305 h 1617945"/>
                <a:gd name="connsiteX9" fmla="*/ 880934 w 1341772"/>
                <a:gd name="connsiteY9" fmla="*/ 1480073 h 1617945"/>
                <a:gd name="connsiteX10" fmla="*/ 1039292 w 1341772"/>
                <a:gd name="connsiteY10" fmla="*/ 1550141 h 1617945"/>
                <a:gd name="connsiteX11" fmla="*/ 1174759 w 1341772"/>
                <a:gd name="connsiteY11" fmla="*/ 1369519 h 1617945"/>
                <a:gd name="connsiteX12" fmla="*/ 1046997 w 1341772"/>
                <a:gd name="connsiteY12" fmla="*/ 1265761 h 1617945"/>
                <a:gd name="connsiteX13" fmla="*/ 1324231 w 1341772"/>
                <a:gd name="connsiteY13" fmla="*/ 1104484 h 1617945"/>
                <a:gd name="connsiteX14" fmla="*/ 1208830 w 1341772"/>
                <a:gd name="connsiteY14" fmla="*/ 756925 h 1617945"/>
                <a:gd name="connsiteX15" fmla="*/ 1330580 w 1341772"/>
                <a:gd name="connsiteY15" fmla="*/ 476239 h 1617945"/>
                <a:gd name="connsiteX16" fmla="*/ 1213826 w 1341772"/>
                <a:gd name="connsiteY16" fmla="*/ 418597 h 1617945"/>
                <a:gd name="connsiteX17" fmla="*/ 1084448 w 1341772"/>
                <a:gd name="connsiteY17" fmla="*/ 229341 h 1617945"/>
                <a:gd name="connsiteX0" fmla="*/ 1084436 w 1341760"/>
                <a:gd name="connsiteY0" fmla="*/ 229341 h 1617945"/>
                <a:gd name="connsiteX1" fmla="*/ 576436 w 1341760"/>
                <a:gd name="connsiteY1" fmla="*/ 3563 h 1617945"/>
                <a:gd name="connsiteX2" fmla="*/ 249058 w 1341760"/>
                <a:gd name="connsiteY2" fmla="*/ 116452 h 1617945"/>
                <a:gd name="connsiteX3" fmla="*/ 181325 w 1341760"/>
                <a:gd name="connsiteY3" fmla="*/ 443830 h 1617945"/>
                <a:gd name="connsiteX4" fmla="*/ 172294 w 1341760"/>
                <a:gd name="connsiteY4" fmla="*/ 901924 h 1617945"/>
                <a:gd name="connsiteX5" fmla="*/ 91661 w 1341760"/>
                <a:gd name="connsiteY5" fmla="*/ 939634 h 1617945"/>
                <a:gd name="connsiteX6" fmla="*/ 702 w 1341760"/>
                <a:gd name="connsiteY6" fmla="*/ 1301786 h 1617945"/>
                <a:gd name="connsiteX7" fmla="*/ 142600 w 1341760"/>
                <a:gd name="connsiteY7" fmla="*/ 1448749 h 1617945"/>
                <a:gd name="connsiteX8" fmla="*/ 440969 w 1341760"/>
                <a:gd name="connsiteY8" fmla="*/ 1617875 h 1617945"/>
                <a:gd name="connsiteX9" fmla="*/ 614937 w 1341760"/>
                <a:gd name="connsiteY9" fmla="*/ 1428305 h 1617945"/>
                <a:gd name="connsiteX10" fmla="*/ 880922 w 1341760"/>
                <a:gd name="connsiteY10" fmla="*/ 1480073 h 1617945"/>
                <a:gd name="connsiteX11" fmla="*/ 1039280 w 1341760"/>
                <a:gd name="connsiteY11" fmla="*/ 1550141 h 1617945"/>
                <a:gd name="connsiteX12" fmla="*/ 1174747 w 1341760"/>
                <a:gd name="connsiteY12" fmla="*/ 1369519 h 1617945"/>
                <a:gd name="connsiteX13" fmla="*/ 1046985 w 1341760"/>
                <a:gd name="connsiteY13" fmla="*/ 1265761 h 1617945"/>
                <a:gd name="connsiteX14" fmla="*/ 1324219 w 1341760"/>
                <a:gd name="connsiteY14" fmla="*/ 1104484 h 1617945"/>
                <a:gd name="connsiteX15" fmla="*/ 1208818 w 1341760"/>
                <a:gd name="connsiteY15" fmla="*/ 756925 h 1617945"/>
                <a:gd name="connsiteX16" fmla="*/ 1330568 w 1341760"/>
                <a:gd name="connsiteY16" fmla="*/ 476239 h 1617945"/>
                <a:gd name="connsiteX17" fmla="*/ 1213814 w 1341760"/>
                <a:gd name="connsiteY17" fmla="*/ 418597 h 1617945"/>
                <a:gd name="connsiteX18" fmla="*/ 1084436 w 1341760"/>
                <a:gd name="connsiteY18" fmla="*/ 229341 h 1617945"/>
                <a:gd name="connsiteX0" fmla="*/ 1084436 w 1341760"/>
                <a:gd name="connsiteY0" fmla="*/ 229341 h 1617945"/>
                <a:gd name="connsiteX1" fmla="*/ 576436 w 1341760"/>
                <a:gd name="connsiteY1" fmla="*/ 3563 h 1617945"/>
                <a:gd name="connsiteX2" fmla="*/ 249058 w 1341760"/>
                <a:gd name="connsiteY2" fmla="*/ 116452 h 1617945"/>
                <a:gd name="connsiteX3" fmla="*/ 181325 w 1341760"/>
                <a:gd name="connsiteY3" fmla="*/ 443830 h 1617945"/>
                <a:gd name="connsiteX4" fmla="*/ 94473 w 1341760"/>
                <a:gd name="connsiteY4" fmla="*/ 644067 h 1617945"/>
                <a:gd name="connsiteX5" fmla="*/ 172294 w 1341760"/>
                <a:gd name="connsiteY5" fmla="*/ 901924 h 1617945"/>
                <a:gd name="connsiteX6" fmla="*/ 91661 w 1341760"/>
                <a:gd name="connsiteY6" fmla="*/ 939634 h 1617945"/>
                <a:gd name="connsiteX7" fmla="*/ 702 w 1341760"/>
                <a:gd name="connsiteY7" fmla="*/ 1301786 h 1617945"/>
                <a:gd name="connsiteX8" fmla="*/ 142600 w 1341760"/>
                <a:gd name="connsiteY8" fmla="*/ 1448749 h 1617945"/>
                <a:gd name="connsiteX9" fmla="*/ 440969 w 1341760"/>
                <a:gd name="connsiteY9" fmla="*/ 1617875 h 1617945"/>
                <a:gd name="connsiteX10" fmla="*/ 614937 w 1341760"/>
                <a:gd name="connsiteY10" fmla="*/ 1428305 h 1617945"/>
                <a:gd name="connsiteX11" fmla="*/ 880922 w 1341760"/>
                <a:gd name="connsiteY11" fmla="*/ 1480073 h 1617945"/>
                <a:gd name="connsiteX12" fmla="*/ 1039280 w 1341760"/>
                <a:gd name="connsiteY12" fmla="*/ 1550141 h 1617945"/>
                <a:gd name="connsiteX13" fmla="*/ 1174747 w 1341760"/>
                <a:gd name="connsiteY13" fmla="*/ 1369519 h 1617945"/>
                <a:gd name="connsiteX14" fmla="*/ 1046985 w 1341760"/>
                <a:gd name="connsiteY14" fmla="*/ 1265761 h 1617945"/>
                <a:gd name="connsiteX15" fmla="*/ 1324219 w 1341760"/>
                <a:gd name="connsiteY15" fmla="*/ 1104484 h 1617945"/>
                <a:gd name="connsiteX16" fmla="*/ 1208818 w 1341760"/>
                <a:gd name="connsiteY16" fmla="*/ 756925 h 1617945"/>
                <a:gd name="connsiteX17" fmla="*/ 1330568 w 1341760"/>
                <a:gd name="connsiteY17" fmla="*/ 476239 h 1617945"/>
                <a:gd name="connsiteX18" fmla="*/ 1213814 w 1341760"/>
                <a:gd name="connsiteY18" fmla="*/ 418597 h 1617945"/>
                <a:gd name="connsiteX19" fmla="*/ 1084436 w 1341760"/>
                <a:gd name="connsiteY19" fmla="*/ 229341 h 1617945"/>
                <a:gd name="connsiteX0" fmla="*/ 1084436 w 1341760"/>
                <a:gd name="connsiteY0" fmla="*/ 230005 h 1618609"/>
                <a:gd name="connsiteX1" fmla="*/ 576436 w 1341760"/>
                <a:gd name="connsiteY1" fmla="*/ 4227 h 1618609"/>
                <a:gd name="connsiteX2" fmla="*/ 249058 w 1341760"/>
                <a:gd name="connsiteY2" fmla="*/ 117116 h 1618609"/>
                <a:gd name="connsiteX3" fmla="*/ 240701 w 1341760"/>
                <a:gd name="connsiteY3" fmla="*/ 523657 h 1618609"/>
                <a:gd name="connsiteX4" fmla="*/ 94473 w 1341760"/>
                <a:gd name="connsiteY4" fmla="*/ 644731 h 1618609"/>
                <a:gd name="connsiteX5" fmla="*/ 172294 w 1341760"/>
                <a:gd name="connsiteY5" fmla="*/ 902588 h 1618609"/>
                <a:gd name="connsiteX6" fmla="*/ 91661 w 1341760"/>
                <a:gd name="connsiteY6" fmla="*/ 940298 h 1618609"/>
                <a:gd name="connsiteX7" fmla="*/ 702 w 1341760"/>
                <a:gd name="connsiteY7" fmla="*/ 1302450 h 1618609"/>
                <a:gd name="connsiteX8" fmla="*/ 142600 w 1341760"/>
                <a:gd name="connsiteY8" fmla="*/ 1449413 h 1618609"/>
                <a:gd name="connsiteX9" fmla="*/ 440969 w 1341760"/>
                <a:gd name="connsiteY9" fmla="*/ 1618539 h 1618609"/>
                <a:gd name="connsiteX10" fmla="*/ 614937 w 1341760"/>
                <a:gd name="connsiteY10" fmla="*/ 1428969 h 1618609"/>
                <a:gd name="connsiteX11" fmla="*/ 880922 w 1341760"/>
                <a:gd name="connsiteY11" fmla="*/ 1480737 h 1618609"/>
                <a:gd name="connsiteX12" fmla="*/ 1039280 w 1341760"/>
                <a:gd name="connsiteY12" fmla="*/ 1550805 h 1618609"/>
                <a:gd name="connsiteX13" fmla="*/ 1174747 w 1341760"/>
                <a:gd name="connsiteY13" fmla="*/ 1370183 h 1618609"/>
                <a:gd name="connsiteX14" fmla="*/ 1046985 w 1341760"/>
                <a:gd name="connsiteY14" fmla="*/ 1266425 h 1618609"/>
                <a:gd name="connsiteX15" fmla="*/ 1324219 w 1341760"/>
                <a:gd name="connsiteY15" fmla="*/ 1105148 h 1618609"/>
                <a:gd name="connsiteX16" fmla="*/ 1208818 w 1341760"/>
                <a:gd name="connsiteY16" fmla="*/ 757589 h 1618609"/>
                <a:gd name="connsiteX17" fmla="*/ 1330568 w 1341760"/>
                <a:gd name="connsiteY17" fmla="*/ 476903 h 1618609"/>
                <a:gd name="connsiteX18" fmla="*/ 1213814 w 1341760"/>
                <a:gd name="connsiteY18" fmla="*/ 419261 h 1618609"/>
                <a:gd name="connsiteX19" fmla="*/ 1084436 w 1341760"/>
                <a:gd name="connsiteY19" fmla="*/ 230005 h 1618609"/>
                <a:gd name="connsiteX0" fmla="*/ 1084436 w 1341760"/>
                <a:gd name="connsiteY0" fmla="*/ 228691 h 1617295"/>
                <a:gd name="connsiteX1" fmla="*/ 576436 w 1341760"/>
                <a:gd name="connsiteY1" fmla="*/ 2913 h 1617295"/>
                <a:gd name="connsiteX2" fmla="*/ 249058 w 1341760"/>
                <a:gd name="connsiteY2" fmla="*/ 115802 h 1617295"/>
                <a:gd name="connsiteX3" fmla="*/ 314426 w 1341760"/>
                <a:gd name="connsiteY3" fmla="*/ 334738 h 1617295"/>
                <a:gd name="connsiteX4" fmla="*/ 240701 w 1341760"/>
                <a:gd name="connsiteY4" fmla="*/ 522343 h 1617295"/>
                <a:gd name="connsiteX5" fmla="*/ 94473 w 1341760"/>
                <a:gd name="connsiteY5" fmla="*/ 643417 h 1617295"/>
                <a:gd name="connsiteX6" fmla="*/ 172294 w 1341760"/>
                <a:gd name="connsiteY6" fmla="*/ 901274 h 1617295"/>
                <a:gd name="connsiteX7" fmla="*/ 91661 w 1341760"/>
                <a:gd name="connsiteY7" fmla="*/ 938984 h 1617295"/>
                <a:gd name="connsiteX8" fmla="*/ 702 w 1341760"/>
                <a:gd name="connsiteY8" fmla="*/ 1301136 h 1617295"/>
                <a:gd name="connsiteX9" fmla="*/ 142600 w 1341760"/>
                <a:gd name="connsiteY9" fmla="*/ 1448099 h 1617295"/>
                <a:gd name="connsiteX10" fmla="*/ 440969 w 1341760"/>
                <a:gd name="connsiteY10" fmla="*/ 1617225 h 1617295"/>
                <a:gd name="connsiteX11" fmla="*/ 614937 w 1341760"/>
                <a:gd name="connsiteY11" fmla="*/ 1427655 h 1617295"/>
                <a:gd name="connsiteX12" fmla="*/ 880922 w 1341760"/>
                <a:gd name="connsiteY12" fmla="*/ 1479423 h 1617295"/>
                <a:gd name="connsiteX13" fmla="*/ 1039280 w 1341760"/>
                <a:gd name="connsiteY13" fmla="*/ 1549491 h 1617295"/>
                <a:gd name="connsiteX14" fmla="*/ 1174747 w 1341760"/>
                <a:gd name="connsiteY14" fmla="*/ 1368869 h 1617295"/>
                <a:gd name="connsiteX15" fmla="*/ 1046985 w 1341760"/>
                <a:gd name="connsiteY15" fmla="*/ 1265111 h 1617295"/>
                <a:gd name="connsiteX16" fmla="*/ 1324219 w 1341760"/>
                <a:gd name="connsiteY16" fmla="*/ 1103834 h 1617295"/>
                <a:gd name="connsiteX17" fmla="*/ 1208818 w 1341760"/>
                <a:gd name="connsiteY17" fmla="*/ 756275 h 1617295"/>
                <a:gd name="connsiteX18" fmla="*/ 1330568 w 1341760"/>
                <a:gd name="connsiteY18" fmla="*/ 475589 h 1617295"/>
                <a:gd name="connsiteX19" fmla="*/ 1213814 w 1341760"/>
                <a:gd name="connsiteY19" fmla="*/ 417947 h 1617295"/>
                <a:gd name="connsiteX20" fmla="*/ 1084436 w 1341760"/>
                <a:gd name="connsiteY20" fmla="*/ 228691 h 1617295"/>
                <a:gd name="connsiteX0" fmla="*/ 1084436 w 1341760"/>
                <a:gd name="connsiteY0" fmla="*/ 227185 h 1615789"/>
                <a:gd name="connsiteX1" fmla="*/ 576436 w 1341760"/>
                <a:gd name="connsiteY1" fmla="*/ 1407 h 1615789"/>
                <a:gd name="connsiteX2" fmla="*/ 418234 w 1341760"/>
                <a:gd name="connsiteY2" fmla="*/ 130779 h 1615789"/>
                <a:gd name="connsiteX3" fmla="*/ 249058 w 1341760"/>
                <a:gd name="connsiteY3" fmla="*/ 114296 h 1615789"/>
                <a:gd name="connsiteX4" fmla="*/ 314426 w 1341760"/>
                <a:gd name="connsiteY4" fmla="*/ 333232 h 1615789"/>
                <a:gd name="connsiteX5" fmla="*/ 240701 w 1341760"/>
                <a:gd name="connsiteY5" fmla="*/ 520837 h 1615789"/>
                <a:gd name="connsiteX6" fmla="*/ 94473 w 1341760"/>
                <a:gd name="connsiteY6" fmla="*/ 641911 h 1615789"/>
                <a:gd name="connsiteX7" fmla="*/ 172294 w 1341760"/>
                <a:gd name="connsiteY7" fmla="*/ 899768 h 1615789"/>
                <a:gd name="connsiteX8" fmla="*/ 91661 w 1341760"/>
                <a:gd name="connsiteY8" fmla="*/ 937478 h 1615789"/>
                <a:gd name="connsiteX9" fmla="*/ 702 w 1341760"/>
                <a:gd name="connsiteY9" fmla="*/ 1299630 h 1615789"/>
                <a:gd name="connsiteX10" fmla="*/ 142600 w 1341760"/>
                <a:gd name="connsiteY10" fmla="*/ 1446593 h 1615789"/>
                <a:gd name="connsiteX11" fmla="*/ 440969 w 1341760"/>
                <a:gd name="connsiteY11" fmla="*/ 1615719 h 1615789"/>
                <a:gd name="connsiteX12" fmla="*/ 614937 w 1341760"/>
                <a:gd name="connsiteY12" fmla="*/ 1426149 h 1615789"/>
                <a:gd name="connsiteX13" fmla="*/ 880922 w 1341760"/>
                <a:gd name="connsiteY13" fmla="*/ 1477917 h 1615789"/>
                <a:gd name="connsiteX14" fmla="*/ 1039280 w 1341760"/>
                <a:gd name="connsiteY14" fmla="*/ 1547985 h 1615789"/>
                <a:gd name="connsiteX15" fmla="*/ 1174747 w 1341760"/>
                <a:gd name="connsiteY15" fmla="*/ 1367363 h 1615789"/>
                <a:gd name="connsiteX16" fmla="*/ 1046985 w 1341760"/>
                <a:gd name="connsiteY16" fmla="*/ 1263605 h 1615789"/>
                <a:gd name="connsiteX17" fmla="*/ 1324219 w 1341760"/>
                <a:gd name="connsiteY17" fmla="*/ 1102328 h 1615789"/>
                <a:gd name="connsiteX18" fmla="*/ 1208818 w 1341760"/>
                <a:gd name="connsiteY18" fmla="*/ 754769 h 1615789"/>
                <a:gd name="connsiteX19" fmla="*/ 1330568 w 1341760"/>
                <a:gd name="connsiteY19" fmla="*/ 474083 h 1615789"/>
                <a:gd name="connsiteX20" fmla="*/ 1213814 w 1341760"/>
                <a:gd name="connsiteY20" fmla="*/ 416441 h 1615789"/>
                <a:gd name="connsiteX21" fmla="*/ 1084436 w 1341760"/>
                <a:gd name="connsiteY21" fmla="*/ 227185 h 16157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</a:cxnLst>
              <a:rect l="l" t="t" r="r" b="b"/>
              <a:pathLst>
                <a:path w="1341760" h="1615789">
                  <a:moveTo>
                    <a:pt x="1084436" y="227185"/>
                  </a:moveTo>
                  <a:cubicBezTo>
                    <a:pt x="978206" y="158013"/>
                    <a:pt x="687470" y="17475"/>
                    <a:pt x="576436" y="1407"/>
                  </a:cubicBezTo>
                  <a:cubicBezTo>
                    <a:pt x="465402" y="-14661"/>
                    <a:pt x="472797" y="111964"/>
                    <a:pt x="418234" y="130779"/>
                  </a:cubicBezTo>
                  <a:cubicBezTo>
                    <a:pt x="363671" y="149594"/>
                    <a:pt x="266359" y="80554"/>
                    <a:pt x="249058" y="114296"/>
                  </a:cubicBezTo>
                  <a:cubicBezTo>
                    <a:pt x="231757" y="148038"/>
                    <a:pt x="315819" y="265475"/>
                    <a:pt x="314426" y="333232"/>
                  </a:cubicBezTo>
                  <a:cubicBezTo>
                    <a:pt x="313033" y="400989"/>
                    <a:pt x="277360" y="469391"/>
                    <a:pt x="240701" y="520837"/>
                  </a:cubicBezTo>
                  <a:cubicBezTo>
                    <a:pt x="204042" y="572283"/>
                    <a:pt x="95978" y="565562"/>
                    <a:pt x="94473" y="641911"/>
                  </a:cubicBezTo>
                  <a:cubicBezTo>
                    <a:pt x="92968" y="718260"/>
                    <a:pt x="187915" y="846535"/>
                    <a:pt x="172294" y="899768"/>
                  </a:cubicBezTo>
                  <a:cubicBezTo>
                    <a:pt x="156673" y="953001"/>
                    <a:pt x="120260" y="870834"/>
                    <a:pt x="91661" y="937478"/>
                  </a:cubicBezTo>
                  <a:cubicBezTo>
                    <a:pt x="63062" y="1004122"/>
                    <a:pt x="-7788" y="1214778"/>
                    <a:pt x="702" y="1299630"/>
                  </a:cubicBezTo>
                  <a:cubicBezTo>
                    <a:pt x="9192" y="1384482"/>
                    <a:pt x="69222" y="1393911"/>
                    <a:pt x="142600" y="1446593"/>
                  </a:cubicBezTo>
                  <a:cubicBezTo>
                    <a:pt x="215978" y="1499275"/>
                    <a:pt x="362246" y="1619126"/>
                    <a:pt x="440969" y="1615719"/>
                  </a:cubicBezTo>
                  <a:cubicBezTo>
                    <a:pt x="519692" y="1612312"/>
                    <a:pt x="541612" y="1449116"/>
                    <a:pt x="614937" y="1426149"/>
                  </a:cubicBezTo>
                  <a:cubicBezTo>
                    <a:pt x="688262" y="1403182"/>
                    <a:pt x="810198" y="1457611"/>
                    <a:pt x="880922" y="1477917"/>
                  </a:cubicBezTo>
                  <a:cubicBezTo>
                    <a:pt x="951646" y="1498223"/>
                    <a:pt x="990309" y="1566411"/>
                    <a:pt x="1039280" y="1547985"/>
                  </a:cubicBezTo>
                  <a:cubicBezTo>
                    <a:pt x="1088251" y="1529559"/>
                    <a:pt x="1173463" y="1414760"/>
                    <a:pt x="1174747" y="1367363"/>
                  </a:cubicBezTo>
                  <a:cubicBezTo>
                    <a:pt x="1176031" y="1319966"/>
                    <a:pt x="988659" y="1303116"/>
                    <a:pt x="1046985" y="1263605"/>
                  </a:cubicBezTo>
                  <a:cubicBezTo>
                    <a:pt x="1105311" y="1224094"/>
                    <a:pt x="1297247" y="1187134"/>
                    <a:pt x="1324219" y="1102328"/>
                  </a:cubicBezTo>
                  <a:cubicBezTo>
                    <a:pt x="1351191" y="1017522"/>
                    <a:pt x="1196801" y="855442"/>
                    <a:pt x="1208818" y="754769"/>
                  </a:cubicBezTo>
                  <a:cubicBezTo>
                    <a:pt x="1220835" y="654096"/>
                    <a:pt x="1281684" y="533791"/>
                    <a:pt x="1330568" y="474083"/>
                  </a:cubicBezTo>
                  <a:cubicBezTo>
                    <a:pt x="1379453" y="414375"/>
                    <a:pt x="1254836" y="457591"/>
                    <a:pt x="1213814" y="416441"/>
                  </a:cubicBezTo>
                  <a:cubicBezTo>
                    <a:pt x="1172792" y="375291"/>
                    <a:pt x="1190666" y="296357"/>
                    <a:pt x="1084436" y="227185"/>
                  </a:cubicBezTo>
                  <a:close/>
                </a:path>
              </a:pathLst>
            </a:custGeom>
            <a:solidFill>
              <a:schemeClr val="bg1">
                <a:lumMod val="85000"/>
              </a:schemeClr>
            </a:solidFill>
            <a:ln w="6350">
              <a:solidFill>
                <a:schemeClr val="bg1">
                  <a:lumMod val="50000"/>
                </a:schemeClr>
              </a:solidFill>
              <a:prstDash val="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45" name="Forme libre 344"/>
            <p:cNvSpPr/>
            <p:nvPr/>
          </p:nvSpPr>
          <p:spPr>
            <a:xfrm rot="5708885">
              <a:off x="5153903" y="1207244"/>
              <a:ext cx="312705" cy="211849"/>
            </a:xfrm>
            <a:custGeom>
              <a:avLst/>
              <a:gdLst>
                <a:gd name="connsiteX0" fmla="*/ 599693 w 1256584"/>
                <a:gd name="connsiteY0" fmla="*/ 3208 h 826201"/>
                <a:gd name="connsiteX1" fmla="*/ 80404 w 1256584"/>
                <a:gd name="connsiteY1" fmla="*/ 138675 h 826201"/>
                <a:gd name="connsiteX2" fmla="*/ 80404 w 1256584"/>
                <a:gd name="connsiteY2" fmla="*/ 612808 h 826201"/>
                <a:gd name="connsiteX3" fmla="*/ 836760 w 1256584"/>
                <a:gd name="connsiteY3" fmla="*/ 816008 h 826201"/>
                <a:gd name="connsiteX4" fmla="*/ 1209293 w 1256584"/>
                <a:gd name="connsiteY4" fmla="*/ 736986 h 826201"/>
                <a:gd name="connsiteX5" fmla="*/ 1186715 w 1256584"/>
                <a:gd name="connsiteY5" fmla="*/ 240275 h 826201"/>
                <a:gd name="connsiteX6" fmla="*/ 599693 w 1256584"/>
                <a:gd name="connsiteY6" fmla="*/ 3208 h 826201"/>
                <a:gd name="connsiteX0" fmla="*/ 599693 w 1256584"/>
                <a:gd name="connsiteY0" fmla="*/ 3208 h 826201"/>
                <a:gd name="connsiteX1" fmla="*/ 80404 w 1256584"/>
                <a:gd name="connsiteY1" fmla="*/ 138675 h 826201"/>
                <a:gd name="connsiteX2" fmla="*/ 80404 w 1256584"/>
                <a:gd name="connsiteY2" fmla="*/ 612808 h 826201"/>
                <a:gd name="connsiteX3" fmla="*/ 836760 w 1256584"/>
                <a:gd name="connsiteY3" fmla="*/ 816008 h 826201"/>
                <a:gd name="connsiteX4" fmla="*/ 1209293 w 1256584"/>
                <a:gd name="connsiteY4" fmla="*/ 736986 h 826201"/>
                <a:gd name="connsiteX5" fmla="*/ 1186715 w 1256584"/>
                <a:gd name="connsiteY5" fmla="*/ 240275 h 826201"/>
                <a:gd name="connsiteX6" fmla="*/ 747724 w 1256584"/>
                <a:gd name="connsiteY6" fmla="*/ 152847 h 826201"/>
                <a:gd name="connsiteX0" fmla="*/ 459650 w 1249388"/>
                <a:gd name="connsiteY0" fmla="*/ 1488 h 920403"/>
                <a:gd name="connsiteX1" fmla="*/ 73208 w 1249388"/>
                <a:gd name="connsiteY1" fmla="*/ 232877 h 920403"/>
                <a:gd name="connsiteX2" fmla="*/ 73208 w 1249388"/>
                <a:gd name="connsiteY2" fmla="*/ 707010 h 920403"/>
                <a:gd name="connsiteX3" fmla="*/ 829564 w 1249388"/>
                <a:gd name="connsiteY3" fmla="*/ 910210 h 920403"/>
                <a:gd name="connsiteX4" fmla="*/ 1202097 w 1249388"/>
                <a:gd name="connsiteY4" fmla="*/ 831188 h 920403"/>
                <a:gd name="connsiteX5" fmla="*/ 1179519 w 1249388"/>
                <a:gd name="connsiteY5" fmla="*/ 334477 h 920403"/>
                <a:gd name="connsiteX6" fmla="*/ 740528 w 1249388"/>
                <a:gd name="connsiteY6" fmla="*/ 247049 h 920403"/>
                <a:gd name="connsiteX0" fmla="*/ 459650 w 1247912"/>
                <a:gd name="connsiteY0" fmla="*/ 1488 h 920403"/>
                <a:gd name="connsiteX1" fmla="*/ 73208 w 1247912"/>
                <a:gd name="connsiteY1" fmla="*/ 232877 h 920403"/>
                <a:gd name="connsiteX2" fmla="*/ 73208 w 1247912"/>
                <a:gd name="connsiteY2" fmla="*/ 707010 h 920403"/>
                <a:gd name="connsiteX3" fmla="*/ 829564 w 1247912"/>
                <a:gd name="connsiteY3" fmla="*/ 910210 h 920403"/>
                <a:gd name="connsiteX4" fmla="*/ 1202097 w 1247912"/>
                <a:gd name="connsiteY4" fmla="*/ 831188 h 920403"/>
                <a:gd name="connsiteX5" fmla="*/ 1179519 w 1247912"/>
                <a:gd name="connsiteY5" fmla="*/ 334477 h 920403"/>
                <a:gd name="connsiteX6" fmla="*/ 639311 w 1247912"/>
                <a:gd name="connsiteY6" fmla="*/ 119153 h 920403"/>
                <a:gd name="connsiteX0" fmla="*/ 459650 w 1247912"/>
                <a:gd name="connsiteY0" fmla="*/ 1488 h 920403"/>
                <a:gd name="connsiteX1" fmla="*/ 73208 w 1247912"/>
                <a:gd name="connsiteY1" fmla="*/ 232877 h 920403"/>
                <a:gd name="connsiteX2" fmla="*/ 73208 w 1247912"/>
                <a:gd name="connsiteY2" fmla="*/ 707010 h 920403"/>
                <a:gd name="connsiteX3" fmla="*/ 829564 w 1247912"/>
                <a:gd name="connsiteY3" fmla="*/ 910210 h 920403"/>
                <a:gd name="connsiteX4" fmla="*/ 1202097 w 1247912"/>
                <a:gd name="connsiteY4" fmla="*/ 831188 h 920403"/>
                <a:gd name="connsiteX5" fmla="*/ 1179519 w 1247912"/>
                <a:gd name="connsiteY5" fmla="*/ 334477 h 920403"/>
                <a:gd name="connsiteX6" fmla="*/ 639311 w 1247912"/>
                <a:gd name="connsiteY6" fmla="*/ 74389 h 920403"/>
                <a:gd name="connsiteX0" fmla="*/ 459650 w 1236362"/>
                <a:gd name="connsiteY0" fmla="*/ 1488 h 920403"/>
                <a:gd name="connsiteX1" fmla="*/ 73208 w 1236362"/>
                <a:gd name="connsiteY1" fmla="*/ 232877 h 920403"/>
                <a:gd name="connsiteX2" fmla="*/ 73208 w 1236362"/>
                <a:gd name="connsiteY2" fmla="*/ 707010 h 920403"/>
                <a:gd name="connsiteX3" fmla="*/ 829564 w 1236362"/>
                <a:gd name="connsiteY3" fmla="*/ 910210 h 920403"/>
                <a:gd name="connsiteX4" fmla="*/ 1202097 w 1236362"/>
                <a:gd name="connsiteY4" fmla="*/ 831188 h 920403"/>
                <a:gd name="connsiteX5" fmla="*/ 1179519 w 1236362"/>
                <a:gd name="connsiteY5" fmla="*/ 334477 h 920403"/>
                <a:gd name="connsiteX6" fmla="*/ 847843 w 1236362"/>
                <a:gd name="connsiteY6" fmla="*/ 119265 h 920403"/>
                <a:gd name="connsiteX0" fmla="*/ 459650 w 1228859"/>
                <a:gd name="connsiteY0" fmla="*/ 1488 h 920403"/>
                <a:gd name="connsiteX1" fmla="*/ 73208 w 1228859"/>
                <a:gd name="connsiteY1" fmla="*/ 232877 h 920403"/>
                <a:gd name="connsiteX2" fmla="*/ 73208 w 1228859"/>
                <a:gd name="connsiteY2" fmla="*/ 707010 h 920403"/>
                <a:gd name="connsiteX3" fmla="*/ 829564 w 1228859"/>
                <a:gd name="connsiteY3" fmla="*/ 910210 h 920403"/>
                <a:gd name="connsiteX4" fmla="*/ 1202097 w 1228859"/>
                <a:gd name="connsiteY4" fmla="*/ 831188 h 920403"/>
                <a:gd name="connsiteX5" fmla="*/ 1179519 w 1228859"/>
                <a:gd name="connsiteY5" fmla="*/ 334477 h 920403"/>
                <a:gd name="connsiteX6" fmla="*/ 931616 w 1228859"/>
                <a:gd name="connsiteY6" fmla="*/ 193768 h 920403"/>
                <a:gd name="connsiteX7" fmla="*/ 847843 w 1228859"/>
                <a:gd name="connsiteY7" fmla="*/ 119265 h 920403"/>
                <a:gd name="connsiteX0" fmla="*/ 459650 w 1228859"/>
                <a:gd name="connsiteY0" fmla="*/ 1488 h 920403"/>
                <a:gd name="connsiteX1" fmla="*/ 73208 w 1228859"/>
                <a:gd name="connsiteY1" fmla="*/ 232877 h 920403"/>
                <a:gd name="connsiteX2" fmla="*/ 73208 w 1228859"/>
                <a:gd name="connsiteY2" fmla="*/ 707010 h 920403"/>
                <a:gd name="connsiteX3" fmla="*/ 829564 w 1228859"/>
                <a:gd name="connsiteY3" fmla="*/ 910210 h 920403"/>
                <a:gd name="connsiteX4" fmla="*/ 1202097 w 1228859"/>
                <a:gd name="connsiteY4" fmla="*/ 831188 h 920403"/>
                <a:gd name="connsiteX5" fmla="*/ 1179519 w 1228859"/>
                <a:gd name="connsiteY5" fmla="*/ 334477 h 920403"/>
                <a:gd name="connsiteX6" fmla="*/ 931616 w 1228859"/>
                <a:gd name="connsiteY6" fmla="*/ 193768 h 920403"/>
                <a:gd name="connsiteX7" fmla="*/ 847843 w 1228859"/>
                <a:gd name="connsiteY7" fmla="*/ 119265 h 920403"/>
                <a:gd name="connsiteX0" fmla="*/ 459126 w 1228888"/>
                <a:gd name="connsiteY0" fmla="*/ 1488 h 872388"/>
                <a:gd name="connsiteX1" fmla="*/ 72684 w 1228888"/>
                <a:gd name="connsiteY1" fmla="*/ 232877 h 872388"/>
                <a:gd name="connsiteX2" fmla="*/ 72684 w 1228888"/>
                <a:gd name="connsiteY2" fmla="*/ 707010 h 872388"/>
                <a:gd name="connsiteX3" fmla="*/ 821554 w 1228888"/>
                <a:gd name="connsiteY3" fmla="*/ 829550 h 872388"/>
                <a:gd name="connsiteX4" fmla="*/ 1201573 w 1228888"/>
                <a:gd name="connsiteY4" fmla="*/ 831188 h 872388"/>
                <a:gd name="connsiteX5" fmla="*/ 1178995 w 1228888"/>
                <a:gd name="connsiteY5" fmla="*/ 334477 h 872388"/>
                <a:gd name="connsiteX6" fmla="*/ 931092 w 1228888"/>
                <a:gd name="connsiteY6" fmla="*/ 193768 h 872388"/>
                <a:gd name="connsiteX7" fmla="*/ 847319 w 1228888"/>
                <a:gd name="connsiteY7" fmla="*/ 119265 h 872388"/>
                <a:gd name="connsiteX0" fmla="*/ 391336 w 1161098"/>
                <a:gd name="connsiteY0" fmla="*/ 1597 h 869868"/>
                <a:gd name="connsiteX1" fmla="*/ 4894 w 1161098"/>
                <a:gd name="connsiteY1" fmla="*/ 232986 h 869868"/>
                <a:gd name="connsiteX2" fmla="*/ 211810 w 1161098"/>
                <a:gd name="connsiteY2" fmla="*/ 770337 h 869868"/>
                <a:gd name="connsiteX3" fmla="*/ 753764 w 1161098"/>
                <a:gd name="connsiteY3" fmla="*/ 829659 h 869868"/>
                <a:gd name="connsiteX4" fmla="*/ 1133783 w 1161098"/>
                <a:gd name="connsiteY4" fmla="*/ 831297 h 869868"/>
                <a:gd name="connsiteX5" fmla="*/ 1111205 w 1161098"/>
                <a:gd name="connsiteY5" fmla="*/ 334586 h 869868"/>
                <a:gd name="connsiteX6" fmla="*/ 863302 w 1161098"/>
                <a:gd name="connsiteY6" fmla="*/ 193877 h 869868"/>
                <a:gd name="connsiteX7" fmla="*/ 779529 w 1161098"/>
                <a:gd name="connsiteY7" fmla="*/ 119374 h 869868"/>
                <a:gd name="connsiteX0" fmla="*/ 387762 w 1157524"/>
                <a:gd name="connsiteY0" fmla="*/ 1294 h 869565"/>
                <a:gd name="connsiteX1" fmla="*/ 1320 w 1157524"/>
                <a:gd name="connsiteY1" fmla="*/ 232683 h 869565"/>
                <a:gd name="connsiteX2" fmla="*/ 259397 w 1157524"/>
                <a:gd name="connsiteY2" fmla="*/ 571530 h 869565"/>
                <a:gd name="connsiteX3" fmla="*/ 208236 w 1157524"/>
                <a:gd name="connsiteY3" fmla="*/ 770034 h 869565"/>
                <a:gd name="connsiteX4" fmla="*/ 750190 w 1157524"/>
                <a:gd name="connsiteY4" fmla="*/ 829356 h 869565"/>
                <a:gd name="connsiteX5" fmla="*/ 1130209 w 1157524"/>
                <a:gd name="connsiteY5" fmla="*/ 830994 h 869565"/>
                <a:gd name="connsiteX6" fmla="*/ 1107631 w 1157524"/>
                <a:gd name="connsiteY6" fmla="*/ 334283 h 869565"/>
                <a:gd name="connsiteX7" fmla="*/ 859728 w 1157524"/>
                <a:gd name="connsiteY7" fmla="*/ 193574 h 869565"/>
                <a:gd name="connsiteX8" fmla="*/ 775955 w 1157524"/>
                <a:gd name="connsiteY8" fmla="*/ 119071 h 869565"/>
                <a:gd name="connsiteX0" fmla="*/ 395201 w 1164963"/>
                <a:gd name="connsiteY0" fmla="*/ 1290 h 869561"/>
                <a:gd name="connsiteX1" fmla="*/ 8759 w 1164963"/>
                <a:gd name="connsiteY1" fmla="*/ 232679 h 869561"/>
                <a:gd name="connsiteX2" fmla="*/ 132386 w 1164963"/>
                <a:gd name="connsiteY2" fmla="*/ 567021 h 869561"/>
                <a:gd name="connsiteX3" fmla="*/ 215675 w 1164963"/>
                <a:gd name="connsiteY3" fmla="*/ 770030 h 869561"/>
                <a:gd name="connsiteX4" fmla="*/ 757629 w 1164963"/>
                <a:gd name="connsiteY4" fmla="*/ 829352 h 869561"/>
                <a:gd name="connsiteX5" fmla="*/ 1137648 w 1164963"/>
                <a:gd name="connsiteY5" fmla="*/ 830990 h 869561"/>
                <a:gd name="connsiteX6" fmla="*/ 1115070 w 1164963"/>
                <a:gd name="connsiteY6" fmla="*/ 334279 h 869561"/>
                <a:gd name="connsiteX7" fmla="*/ 867167 w 1164963"/>
                <a:gd name="connsiteY7" fmla="*/ 193570 h 869561"/>
                <a:gd name="connsiteX8" fmla="*/ 783394 w 1164963"/>
                <a:gd name="connsiteY8" fmla="*/ 119067 h 869561"/>
                <a:gd name="connsiteX0" fmla="*/ 540616 w 1310378"/>
                <a:gd name="connsiteY0" fmla="*/ 1193 h 869464"/>
                <a:gd name="connsiteX1" fmla="*/ 4598 w 1310378"/>
                <a:gd name="connsiteY1" fmla="*/ 245664 h 869464"/>
                <a:gd name="connsiteX2" fmla="*/ 277801 w 1310378"/>
                <a:gd name="connsiteY2" fmla="*/ 566924 h 869464"/>
                <a:gd name="connsiteX3" fmla="*/ 361090 w 1310378"/>
                <a:gd name="connsiteY3" fmla="*/ 769933 h 869464"/>
                <a:gd name="connsiteX4" fmla="*/ 903044 w 1310378"/>
                <a:gd name="connsiteY4" fmla="*/ 829255 h 869464"/>
                <a:gd name="connsiteX5" fmla="*/ 1283063 w 1310378"/>
                <a:gd name="connsiteY5" fmla="*/ 830893 h 869464"/>
                <a:gd name="connsiteX6" fmla="*/ 1260485 w 1310378"/>
                <a:gd name="connsiteY6" fmla="*/ 334182 h 869464"/>
                <a:gd name="connsiteX7" fmla="*/ 1012582 w 1310378"/>
                <a:gd name="connsiteY7" fmla="*/ 193473 h 869464"/>
                <a:gd name="connsiteX8" fmla="*/ 928809 w 1310378"/>
                <a:gd name="connsiteY8" fmla="*/ 118970 h 869464"/>
                <a:gd name="connsiteX0" fmla="*/ 540616 w 1310378"/>
                <a:gd name="connsiteY0" fmla="*/ 1193 h 873054"/>
                <a:gd name="connsiteX1" fmla="*/ 4598 w 1310378"/>
                <a:gd name="connsiteY1" fmla="*/ 245664 h 873054"/>
                <a:gd name="connsiteX2" fmla="*/ 277801 w 1310378"/>
                <a:gd name="connsiteY2" fmla="*/ 566924 h 873054"/>
                <a:gd name="connsiteX3" fmla="*/ 403457 w 1310378"/>
                <a:gd name="connsiteY3" fmla="*/ 684916 h 873054"/>
                <a:gd name="connsiteX4" fmla="*/ 903044 w 1310378"/>
                <a:gd name="connsiteY4" fmla="*/ 829255 h 873054"/>
                <a:gd name="connsiteX5" fmla="*/ 1283063 w 1310378"/>
                <a:gd name="connsiteY5" fmla="*/ 830893 h 873054"/>
                <a:gd name="connsiteX6" fmla="*/ 1260485 w 1310378"/>
                <a:gd name="connsiteY6" fmla="*/ 334182 h 873054"/>
                <a:gd name="connsiteX7" fmla="*/ 1012582 w 1310378"/>
                <a:gd name="connsiteY7" fmla="*/ 193473 h 873054"/>
                <a:gd name="connsiteX8" fmla="*/ 928809 w 1310378"/>
                <a:gd name="connsiteY8" fmla="*/ 118970 h 873054"/>
                <a:gd name="connsiteX0" fmla="*/ 540616 w 1310378"/>
                <a:gd name="connsiteY0" fmla="*/ 1193 h 866560"/>
                <a:gd name="connsiteX1" fmla="*/ 4598 w 1310378"/>
                <a:gd name="connsiteY1" fmla="*/ 245664 h 866560"/>
                <a:gd name="connsiteX2" fmla="*/ 277801 w 1310378"/>
                <a:gd name="connsiteY2" fmla="*/ 566924 h 866560"/>
                <a:gd name="connsiteX3" fmla="*/ 403457 w 1310378"/>
                <a:gd name="connsiteY3" fmla="*/ 684916 h 866560"/>
                <a:gd name="connsiteX4" fmla="*/ 605396 w 1310378"/>
                <a:gd name="connsiteY4" fmla="*/ 847262 h 866560"/>
                <a:gd name="connsiteX5" fmla="*/ 903044 w 1310378"/>
                <a:gd name="connsiteY5" fmla="*/ 829255 h 866560"/>
                <a:gd name="connsiteX6" fmla="*/ 1283063 w 1310378"/>
                <a:gd name="connsiteY6" fmla="*/ 830893 h 866560"/>
                <a:gd name="connsiteX7" fmla="*/ 1260485 w 1310378"/>
                <a:gd name="connsiteY7" fmla="*/ 334182 h 866560"/>
                <a:gd name="connsiteX8" fmla="*/ 1012582 w 1310378"/>
                <a:gd name="connsiteY8" fmla="*/ 193473 h 866560"/>
                <a:gd name="connsiteX9" fmla="*/ 928809 w 1310378"/>
                <a:gd name="connsiteY9" fmla="*/ 118970 h 866560"/>
                <a:gd name="connsiteX0" fmla="*/ 540616 w 1301058"/>
                <a:gd name="connsiteY0" fmla="*/ 1193 h 855571"/>
                <a:gd name="connsiteX1" fmla="*/ 4598 w 1301058"/>
                <a:gd name="connsiteY1" fmla="*/ 245664 h 855571"/>
                <a:gd name="connsiteX2" fmla="*/ 277801 w 1301058"/>
                <a:gd name="connsiteY2" fmla="*/ 566924 h 855571"/>
                <a:gd name="connsiteX3" fmla="*/ 403457 w 1301058"/>
                <a:gd name="connsiteY3" fmla="*/ 684916 h 855571"/>
                <a:gd name="connsiteX4" fmla="*/ 605396 w 1301058"/>
                <a:gd name="connsiteY4" fmla="*/ 847262 h 855571"/>
                <a:gd name="connsiteX5" fmla="*/ 903044 w 1301058"/>
                <a:gd name="connsiteY5" fmla="*/ 829255 h 855571"/>
                <a:gd name="connsiteX6" fmla="*/ 1283063 w 1301058"/>
                <a:gd name="connsiteY6" fmla="*/ 830893 h 855571"/>
                <a:gd name="connsiteX7" fmla="*/ 1241713 w 1301058"/>
                <a:gd name="connsiteY7" fmla="*/ 482630 h 855571"/>
                <a:gd name="connsiteX8" fmla="*/ 1260485 w 1301058"/>
                <a:gd name="connsiteY8" fmla="*/ 334182 h 855571"/>
                <a:gd name="connsiteX9" fmla="*/ 1012582 w 1301058"/>
                <a:gd name="connsiteY9" fmla="*/ 193473 h 855571"/>
                <a:gd name="connsiteX10" fmla="*/ 928809 w 1301058"/>
                <a:gd name="connsiteY10" fmla="*/ 118970 h 85557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1301058" h="855571">
                  <a:moveTo>
                    <a:pt x="540616" y="1193"/>
                  </a:moveTo>
                  <a:cubicBezTo>
                    <a:pt x="356231" y="-15740"/>
                    <a:pt x="48401" y="151376"/>
                    <a:pt x="4598" y="245664"/>
                  </a:cubicBezTo>
                  <a:cubicBezTo>
                    <a:pt x="-39205" y="339953"/>
                    <a:pt x="243315" y="477366"/>
                    <a:pt x="277801" y="566924"/>
                  </a:cubicBezTo>
                  <a:cubicBezTo>
                    <a:pt x="312287" y="656483"/>
                    <a:pt x="348858" y="638193"/>
                    <a:pt x="403457" y="684916"/>
                  </a:cubicBezTo>
                  <a:cubicBezTo>
                    <a:pt x="458056" y="731639"/>
                    <a:pt x="522132" y="823206"/>
                    <a:pt x="605396" y="847262"/>
                  </a:cubicBezTo>
                  <a:cubicBezTo>
                    <a:pt x="688660" y="871318"/>
                    <a:pt x="790100" y="831983"/>
                    <a:pt x="903044" y="829255"/>
                  </a:cubicBezTo>
                  <a:cubicBezTo>
                    <a:pt x="1015988" y="826527"/>
                    <a:pt x="1226618" y="888664"/>
                    <a:pt x="1283063" y="830893"/>
                  </a:cubicBezTo>
                  <a:cubicBezTo>
                    <a:pt x="1339508" y="773122"/>
                    <a:pt x="1245476" y="565415"/>
                    <a:pt x="1241713" y="482630"/>
                  </a:cubicBezTo>
                  <a:cubicBezTo>
                    <a:pt x="1237950" y="399845"/>
                    <a:pt x="1298673" y="382375"/>
                    <a:pt x="1260485" y="334182"/>
                  </a:cubicBezTo>
                  <a:cubicBezTo>
                    <a:pt x="1222297" y="285989"/>
                    <a:pt x="1067861" y="229342"/>
                    <a:pt x="1012582" y="193473"/>
                  </a:cubicBezTo>
                  <a:cubicBezTo>
                    <a:pt x="957303" y="157604"/>
                    <a:pt x="957738" y="121518"/>
                    <a:pt x="928809" y="118970"/>
                  </a:cubicBezTo>
                </a:path>
              </a:pathLst>
            </a:custGeom>
            <a:solidFill>
              <a:schemeClr val="bg1"/>
            </a:solidFill>
            <a:ln w="9525">
              <a:solidFill>
                <a:srgbClr val="548235">
                  <a:alpha val="50196"/>
                </a:srgbClr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346" name="Groupe 345"/>
            <p:cNvGrpSpPr/>
            <p:nvPr/>
          </p:nvGrpSpPr>
          <p:grpSpPr>
            <a:xfrm>
              <a:off x="5199548" y="1182582"/>
              <a:ext cx="241768" cy="289369"/>
              <a:chOff x="3843812" y="362345"/>
              <a:chExt cx="241768" cy="289369"/>
            </a:xfrm>
          </p:grpSpPr>
          <p:pic>
            <p:nvPicPr>
              <p:cNvPr id="347" name="Image 346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2151359">
                <a:off x="3843812" y="531813"/>
                <a:ext cx="91742" cy="119901"/>
              </a:xfrm>
              <a:prstGeom prst="rect">
                <a:avLst/>
              </a:prstGeom>
            </p:spPr>
          </p:pic>
          <p:pic>
            <p:nvPicPr>
              <p:cNvPr id="348" name="Image 347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956907" y="481871"/>
                <a:ext cx="91742" cy="119901"/>
              </a:xfrm>
              <a:prstGeom prst="rect">
                <a:avLst/>
              </a:prstGeom>
            </p:spPr>
          </p:pic>
          <p:pic>
            <p:nvPicPr>
              <p:cNvPr id="349" name="Image 348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20454063">
                <a:off x="3907315" y="517634"/>
                <a:ext cx="91742" cy="119901"/>
              </a:xfrm>
              <a:prstGeom prst="rect">
                <a:avLst/>
              </a:prstGeom>
            </p:spPr>
          </p:pic>
          <p:pic>
            <p:nvPicPr>
              <p:cNvPr id="350" name="Image 349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16413979">
                <a:off x="3979759" y="400586"/>
                <a:ext cx="91742" cy="119901"/>
              </a:xfrm>
              <a:prstGeom prst="rect">
                <a:avLst/>
              </a:prstGeom>
            </p:spPr>
          </p:pic>
          <p:pic>
            <p:nvPicPr>
              <p:cNvPr id="351" name="Image 350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15130222">
                <a:off x="3951217" y="348265"/>
                <a:ext cx="91742" cy="119901"/>
              </a:xfrm>
              <a:prstGeom prst="rect">
                <a:avLst/>
              </a:prstGeom>
            </p:spPr>
          </p:pic>
          <p:pic>
            <p:nvPicPr>
              <p:cNvPr id="352" name="Image 35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7210582">
                <a:off x="3858633" y="428246"/>
                <a:ext cx="91742" cy="119901"/>
              </a:xfrm>
              <a:prstGeom prst="rect">
                <a:avLst/>
              </a:prstGeom>
            </p:spPr>
          </p:pic>
        </p:grpSp>
      </p:grpSp>
      <p:sp>
        <p:nvSpPr>
          <p:cNvPr id="353" name="Accolade ouvrante 352"/>
          <p:cNvSpPr/>
          <p:nvPr/>
        </p:nvSpPr>
        <p:spPr>
          <a:xfrm>
            <a:off x="1628828" y="1578724"/>
            <a:ext cx="441668" cy="881682"/>
          </a:xfrm>
          <a:prstGeom prst="leftBrace">
            <a:avLst>
              <a:gd name="adj1" fmla="val 8333"/>
              <a:gd name="adj2" fmla="val 50384"/>
            </a:avLst>
          </a:prstGeom>
          <a:noFill/>
          <a:ln w="38100">
            <a:solidFill>
              <a:schemeClr val="bg1">
                <a:lumMod val="50000"/>
              </a:schemeClr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354" name="Groupe 353"/>
          <p:cNvGrpSpPr/>
          <p:nvPr/>
        </p:nvGrpSpPr>
        <p:grpSpPr>
          <a:xfrm>
            <a:off x="1667461" y="1699881"/>
            <a:ext cx="381836" cy="240147"/>
            <a:chOff x="1885684" y="1835881"/>
            <a:chExt cx="248412" cy="167244"/>
          </a:xfrm>
        </p:grpSpPr>
        <p:sp>
          <p:nvSpPr>
            <p:cNvPr id="355" name="Ellipse 354"/>
            <p:cNvSpPr/>
            <p:nvPr/>
          </p:nvSpPr>
          <p:spPr>
            <a:xfrm>
              <a:off x="1922940" y="1846892"/>
              <a:ext cx="168633" cy="15623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356" name="ZoneTexte 355"/>
            <p:cNvSpPr txBox="1"/>
            <p:nvPr/>
          </p:nvSpPr>
          <p:spPr>
            <a:xfrm>
              <a:off x="1885684" y="1835881"/>
              <a:ext cx="248412" cy="160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solidFill>
                    <a:schemeClr val="bg1">
                      <a:lumMod val="50000"/>
                    </a:schemeClr>
                  </a:solidFill>
                </a:rPr>
                <a:t>61%</a:t>
              </a:r>
              <a:endParaRPr lang="fr-FR" sz="9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357" name="Groupe 356"/>
          <p:cNvGrpSpPr/>
          <p:nvPr/>
        </p:nvGrpSpPr>
        <p:grpSpPr>
          <a:xfrm>
            <a:off x="1673351" y="2154700"/>
            <a:ext cx="381836" cy="230832"/>
            <a:chOff x="1892130" y="1845349"/>
            <a:chExt cx="248411" cy="160757"/>
          </a:xfrm>
        </p:grpSpPr>
        <p:sp>
          <p:nvSpPr>
            <p:cNvPr id="358" name="Ellipse 357"/>
            <p:cNvSpPr/>
            <p:nvPr/>
          </p:nvSpPr>
          <p:spPr>
            <a:xfrm>
              <a:off x="1922940" y="1846892"/>
              <a:ext cx="168633" cy="156233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359" name="ZoneTexte 358"/>
            <p:cNvSpPr txBox="1"/>
            <p:nvPr/>
          </p:nvSpPr>
          <p:spPr>
            <a:xfrm>
              <a:off x="1892130" y="1845349"/>
              <a:ext cx="248411" cy="160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solidFill>
                    <a:schemeClr val="bg1">
                      <a:lumMod val="50000"/>
                    </a:schemeClr>
                  </a:solidFill>
                </a:rPr>
                <a:t>39%</a:t>
              </a:r>
              <a:endParaRPr lang="fr-FR" sz="9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360" name="Groupe 359"/>
          <p:cNvGrpSpPr/>
          <p:nvPr/>
        </p:nvGrpSpPr>
        <p:grpSpPr>
          <a:xfrm>
            <a:off x="3236659" y="1264940"/>
            <a:ext cx="547946" cy="583946"/>
            <a:chOff x="3319791" y="994138"/>
            <a:chExt cx="737060" cy="685867"/>
          </a:xfrm>
        </p:grpSpPr>
        <p:grpSp>
          <p:nvGrpSpPr>
            <p:cNvPr id="361" name="Groupe 360"/>
            <p:cNvGrpSpPr/>
            <p:nvPr/>
          </p:nvGrpSpPr>
          <p:grpSpPr>
            <a:xfrm rot="4286376">
              <a:off x="3345387" y="968542"/>
              <a:ext cx="685867" cy="737060"/>
              <a:chOff x="1854653" y="1204347"/>
              <a:chExt cx="1291883" cy="1442530"/>
            </a:xfrm>
          </p:grpSpPr>
          <p:sp>
            <p:nvSpPr>
              <p:cNvPr id="368" name="Forme libre 367"/>
              <p:cNvSpPr/>
              <p:nvPr/>
            </p:nvSpPr>
            <p:spPr>
              <a:xfrm>
                <a:off x="1854653" y="1204347"/>
                <a:ext cx="1291883" cy="1442530"/>
              </a:xfrm>
              <a:custGeom>
                <a:avLst/>
                <a:gdLst>
                  <a:gd name="connsiteX0" fmla="*/ 1245464 w 1694550"/>
                  <a:gd name="connsiteY0" fmla="*/ 229341 h 1996683"/>
                  <a:gd name="connsiteX1" fmla="*/ 737464 w 1694550"/>
                  <a:gd name="connsiteY1" fmla="*/ 3563 h 1996683"/>
                  <a:gd name="connsiteX2" fmla="*/ 410086 w 1694550"/>
                  <a:gd name="connsiteY2" fmla="*/ 116452 h 1996683"/>
                  <a:gd name="connsiteX3" fmla="*/ 342353 w 1694550"/>
                  <a:gd name="connsiteY3" fmla="*/ 443830 h 1996683"/>
                  <a:gd name="connsiteX4" fmla="*/ 14975 w 1694550"/>
                  <a:gd name="connsiteY4" fmla="*/ 726052 h 1996683"/>
                  <a:gd name="connsiteX5" fmla="*/ 161730 w 1694550"/>
                  <a:gd name="connsiteY5" fmla="*/ 1301786 h 1996683"/>
                  <a:gd name="connsiteX6" fmla="*/ 14975 w 1694550"/>
                  <a:gd name="connsiteY6" fmla="*/ 1640452 h 1996683"/>
                  <a:gd name="connsiteX7" fmla="*/ 601997 w 1694550"/>
                  <a:gd name="connsiteY7" fmla="*/ 1617875 h 1996683"/>
                  <a:gd name="connsiteX8" fmla="*/ 624575 w 1694550"/>
                  <a:gd name="connsiteY8" fmla="*/ 1922675 h 1996683"/>
                  <a:gd name="connsiteX9" fmla="*/ 997108 w 1694550"/>
                  <a:gd name="connsiteY9" fmla="*/ 1967830 h 1996683"/>
                  <a:gd name="connsiteX10" fmla="*/ 1200308 w 1694550"/>
                  <a:gd name="connsiteY10" fmla="*/ 1550141 h 1996683"/>
                  <a:gd name="connsiteX11" fmla="*/ 1335775 w 1694550"/>
                  <a:gd name="connsiteY11" fmla="*/ 1369519 h 1996683"/>
                  <a:gd name="connsiteX12" fmla="*/ 1685730 w 1694550"/>
                  <a:gd name="connsiteY12" fmla="*/ 1132452 h 1996683"/>
                  <a:gd name="connsiteX13" fmla="*/ 1595419 w 1694550"/>
                  <a:gd name="connsiteY13" fmla="*/ 771208 h 1996683"/>
                  <a:gd name="connsiteX14" fmla="*/ 1663153 w 1694550"/>
                  <a:gd name="connsiteY14" fmla="*/ 398675 h 1996683"/>
                  <a:gd name="connsiteX15" fmla="*/ 1245464 w 1694550"/>
                  <a:gd name="connsiteY15" fmla="*/ 229341 h 19966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1694550" h="1996683">
                    <a:moveTo>
                      <a:pt x="1245464" y="229341"/>
                    </a:moveTo>
                    <a:cubicBezTo>
                      <a:pt x="1091183" y="163489"/>
                      <a:pt x="876694" y="22378"/>
                      <a:pt x="737464" y="3563"/>
                    </a:cubicBezTo>
                    <a:cubicBezTo>
                      <a:pt x="598234" y="-15252"/>
                      <a:pt x="475938" y="43074"/>
                      <a:pt x="410086" y="116452"/>
                    </a:cubicBezTo>
                    <a:cubicBezTo>
                      <a:pt x="344234" y="189830"/>
                      <a:pt x="408205" y="342230"/>
                      <a:pt x="342353" y="443830"/>
                    </a:cubicBezTo>
                    <a:cubicBezTo>
                      <a:pt x="276501" y="545430"/>
                      <a:pt x="45079" y="583059"/>
                      <a:pt x="14975" y="726052"/>
                    </a:cubicBezTo>
                    <a:cubicBezTo>
                      <a:pt x="-15129" y="869045"/>
                      <a:pt x="161730" y="1149386"/>
                      <a:pt x="161730" y="1301786"/>
                    </a:cubicBezTo>
                    <a:cubicBezTo>
                      <a:pt x="161730" y="1454186"/>
                      <a:pt x="-58403" y="1587770"/>
                      <a:pt x="14975" y="1640452"/>
                    </a:cubicBezTo>
                    <a:cubicBezTo>
                      <a:pt x="88353" y="1693134"/>
                      <a:pt x="500397" y="1570838"/>
                      <a:pt x="601997" y="1617875"/>
                    </a:cubicBezTo>
                    <a:cubicBezTo>
                      <a:pt x="703597" y="1664912"/>
                      <a:pt x="558723" y="1864349"/>
                      <a:pt x="624575" y="1922675"/>
                    </a:cubicBezTo>
                    <a:cubicBezTo>
                      <a:pt x="690427" y="1981001"/>
                      <a:pt x="901153" y="2029919"/>
                      <a:pt x="997108" y="1967830"/>
                    </a:cubicBezTo>
                    <a:cubicBezTo>
                      <a:pt x="1093063" y="1905741"/>
                      <a:pt x="1143864" y="1649859"/>
                      <a:pt x="1200308" y="1550141"/>
                    </a:cubicBezTo>
                    <a:cubicBezTo>
                      <a:pt x="1256752" y="1450423"/>
                      <a:pt x="1254871" y="1439134"/>
                      <a:pt x="1335775" y="1369519"/>
                    </a:cubicBezTo>
                    <a:cubicBezTo>
                      <a:pt x="1416679" y="1299904"/>
                      <a:pt x="1642456" y="1232170"/>
                      <a:pt x="1685730" y="1132452"/>
                    </a:cubicBezTo>
                    <a:cubicBezTo>
                      <a:pt x="1729004" y="1032734"/>
                      <a:pt x="1599182" y="893504"/>
                      <a:pt x="1595419" y="771208"/>
                    </a:cubicBezTo>
                    <a:cubicBezTo>
                      <a:pt x="1591656" y="648912"/>
                      <a:pt x="1715834" y="485223"/>
                      <a:pt x="1663153" y="398675"/>
                    </a:cubicBezTo>
                    <a:cubicBezTo>
                      <a:pt x="1610472" y="312127"/>
                      <a:pt x="1399745" y="295193"/>
                      <a:pt x="1245464" y="229341"/>
                    </a:cubicBez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6350">
                <a:solidFill>
                  <a:schemeClr val="bg1">
                    <a:lumMod val="50000"/>
                  </a:schemeClr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69" name="Forme libre 368"/>
              <p:cNvSpPr/>
              <p:nvPr/>
            </p:nvSpPr>
            <p:spPr>
              <a:xfrm>
                <a:off x="2228955" y="1423570"/>
                <a:ext cx="538612" cy="483979"/>
              </a:xfrm>
              <a:custGeom>
                <a:avLst/>
                <a:gdLst>
                  <a:gd name="connsiteX0" fmla="*/ 599693 w 1256584"/>
                  <a:gd name="connsiteY0" fmla="*/ 3208 h 826201"/>
                  <a:gd name="connsiteX1" fmla="*/ 80404 w 1256584"/>
                  <a:gd name="connsiteY1" fmla="*/ 138675 h 826201"/>
                  <a:gd name="connsiteX2" fmla="*/ 80404 w 1256584"/>
                  <a:gd name="connsiteY2" fmla="*/ 612808 h 826201"/>
                  <a:gd name="connsiteX3" fmla="*/ 836760 w 1256584"/>
                  <a:gd name="connsiteY3" fmla="*/ 816008 h 826201"/>
                  <a:gd name="connsiteX4" fmla="*/ 1209293 w 1256584"/>
                  <a:gd name="connsiteY4" fmla="*/ 736986 h 826201"/>
                  <a:gd name="connsiteX5" fmla="*/ 1186715 w 1256584"/>
                  <a:gd name="connsiteY5" fmla="*/ 240275 h 826201"/>
                  <a:gd name="connsiteX6" fmla="*/ 599693 w 1256584"/>
                  <a:gd name="connsiteY6" fmla="*/ 3208 h 82620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256584" h="826201">
                    <a:moveTo>
                      <a:pt x="599693" y="3208"/>
                    </a:moveTo>
                    <a:cubicBezTo>
                      <a:pt x="415308" y="-13725"/>
                      <a:pt x="166952" y="37075"/>
                      <a:pt x="80404" y="138675"/>
                    </a:cubicBezTo>
                    <a:cubicBezTo>
                      <a:pt x="-6144" y="240275"/>
                      <a:pt x="-45655" y="499919"/>
                      <a:pt x="80404" y="612808"/>
                    </a:cubicBezTo>
                    <a:cubicBezTo>
                      <a:pt x="206463" y="725697"/>
                      <a:pt x="648612" y="795312"/>
                      <a:pt x="836760" y="816008"/>
                    </a:cubicBezTo>
                    <a:cubicBezTo>
                      <a:pt x="1024908" y="836704"/>
                      <a:pt x="1150967" y="832941"/>
                      <a:pt x="1209293" y="736986"/>
                    </a:cubicBezTo>
                    <a:cubicBezTo>
                      <a:pt x="1267619" y="641031"/>
                      <a:pt x="1284552" y="358808"/>
                      <a:pt x="1186715" y="240275"/>
                    </a:cubicBezTo>
                    <a:cubicBezTo>
                      <a:pt x="1088878" y="121742"/>
                      <a:pt x="784078" y="20141"/>
                      <a:pt x="599693" y="3208"/>
                    </a:cubicBezTo>
                    <a:close/>
                  </a:path>
                </a:pathLst>
              </a:custGeom>
              <a:solidFill>
                <a:schemeClr val="accent6">
                  <a:lumMod val="20000"/>
                  <a:lumOff val="80000"/>
                </a:schemeClr>
              </a:solidFill>
              <a:ln w="9525">
                <a:solidFill>
                  <a:srgbClr val="548235">
                    <a:alpha val="50980"/>
                  </a:srgbClr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362" name="Image 36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43697" y="1273857"/>
              <a:ext cx="91742" cy="119901"/>
            </a:xfrm>
            <a:prstGeom prst="rect">
              <a:avLst/>
            </a:prstGeom>
          </p:spPr>
        </p:pic>
        <p:pic>
          <p:nvPicPr>
            <p:cNvPr id="363" name="Image 36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6413979">
              <a:off x="3824925" y="1178555"/>
              <a:ext cx="91742" cy="119901"/>
            </a:xfrm>
            <a:prstGeom prst="rect">
              <a:avLst/>
            </a:prstGeom>
          </p:spPr>
        </p:pic>
        <p:pic>
          <p:nvPicPr>
            <p:cNvPr id="364" name="Image 36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5130222">
              <a:off x="3763169" y="1132283"/>
              <a:ext cx="91742" cy="119901"/>
            </a:xfrm>
            <a:prstGeom prst="rect">
              <a:avLst/>
            </a:prstGeom>
          </p:spPr>
        </p:pic>
        <p:pic>
          <p:nvPicPr>
            <p:cNvPr id="365" name="Image 36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7210582">
              <a:off x="3714087" y="1232647"/>
              <a:ext cx="91742" cy="119901"/>
            </a:xfrm>
            <a:prstGeom prst="rect">
              <a:avLst/>
            </a:prstGeom>
          </p:spPr>
        </p:pic>
        <p:pic>
          <p:nvPicPr>
            <p:cNvPr id="366" name="Image 36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2151359">
              <a:off x="3720586" y="1333177"/>
              <a:ext cx="91742" cy="119901"/>
            </a:xfrm>
            <a:prstGeom prst="rect">
              <a:avLst/>
            </a:prstGeom>
          </p:spPr>
        </p:pic>
        <p:pic>
          <p:nvPicPr>
            <p:cNvPr id="367" name="Image 36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20454063">
              <a:off x="3781781" y="1317521"/>
              <a:ext cx="91742" cy="119901"/>
            </a:xfrm>
            <a:prstGeom prst="rect">
              <a:avLst/>
            </a:prstGeom>
          </p:spPr>
        </p:pic>
      </p:grpSp>
      <p:grpSp>
        <p:nvGrpSpPr>
          <p:cNvPr id="370" name="Groupe 369"/>
          <p:cNvGrpSpPr/>
          <p:nvPr/>
        </p:nvGrpSpPr>
        <p:grpSpPr>
          <a:xfrm>
            <a:off x="2056034" y="1220589"/>
            <a:ext cx="547946" cy="640624"/>
            <a:chOff x="2035498" y="982954"/>
            <a:chExt cx="737060" cy="752438"/>
          </a:xfrm>
        </p:grpSpPr>
        <p:grpSp>
          <p:nvGrpSpPr>
            <p:cNvPr id="371" name="Groupe 370"/>
            <p:cNvGrpSpPr/>
            <p:nvPr/>
          </p:nvGrpSpPr>
          <p:grpSpPr>
            <a:xfrm rot="4140921">
              <a:off x="2027809" y="990643"/>
              <a:ext cx="752438" cy="737060"/>
              <a:chOff x="304339" y="1159239"/>
              <a:chExt cx="1291883" cy="1442530"/>
            </a:xfrm>
          </p:grpSpPr>
          <p:sp>
            <p:nvSpPr>
              <p:cNvPr id="378" name="Forme libre 377"/>
              <p:cNvSpPr/>
              <p:nvPr/>
            </p:nvSpPr>
            <p:spPr>
              <a:xfrm>
                <a:off x="304339" y="1159239"/>
                <a:ext cx="1291883" cy="1442530"/>
              </a:xfrm>
              <a:custGeom>
                <a:avLst/>
                <a:gdLst>
                  <a:gd name="connsiteX0" fmla="*/ 1245464 w 1694550"/>
                  <a:gd name="connsiteY0" fmla="*/ 229341 h 1996683"/>
                  <a:gd name="connsiteX1" fmla="*/ 737464 w 1694550"/>
                  <a:gd name="connsiteY1" fmla="*/ 3563 h 1996683"/>
                  <a:gd name="connsiteX2" fmla="*/ 410086 w 1694550"/>
                  <a:gd name="connsiteY2" fmla="*/ 116452 h 1996683"/>
                  <a:gd name="connsiteX3" fmla="*/ 342353 w 1694550"/>
                  <a:gd name="connsiteY3" fmla="*/ 443830 h 1996683"/>
                  <a:gd name="connsiteX4" fmla="*/ 14975 w 1694550"/>
                  <a:gd name="connsiteY4" fmla="*/ 726052 h 1996683"/>
                  <a:gd name="connsiteX5" fmla="*/ 161730 w 1694550"/>
                  <a:gd name="connsiteY5" fmla="*/ 1301786 h 1996683"/>
                  <a:gd name="connsiteX6" fmla="*/ 14975 w 1694550"/>
                  <a:gd name="connsiteY6" fmla="*/ 1640452 h 1996683"/>
                  <a:gd name="connsiteX7" fmla="*/ 601997 w 1694550"/>
                  <a:gd name="connsiteY7" fmla="*/ 1617875 h 1996683"/>
                  <a:gd name="connsiteX8" fmla="*/ 624575 w 1694550"/>
                  <a:gd name="connsiteY8" fmla="*/ 1922675 h 1996683"/>
                  <a:gd name="connsiteX9" fmla="*/ 997108 w 1694550"/>
                  <a:gd name="connsiteY9" fmla="*/ 1967830 h 1996683"/>
                  <a:gd name="connsiteX10" fmla="*/ 1200308 w 1694550"/>
                  <a:gd name="connsiteY10" fmla="*/ 1550141 h 1996683"/>
                  <a:gd name="connsiteX11" fmla="*/ 1335775 w 1694550"/>
                  <a:gd name="connsiteY11" fmla="*/ 1369519 h 1996683"/>
                  <a:gd name="connsiteX12" fmla="*/ 1685730 w 1694550"/>
                  <a:gd name="connsiteY12" fmla="*/ 1132452 h 1996683"/>
                  <a:gd name="connsiteX13" fmla="*/ 1595419 w 1694550"/>
                  <a:gd name="connsiteY13" fmla="*/ 771208 h 1996683"/>
                  <a:gd name="connsiteX14" fmla="*/ 1663153 w 1694550"/>
                  <a:gd name="connsiteY14" fmla="*/ 398675 h 1996683"/>
                  <a:gd name="connsiteX15" fmla="*/ 1245464 w 1694550"/>
                  <a:gd name="connsiteY15" fmla="*/ 229341 h 19966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1694550" h="1996683">
                    <a:moveTo>
                      <a:pt x="1245464" y="229341"/>
                    </a:moveTo>
                    <a:cubicBezTo>
                      <a:pt x="1091183" y="163489"/>
                      <a:pt x="876694" y="22378"/>
                      <a:pt x="737464" y="3563"/>
                    </a:cubicBezTo>
                    <a:cubicBezTo>
                      <a:pt x="598234" y="-15252"/>
                      <a:pt x="475938" y="43074"/>
                      <a:pt x="410086" y="116452"/>
                    </a:cubicBezTo>
                    <a:cubicBezTo>
                      <a:pt x="344234" y="189830"/>
                      <a:pt x="408205" y="342230"/>
                      <a:pt x="342353" y="443830"/>
                    </a:cubicBezTo>
                    <a:cubicBezTo>
                      <a:pt x="276501" y="545430"/>
                      <a:pt x="45079" y="583059"/>
                      <a:pt x="14975" y="726052"/>
                    </a:cubicBezTo>
                    <a:cubicBezTo>
                      <a:pt x="-15129" y="869045"/>
                      <a:pt x="161730" y="1149386"/>
                      <a:pt x="161730" y="1301786"/>
                    </a:cubicBezTo>
                    <a:cubicBezTo>
                      <a:pt x="161730" y="1454186"/>
                      <a:pt x="-58403" y="1587770"/>
                      <a:pt x="14975" y="1640452"/>
                    </a:cubicBezTo>
                    <a:cubicBezTo>
                      <a:pt x="88353" y="1693134"/>
                      <a:pt x="500397" y="1570838"/>
                      <a:pt x="601997" y="1617875"/>
                    </a:cubicBezTo>
                    <a:cubicBezTo>
                      <a:pt x="703597" y="1664912"/>
                      <a:pt x="558723" y="1864349"/>
                      <a:pt x="624575" y="1922675"/>
                    </a:cubicBezTo>
                    <a:cubicBezTo>
                      <a:pt x="690427" y="1981001"/>
                      <a:pt x="901153" y="2029919"/>
                      <a:pt x="997108" y="1967830"/>
                    </a:cubicBezTo>
                    <a:cubicBezTo>
                      <a:pt x="1093063" y="1905741"/>
                      <a:pt x="1143864" y="1649859"/>
                      <a:pt x="1200308" y="1550141"/>
                    </a:cubicBezTo>
                    <a:cubicBezTo>
                      <a:pt x="1256752" y="1450423"/>
                      <a:pt x="1254871" y="1439134"/>
                      <a:pt x="1335775" y="1369519"/>
                    </a:cubicBezTo>
                    <a:cubicBezTo>
                      <a:pt x="1416679" y="1299904"/>
                      <a:pt x="1642456" y="1232170"/>
                      <a:pt x="1685730" y="1132452"/>
                    </a:cubicBezTo>
                    <a:cubicBezTo>
                      <a:pt x="1729004" y="1032734"/>
                      <a:pt x="1599182" y="893504"/>
                      <a:pt x="1595419" y="771208"/>
                    </a:cubicBezTo>
                    <a:cubicBezTo>
                      <a:pt x="1591656" y="648912"/>
                      <a:pt x="1715834" y="485223"/>
                      <a:pt x="1663153" y="398675"/>
                    </a:cubicBezTo>
                    <a:cubicBezTo>
                      <a:pt x="1610472" y="312127"/>
                      <a:pt x="1399745" y="295193"/>
                      <a:pt x="1245464" y="229341"/>
                    </a:cubicBez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6350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79" name="Forme libre 378"/>
              <p:cNvSpPr/>
              <p:nvPr/>
            </p:nvSpPr>
            <p:spPr>
              <a:xfrm>
                <a:off x="643434" y="1366517"/>
                <a:ext cx="775185" cy="752863"/>
              </a:xfrm>
              <a:custGeom>
                <a:avLst/>
                <a:gdLst>
                  <a:gd name="connsiteX0" fmla="*/ 599693 w 1256584"/>
                  <a:gd name="connsiteY0" fmla="*/ 3208 h 826201"/>
                  <a:gd name="connsiteX1" fmla="*/ 80404 w 1256584"/>
                  <a:gd name="connsiteY1" fmla="*/ 138675 h 826201"/>
                  <a:gd name="connsiteX2" fmla="*/ 80404 w 1256584"/>
                  <a:gd name="connsiteY2" fmla="*/ 612808 h 826201"/>
                  <a:gd name="connsiteX3" fmla="*/ 836760 w 1256584"/>
                  <a:gd name="connsiteY3" fmla="*/ 816008 h 826201"/>
                  <a:gd name="connsiteX4" fmla="*/ 1209293 w 1256584"/>
                  <a:gd name="connsiteY4" fmla="*/ 736986 h 826201"/>
                  <a:gd name="connsiteX5" fmla="*/ 1186715 w 1256584"/>
                  <a:gd name="connsiteY5" fmla="*/ 240275 h 826201"/>
                  <a:gd name="connsiteX6" fmla="*/ 599693 w 1256584"/>
                  <a:gd name="connsiteY6" fmla="*/ 3208 h 826201"/>
                  <a:gd name="connsiteX0" fmla="*/ 595273 w 1252164"/>
                  <a:gd name="connsiteY0" fmla="*/ 3208 h 1001020"/>
                  <a:gd name="connsiteX1" fmla="*/ 75984 w 1252164"/>
                  <a:gd name="connsiteY1" fmla="*/ 138675 h 1001020"/>
                  <a:gd name="connsiteX2" fmla="*/ 75984 w 1252164"/>
                  <a:gd name="connsiteY2" fmla="*/ 612808 h 1001020"/>
                  <a:gd name="connsiteX3" fmla="*/ 766437 w 1252164"/>
                  <a:gd name="connsiteY3" fmla="*/ 999436 h 1001020"/>
                  <a:gd name="connsiteX4" fmla="*/ 1204873 w 1252164"/>
                  <a:gd name="connsiteY4" fmla="*/ 736986 h 1001020"/>
                  <a:gd name="connsiteX5" fmla="*/ 1182295 w 1252164"/>
                  <a:gd name="connsiteY5" fmla="*/ 240275 h 1001020"/>
                  <a:gd name="connsiteX6" fmla="*/ 595273 w 1252164"/>
                  <a:gd name="connsiteY6" fmla="*/ 3208 h 1001020"/>
                  <a:gd name="connsiteX0" fmla="*/ 576932 w 1233823"/>
                  <a:gd name="connsiteY0" fmla="*/ 6014 h 1007843"/>
                  <a:gd name="connsiteX1" fmla="*/ 57643 w 1233823"/>
                  <a:gd name="connsiteY1" fmla="*/ 141481 h 1007843"/>
                  <a:gd name="connsiteX2" fmla="*/ 90437 w 1233823"/>
                  <a:gd name="connsiteY2" fmla="*/ 853481 h 1007843"/>
                  <a:gd name="connsiteX3" fmla="*/ 748096 w 1233823"/>
                  <a:gd name="connsiteY3" fmla="*/ 1002242 h 1007843"/>
                  <a:gd name="connsiteX4" fmla="*/ 1186532 w 1233823"/>
                  <a:gd name="connsiteY4" fmla="*/ 739792 h 1007843"/>
                  <a:gd name="connsiteX5" fmla="*/ 1163954 w 1233823"/>
                  <a:gd name="connsiteY5" fmla="*/ 243081 h 1007843"/>
                  <a:gd name="connsiteX6" fmla="*/ 576932 w 1233823"/>
                  <a:gd name="connsiteY6" fmla="*/ 6014 h 1007843"/>
                  <a:gd name="connsiteX0" fmla="*/ 577640 w 1234531"/>
                  <a:gd name="connsiteY0" fmla="*/ 6014 h 1080027"/>
                  <a:gd name="connsiteX1" fmla="*/ 58351 w 1234531"/>
                  <a:gd name="connsiteY1" fmla="*/ 141481 h 1080027"/>
                  <a:gd name="connsiteX2" fmla="*/ 91145 w 1234531"/>
                  <a:gd name="connsiteY2" fmla="*/ 853481 h 1080027"/>
                  <a:gd name="connsiteX3" fmla="*/ 761200 w 1234531"/>
                  <a:gd name="connsiteY3" fmla="*/ 1077457 h 1080027"/>
                  <a:gd name="connsiteX4" fmla="*/ 1187240 w 1234531"/>
                  <a:gd name="connsiteY4" fmla="*/ 739792 h 1080027"/>
                  <a:gd name="connsiteX5" fmla="*/ 1164662 w 1234531"/>
                  <a:gd name="connsiteY5" fmla="*/ 243081 h 1080027"/>
                  <a:gd name="connsiteX6" fmla="*/ 577640 w 1234531"/>
                  <a:gd name="connsiteY6" fmla="*/ 6014 h 10800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234531" h="1080027">
                    <a:moveTo>
                      <a:pt x="577640" y="6014"/>
                    </a:moveTo>
                    <a:cubicBezTo>
                      <a:pt x="393255" y="-10919"/>
                      <a:pt x="139433" y="237"/>
                      <a:pt x="58351" y="141481"/>
                    </a:cubicBezTo>
                    <a:cubicBezTo>
                      <a:pt x="-22731" y="282725"/>
                      <a:pt x="-25997" y="697485"/>
                      <a:pt x="91145" y="853481"/>
                    </a:cubicBezTo>
                    <a:cubicBezTo>
                      <a:pt x="208287" y="1009477"/>
                      <a:pt x="578518" y="1096405"/>
                      <a:pt x="761200" y="1077457"/>
                    </a:cubicBezTo>
                    <a:cubicBezTo>
                      <a:pt x="943883" y="1058509"/>
                      <a:pt x="1128914" y="835747"/>
                      <a:pt x="1187240" y="739792"/>
                    </a:cubicBezTo>
                    <a:cubicBezTo>
                      <a:pt x="1245566" y="643837"/>
                      <a:pt x="1262499" y="361614"/>
                      <a:pt x="1164662" y="243081"/>
                    </a:cubicBezTo>
                    <a:cubicBezTo>
                      <a:pt x="1066825" y="124548"/>
                      <a:pt x="762025" y="22947"/>
                      <a:pt x="577640" y="6014"/>
                    </a:cubicBezTo>
                    <a:close/>
                  </a:path>
                </a:pathLst>
              </a:custGeom>
              <a:solidFill>
                <a:srgbClr val="94BB61">
                  <a:alpha val="56000"/>
                </a:srgbClr>
              </a:solidFill>
              <a:ln w="6350">
                <a:solidFill>
                  <a:srgbClr val="517D33">
                    <a:alpha val="27843"/>
                  </a:srgb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372" name="Image 37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87304" y="1492027"/>
              <a:ext cx="91742" cy="119901"/>
            </a:xfrm>
            <a:prstGeom prst="rect">
              <a:avLst/>
            </a:prstGeom>
          </p:spPr>
        </p:pic>
        <p:pic>
          <p:nvPicPr>
            <p:cNvPr id="373" name="Image 37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9697824">
              <a:off x="2568211" y="1436767"/>
              <a:ext cx="91742" cy="119901"/>
            </a:xfrm>
            <a:prstGeom prst="rect">
              <a:avLst/>
            </a:prstGeom>
          </p:spPr>
        </p:pic>
        <p:pic>
          <p:nvPicPr>
            <p:cNvPr id="374" name="Image 37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8862660">
              <a:off x="2579084" y="1363197"/>
              <a:ext cx="91742" cy="119901"/>
            </a:xfrm>
            <a:prstGeom prst="rect">
              <a:avLst/>
            </a:prstGeom>
          </p:spPr>
        </p:pic>
        <p:pic>
          <p:nvPicPr>
            <p:cNvPr id="375" name="Image 37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6413979">
              <a:off x="2547142" y="1215028"/>
              <a:ext cx="91742" cy="119901"/>
            </a:xfrm>
            <a:prstGeom prst="rect">
              <a:avLst/>
            </a:prstGeom>
          </p:spPr>
        </p:pic>
        <p:pic>
          <p:nvPicPr>
            <p:cNvPr id="376" name="Image 37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5130222">
              <a:off x="2497389" y="1123575"/>
              <a:ext cx="91742" cy="119901"/>
            </a:xfrm>
            <a:prstGeom prst="rect">
              <a:avLst/>
            </a:prstGeom>
          </p:spPr>
        </p:pic>
        <p:pic>
          <p:nvPicPr>
            <p:cNvPr id="377" name="Image 37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7210582">
              <a:off x="2305602" y="1329716"/>
              <a:ext cx="91742" cy="119901"/>
            </a:xfrm>
            <a:prstGeom prst="rect">
              <a:avLst/>
            </a:prstGeom>
          </p:spPr>
        </p:pic>
      </p:grpSp>
      <p:sp>
        <p:nvSpPr>
          <p:cNvPr id="380" name="Rectangle 379"/>
          <p:cNvSpPr/>
          <p:nvPr/>
        </p:nvSpPr>
        <p:spPr>
          <a:xfrm>
            <a:off x="3354776" y="1903531"/>
            <a:ext cx="396837" cy="1855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>
              <a:solidFill>
                <a:schemeClr val="tx1"/>
              </a:solidFill>
            </a:endParaRPr>
          </a:p>
        </p:txBody>
      </p:sp>
      <p:sp>
        <p:nvSpPr>
          <p:cNvPr id="381" name="Rectangle 380"/>
          <p:cNvSpPr/>
          <p:nvPr/>
        </p:nvSpPr>
        <p:spPr>
          <a:xfrm>
            <a:off x="4825307" y="2309595"/>
            <a:ext cx="873769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fr-FR" sz="800" b="1" dirty="0" err="1"/>
              <a:t>P</a:t>
            </a:r>
            <a:r>
              <a:rPr lang="fr-FR" sz="800" b="1" dirty="0" err="1" smtClean="0"/>
              <a:t>olarized</a:t>
            </a:r>
            <a:r>
              <a:rPr lang="fr-FR" sz="800" b="1" dirty="0" smtClean="0"/>
              <a:t> </a:t>
            </a:r>
            <a:r>
              <a:rPr lang="fr-FR" sz="800" b="1" dirty="0" err="1" smtClean="0"/>
              <a:t>exposure</a:t>
            </a:r>
            <a:endParaRPr lang="fr-FR" sz="800" b="1" dirty="0"/>
          </a:p>
        </p:txBody>
      </p:sp>
      <p:sp>
        <p:nvSpPr>
          <p:cNvPr id="382" name="Rectangle 381"/>
          <p:cNvSpPr/>
          <p:nvPr/>
        </p:nvSpPr>
        <p:spPr>
          <a:xfrm>
            <a:off x="4768291" y="1339309"/>
            <a:ext cx="903487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fr-FR" sz="800" b="1" dirty="0" err="1" smtClean="0"/>
              <a:t>Intracellular</a:t>
            </a:r>
            <a:r>
              <a:rPr lang="fr-FR" sz="800" b="1" dirty="0" smtClean="0"/>
              <a:t> </a:t>
            </a:r>
            <a:r>
              <a:rPr lang="fr-FR" sz="800" b="1" dirty="0" err="1" smtClean="0"/>
              <a:t>trapping</a:t>
            </a:r>
            <a:r>
              <a:rPr lang="fr-FR" sz="800" b="1" dirty="0" smtClean="0"/>
              <a:t> </a:t>
            </a:r>
          </a:p>
        </p:txBody>
      </p:sp>
      <p:sp>
        <p:nvSpPr>
          <p:cNvPr id="383" name="Flèche droite 382"/>
          <p:cNvSpPr/>
          <p:nvPr/>
        </p:nvSpPr>
        <p:spPr>
          <a:xfrm>
            <a:off x="3794158" y="1457883"/>
            <a:ext cx="612000" cy="91894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384" name="Connecteur droit 383"/>
          <p:cNvCxnSpPr/>
          <p:nvPr/>
        </p:nvCxnSpPr>
        <p:spPr>
          <a:xfrm>
            <a:off x="2547164" y="3309204"/>
            <a:ext cx="180000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85" name="Groupe 384"/>
          <p:cNvGrpSpPr/>
          <p:nvPr/>
        </p:nvGrpSpPr>
        <p:grpSpPr>
          <a:xfrm>
            <a:off x="3215251" y="2240367"/>
            <a:ext cx="597665" cy="523805"/>
            <a:chOff x="4811557" y="1427018"/>
            <a:chExt cx="837891" cy="681694"/>
          </a:xfrm>
        </p:grpSpPr>
        <p:grpSp>
          <p:nvGrpSpPr>
            <p:cNvPr id="386" name="Groupe 385"/>
            <p:cNvGrpSpPr/>
            <p:nvPr/>
          </p:nvGrpSpPr>
          <p:grpSpPr>
            <a:xfrm rot="4730976">
              <a:off x="4839669" y="1398906"/>
              <a:ext cx="681694" cy="737917"/>
              <a:chOff x="5174972" y="1182750"/>
              <a:chExt cx="1284023" cy="1444207"/>
            </a:xfrm>
          </p:grpSpPr>
          <p:sp>
            <p:nvSpPr>
              <p:cNvPr id="393" name="Forme libre 392"/>
              <p:cNvSpPr/>
              <p:nvPr/>
            </p:nvSpPr>
            <p:spPr>
              <a:xfrm>
                <a:off x="5174972" y="1551746"/>
                <a:ext cx="1284023" cy="1075211"/>
              </a:xfrm>
              <a:custGeom>
                <a:avLst/>
                <a:gdLst>
                  <a:gd name="connsiteX0" fmla="*/ 1245464 w 1694550"/>
                  <a:gd name="connsiteY0" fmla="*/ 229341 h 1996683"/>
                  <a:gd name="connsiteX1" fmla="*/ 737464 w 1694550"/>
                  <a:gd name="connsiteY1" fmla="*/ 3563 h 1996683"/>
                  <a:gd name="connsiteX2" fmla="*/ 410086 w 1694550"/>
                  <a:gd name="connsiteY2" fmla="*/ 116452 h 1996683"/>
                  <a:gd name="connsiteX3" fmla="*/ 342353 w 1694550"/>
                  <a:gd name="connsiteY3" fmla="*/ 443830 h 1996683"/>
                  <a:gd name="connsiteX4" fmla="*/ 14975 w 1694550"/>
                  <a:gd name="connsiteY4" fmla="*/ 726052 h 1996683"/>
                  <a:gd name="connsiteX5" fmla="*/ 161730 w 1694550"/>
                  <a:gd name="connsiteY5" fmla="*/ 1301786 h 1996683"/>
                  <a:gd name="connsiteX6" fmla="*/ 14975 w 1694550"/>
                  <a:gd name="connsiteY6" fmla="*/ 1640452 h 1996683"/>
                  <a:gd name="connsiteX7" fmla="*/ 601997 w 1694550"/>
                  <a:gd name="connsiteY7" fmla="*/ 1617875 h 1996683"/>
                  <a:gd name="connsiteX8" fmla="*/ 624575 w 1694550"/>
                  <a:gd name="connsiteY8" fmla="*/ 1922675 h 1996683"/>
                  <a:gd name="connsiteX9" fmla="*/ 997108 w 1694550"/>
                  <a:gd name="connsiteY9" fmla="*/ 1967830 h 1996683"/>
                  <a:gd name="connsiteX10" fmla="*/ 1200308 w 1694550"/>
                  <a:gd name="connsiteY10" fmla="*/ 1550141 h 1996683"/>
                  <a:gd name="connsiteX11" fmla="*/ 1335775 w 1694550"/>
                  <a:gd name="connsiteY11" fmla="*/ 1369519 h 1996683"/>
                  <a:gd name="connsiteX12" fmla="*/ 1685730 w 1694550"/>
                  <a:gd name="connsiteY12" fmla="*/ 1132452 h 1996683"/>
                  <a:gd name="connsiteX13" fmla="*/ 1595419 w 1694550"/>
                  <a:gd name="connsiteY13" fmla="*/ 771208 h 1996683"/>
                  <a:gd name="connsiteX14" fmla="*/ 1663153 w 1694550"/>
                  <a:gd name="connsiteY14" fmla="*/ 398675 h 1996683"/>
                  <a:gd name="connsiteX15" fmla="*/ 1245464 w 1694550"/>
                  <a:gd name="connsiteY15" fmla="*/ 229341 h 1996683"/>
                  <a:gd name="connsiteX0" fmla="*/ 1245464 w 1694550"/>
                  <a:gd name="connsiteY0" fmla="*/ 124321 h 1891663"/>
                  <a:gd name="connsiteX1" fmla="*/ 782620 w 1694550"/>
                  <a:gd name="connsiteY1" fmla="*/ 79165 h 1891663"/>
                  <a:gd name="connsiteX2" fmla="*/ 410086 w 1694550"/>
                  <a:gd name="connsiteY2" fmla="*/ 11432 h 1891663"/>
                  <a:gd name="connsiteX3" fmla="*/ 342353 w 1694550"/>
                  <a:gd name="connsiteY3" fmla="*/ 338810 h 1891663"/>
                  <a:gd name="connsiteX4" fmla="*/ 14975 w 1694550"/>
                  <a:gd name="connsiteY4" fmla="*/ 621032 h 1891663"/>
                  <a:gd name="connsiteX5" fmla="*/ 161730 w 1694550"/>
                  <a:gd name="connsiteY5" fmla="*/ 1196766 h 1891663"/>
                  <a:gd name="connsiteX6" fmla="*/ 14975 w 1694550"/>
                  <a:gd name="connsiteY6" fmla="*/ 1535432 h 1891663"/>
                  <a:gd name="connsiteX7" fmla="*/ 601997 w 1694550"/>
                  <a:gd name="connsiteY7" fmla="*/ 1512855 h 1891663"/>
                  <a:gd name="connsiteX8" fmla="*/ 624575 w 1694550"/>
                  <a:gd name="connsiteY8" fmla="*/ 1817655 h 1891663"/>
                  <a:gd name="connsiteX9" fmla="*/ 997108 w 1694550"/>
                  <a:gd name="connsiteY9" fmla="*/ 1862810 h 1891663"/>
                  <a:gd name="connsiteX10" fmla="*/ 1200308 w 1694550"/>
                  <a:gd name="connsiteY10" fmla="*/ 1445121 h 1891663"/>
                  <a:gd name="connsiteX11" fmla="*/ 1335775 w 1694550"/>
                  <a:gd name="connsiteY11" fmla="*/ 1264499 h 1891663"/>
                  <a:gd name="connsiteX12" fmla="*/ 1685730 w 1694550"/>
                  <a:gd name="connsiteY12" fmla="*/ 1027432 h 1891663"/>
                  <a:gd name="connsiteX13" fmla="*/ 1595419 w 1694550"/>
                  <a:gd name="connsiteY13" fmla="*/ 666188 h 1891663"/>
                  <a:gd name="connsiteX14" fmla="*/ 1663153 w 1694550"/>
                  <a:gd name="connsiteY14" fmla="*/ 293655 h 1891663"/>
                  <a:gd name="connsiteX15" fmla="*/ 1245464 w 1694550"/>
                  <a:gd name="connsiteY15" fmla="*/ 124321 h 1891663"/>
                  <a:gd name="connsiteX0" fmla="*/ 782620 w 1694550"/>
                  <a:gd name="connsiteY0" fmla="*/ 79165 h 1891663"/>
                  <a:gd name="connsiteX1" fmla="*/ 410086 w 1694550"/>
                  <a:gd name="connsiteY1" fmla="*/ 11432 h 1891663"/>
                  <a:gd name="connsiteX2" fmla="*/ 342353 w 1694550"/>
                  <a:gd name="connsiteY2" fmla="*/ 338810 h 1891663"/>
                  <a:gd name="connsiteX3" fmla="*/ 14975 w 1694550"/>
                  <a:gd name="connsiteY3" fmla="*/ 621032 h 1891663"/>
                  <a:gd name="connsiteX4" fmla="*/ 161730 w 1694550"/>
                  <a:gd name="connsiteY4" fmla="*/ 1196766 h 1891663"/>
                  <a:gd name="connsiteX5" fmla="*/ 14975 w 1694550"/>
                  <a:gd name="connsiteY5" fmla="*/ 1535432 h 1891663"/>
                  <a:gd name="connsiteX6" fmla="*/ 601997 w 1694550"/>
                  <a:gd name="connsiteY6" fmla="*/ 1512855 h 1891663"/>
                  <a:gd name="connsiteX7" fmla="*/ 624575 w 1694550"/>
                  <a:gd name="connsiteY7" fmla="*/ 1817655 h 1891663"/>
                  <a:gd name="connsiteX8" fmla="*/ 997108 w 1694550"/>
                  <a:gd name="connsiteY8" fmla="*/ 1862810 h 1891663"/>
                  <a:gd name="connsiteX9" fmla="*/ 1200308 w 1694550"/>
                  <a:gd name="connsiteY9" fmla="*/ 1445121 h 1891663"/>
                  <a:gd name="connsiteX10" fmla="*/ 1335775 w 1694550"/>
                  <a:gd name="connsiteY10" fmla="*/ 1264499 h 1891663"/>
                  <a:gd name="connsiteX11" fmla="*/ 1685730 w 1694550"/>
                  <a:gd name="connsiteY11" fmla="*/ 1027432 h 1891663"/>
                  <a:gd name="connsiteX12" fmla="*/ 1595419 w 1694550"/>
                  <a:gd name="connsiteY12" fmla="*/ 666188 h 1891663"/>
                  <a:gd name="connsiteX13" fmla="*/ 1663153 w 1694550"/>
                  <a:gd name="connsiteY13" fmla="*/ 293655 h 1891663"/>
                  <a:gd name="connsiteX14" fmla="*/ 1245464 w 1694550"/>
                  <a:gd name="connsiteY14" fmla="*/ 124321 h 1891663"/>
                  <a:gd name="connsiteX15" fmla="*/ 874060 w 1694550"/>
                  <a:gd name="connsiteY15" fmla="*/ 170605 h 1891663"/>
                  <a:gd name="connsiteX0" fmla="*/ 816486 w 1694550"/>
                  <a:gd name="connsiteY0" fmla="*/ 150556 h 1884032"/>
                  <a:gd name="connsiteX1" fmla="*/ 410086 w 1694550"/>
                  <a:gd name="connsiteY1" fmla="*/ 3801 h 1884032"/>
                  <a:gd name="connsiteX2" fmla="*/ 342353 w 1694550"/>
                  <a:gd name="connsiteY2" fmla="*/ 331179 h 1884032"/>
                  <a:gd name="connsiteX3" fmla="*/ 14975 w 1694550"/>
                  <a:gd name="connsiteY3" fmla="*/ 613401 h 1884032"/>
                  <a:gd name="connsiteX4" fmla="*/ 161730 w 1694550"/>
                  <a:gd name="connsiteY4" fmla="*/ 1189135 h 1884032"/>
                  <a:gd name="connsiteX5" fmla="*/ 14975 w 1694550"/>
                  <a:gd name="connsiteY5" fmla="*/ 1527801 h 1884032"/>
                  <a:gd name="connsiteX6" fmla="*/ 601997 w 1694550"/>
                  <a:gd name="connsiteY6" fmla="*/ 1505224 h 1884032"/>
                  <a:gd name="connsiteX7" fmla="*/ 624575 w 1694550"/>
                  <a:gd name="connsiteY7" fmla="*/ 1810024 h 1884032"/>
                  <a:gd name="connsiteX8" fmla="*/ 997108 w 1694550"/>
                  <a:gd name="connsiteY8" fmla="*/ 1855179 h 1884032"/>
                  <a:gd name="connsiteX9" fmla="*/ 1200308 w 1694550"/>
                  <a:gd name="connsiteY9" fmla="*/ 1437490 h 1884032"/>
                  <a:gd name="connsiteX10" fmla="*/ 1335775 w 1694550"/>
                  <a:gd name="connsiteY10" fmla="*/ 1256868 h 1884032"/>
                  <a:gd name="connsiteX11" fmla="*/ 1685730 w 1694550"/>
                  <a:gd name="connsiteY11" fmla="*/ 1019801 h 1884032"/>
                  <a:gd name="connsiteX12" fmla="*/ 1595419 w 1694550"/>
                  <a:gd name="connsiteY12" fmla="*/ 658557 h 1884032"/>
                  <a:gd name="connsiteX13" fmla="*/ 1663153 w 1694550"/>
                  <a:gd name="connsiteY13" fmla="*/ 286024 h 1884032"/>
                  <a:gd name="connsiteX14" fmla="*/ 1245464 w 1694550"/>
                  <a:gd name="connsiteY14" fmla="*/ 116690 h 1884032"/>
                  <a:gd name="connsiteX15" fmla="*/ 874060 w 1694550"/>
                  <a:gd name="connsiteY15" fmla="*/ 162974 h 1884032"/>
                  <a:gd name="connsiteX0" fmla="*/ 816486 w 1694550"/>
                  <a:gd name="connsiteY0" fmla="*/ 150556 h 1884032"/>
                  <a:gd name="connsiteX1" fmla="*/ 410086 w 1694550"/>
                  <a:gd name="connsiteY1" fmla="*/ 3801 h 1884032"/>
                  <a:gd name="connsiteX2" fmla="*/ 342353 w 1694550"/>
                  <a:gd name="connsiteY2" fmla="*/ 331179 h 1884032"/>
                  <a:gd name="connsiteX3" fmla="*/ 14975 w 1694550"/>
                  <a:gd name="connsiteY3" fmla="*/ 613401 h 1884032"/>
                  <a:gd name="connsiteX4" fmla="*/ 161730 w 1694550"/>
                  <a:gd name="connsiteY4" fmla="*/ 1189135 h 1884032"/>
                  <a:gd name="connsiteX5" fmla="*/ 14975 w 1694550"/>
                  <a:gd name="connsiteY5" fmla="*/ 1527801 h 1884032"/>
                  <a:gd name="connsiteX6" fmla="*/ 601997 w 1694550"/>
                  <a:gd name="connsiteY6" fmla="*/ 1505224 h 1884032"/>
                  <a:gd name="connsiteX7" fmla="*/ 624575 w 1694550"/>
                  <a:gd name="connsiteY7" fmla="*/ 1810024 h 1884032"/>
                  <a:gd name="connsiteX8" fmla="*/ 997108 w 1694550"/>
                  <a:gd name="connsiteY8" fmla="*/ 1855179 h 1884032"/>
                  <a:gd name="connsiteX9" fmla="*/ 1200308 w 1694550"/>
                  <a:gd name="connsiteY9" fmla="*/ 1437490 h 1884032"/>
                  <a:gd name="connsiteX10" fmla="*/ 1335775 w 1694550"/>
                  <a:gd name="connsiteY10" fmla="*/ 1256868 h 1884032"/>
                  <a:gd name="connsiteX11" fmla="*/ 1685730 w 1694550"/>
                  <a:gd name="connsiteY11" fmla="*/ 1019801 h 1884032"/>
                  <a:gd name="connsiteX12" fmla="*/ 1595419 w 1694550"/>
                  <a:gd name="connsiteY12" fmla="*/ 658557 h 1884032"/>
                  <a:gd name="connsiteX13" fmla="*/ 1663153 w 1694550"/>
                  <a:gd name="connsiteY13" fmla="*/ 286024 h 1884032"/>
                  <a:gd name="connsiteX14" fmla="*/ 1245464 w 1694550"/>
                  <a:gd name="connsiteY14" fmla="*/ 116690 h 1884032"/>
                  <a:gd name="connsiteX15" fmla="*/ 964371 w 1694550"/>
                  <a:gd name="connsiteY15" fmla="*/ 309729 h 1884032"/>
                  <a:gd name="connsiteX0" fmla="*/ 748753 w 1694550"/>
                  <a:gd name="connsiteY0" fmla="*/ 282376 h 1880385"/>
                  <a:gd name="connsiteX1" fmla="*/ 410086 w 1694550"/>
                  <a:gd name="connsiteY1" fmla="*/ 154 h 1880385"/>
                  <a:gd name="connsiteX2" fmla="*/ 342353 w 1694550"/>
                  <a:gd name="connsiteY2" fmla="*/ 327532 h 1880385"/>
                  <a:gd name="connsiteX3" fmla="*/ 14975 w 1694550"/>
                  <a:gd name="connsiteY3" fmla="*/ 609754 h 1880385"/>
                  <a:gd name="connsiteX4" fmla="*/ 161730 w 1694550"/>
                  <a:gd name="connsiteY4" fmla="*/ 1185488 h 1880385"/>
                  <a:gd name="connsiteX5" fmla="*/ 14975 w 1694550"/>
                  <a:gd name="connsiteY5" fmla="*/ 1524154 h 1880385"/>
                  <a:gd name="connsiteX6" fmla="*/ 601997 w 1694550"/>
                  <a:gd name="connsiteY6" fmla="*/ 1501577 h 1880385"/>
                  <a:gd name="connsiteX7" fmla="*/ 624575 w 1694550"/>
                  <a:gd name="connsiteY7" fmla="*/ 1806377 h 1880385"/>
                  <a:gd name="connsiteX8" fmla="*/ 997108 w 1694550"/>
                  <a:gd name="connsiteY8" fmla="*/ 1851532 h 1880385"/>
                  <a:gd name="connsiteX9" fmla="*/ 1200308 w 1694550"/>
                  <a:gd name="connsiteY9" fmla="*/ 1433843 h 1880385"/>
                  <a:gd name="connsiteX10" fmla="*/ 1335775 w 1694550"/>
                  <a:gd name="connsiteY10" fmla="*/ 1253221 h 1880385"/>
                  <a:gd name="connsiteX11" fmla="*/ 1685730 w 1694550"/>
                  <a:gd name="connsiteY11" fmla="*/ 1016154 h 1880385"/>
                  <a:gd name="connsiteX12" fmla="*/ 1595419 w 1694550"/>
                  <a:gd name="connsiteY12" fmla="*/ 654910 h 1880385"/>
                  <a:gd name="connsiteX13" fmla="*/ 1663153 w 1694550"/>
                  <a:gd name="connsiteY13" fmla="*/ 282377 h 1880385"/>
                  <a:gd name="connsiteX14" fmla="*/ 1245464 w 1694550"/>
                  <a:gd name="connsiteY14" fmla="*/ 113043 h 1880385"/>
                  <a:gd name="connsiteX15" fmla="*/ 964371 w 1694550"/>
                  <a:gd name="connsiteY15" fmla="*/ 306082 h 1880385"/>
                  <a:gd name="connsiteX0" fmla="*/ 748753 w 1694550"/>
                  <a:gd name="connsiteY0" fmla="*/ 338679 h 1880243"/>
                  <a:gd name="connsiteX1" fmla="*/ 410086 w 1694550"/>
                  <a:gd name="connsiteY1" fmla="*/ 12 h 1880243"/>
                  <a:gd name="connsiteX2" fmla="*/ 342353 w 1694550"/>
                  <a:gd name="connsiteY2" fmla="*/ 327390 h 1880243"/>
                  <a:gd name="connsiteX3" fmla="*/ 14975 w 1694550"/>
                  <a:gd name="connsiteY3" fmla="*/ 609612 h 1880243"/>
                  <a:gd name="connsiteX4" fmla="*/ 161730 w 1694550"/>
                  <a:gd name="connsiteY4" fmla="*/ 1185346 h 1880243"/>
                  <a:gd name="connsiteX5" fmla="*/ 14975 w 1694550"/>
                  <a:gd name="connsiteY5" fmla="*/ 1524012 h 1880243"/>
                  <a:gd name="connsiteX6" fmla="*/ 601997 w 1694550"/>
                  <a:gd name="connsiteY6" fmla="*/ 1501435 h 1880243"/>
                  <a:gd name="connsiteX7" fmla="*/ 624575 w 1694550"/>
                  <a:gd name="connsiteY7" fmla="*/ 1806235 h 1880243"/>
                  <a:gd name="connsiteX8" fmla="*/ 997108 w 1694550"/>
                  <a:gd name="connsiteY8" fmla="*/ 1851390 h 1880243"/>
                  <a:gd name="connsiteX9" fmla="*/ 1200308 w 1694550"/>
                  <a:gd name="connsiteY9" fmla="*/ 1433701 h 1880243"/>
                  <a:gd name="connsiteX10" fmla="*/ 1335775 w 1694550"/>
                  <a:gd name="connsiteY10" fmla="*/ 1253079 h 1880243"/>
                  <a:gd name="connsiteX11" fmla="*/ 1685730 w 1694550"/>
                  <a:gd name="connsiteY11" fmla="*/ 1016012 h 1880243"/>
                  <a:gd name="connsiteX12" fmla="*/ 1595419 w 1694550"/>
                  <a:gd name="connsiteY12" fmla="*/ 654768 h 1880243"/>
                  <a:gd name="connsiteX13" fmla="*/ 1663153 w 1694550"/>
                  <a:gd name="connsiteY13" fmla="*/ 282235 h 1880243"/>
                  <a:gd name="connsiteX14" fmla="*/ 1245464 w 1694550"/>
                  <a:gd name="connsiteY14" fmla="*/ 112901 h 1880243"/>
                  <a:gd name="connsiteX15" fmla="*/ 964371 w 1694550"/>
                  <a:gd name="connsiteY15" fmla="*/ 305940 h 1880243"/>
                  <a:gd name="connsiteX0" fmla="*/ 748753 w 1694550"/>
                  <a:gd name="connsiteY0" fmla="*/ 225909 h 1767473"/>
                  <a:gd name="connsiteX1" fmla="*/ 493212 w 1694550"/>
                  <a:gd name="connsiteY1" fmla="*/ 150401 h 1767473"/>
                  <a:gd name="connsiteX2" fmla="*/ 342353 w 1694550"/>
                  <a:gd name="connsiteY2" fmla="*/ 214620 h 1767473"/>
                  <a:gd name="connsiteX3" fmla="*/ 14975 w 1694550"/>
                  <a:gd name="connsiteY3" fmla="*/ 496842 h 1767473"/>
                  <a:gd name="connsiteX4" fmla="*/ 161730 w 1694550"/>
                  <a:gd name="connsiteY4" fmla="*/ 1072576 h 1767473"/>
                  <a:gd name="connsiteX5" fmla="*/ 14975 w 1694550"/>
                  <a:gd name="connsiteY5" fmla="*/ 1411242 h 1767473"/>
                  <a:gd name="connsiteX6" fmla="*/ 601997 w 1694550"/>
                  <a:gd name="connsiteY6" fmla="*/ 1388665 h 1767473"/>
                  <a:gd name="connsiteX7" fmla="*/ 624575 w 1694550"/>
                  <a:gd name="connsiteY7" fmla="*/ 1693465 h 1767473"/>
                  <a:gd name="connsiteX8" fmla="*/ 997108 w 1694550"/>
                  <a:gd name="connsiteY8" fmla="*/ 1738620 h 1767473"/>
                  <a:gd name="connsiteX9" fmla="*/ 1200308 w 1694550"/>
                  <a:gd name="connsiteY9" fmla="*/ 1320931 h 1767473"/>
                  <a:gd name="connsiteX10" fmla="*/ 1335775 w 1694550"/>
                  <a:gd name="connsiteY10" fmla="*/ 1140309 h 1767473"/>
                  <a:gd name="connsiteX11" fmla="*/ 1685730 w 1694550"/>
                  <a:gd name="connsiteY11" fmla="*/ 903242 h 1767473"/>
                  <a:gd name="connsiteX12" fmla="*/ 1595419 w 1694550"/>
                  <a:gd name="connsiteY12" fmla="*/ 541998 h 1767473"/>
                  <a:gd name="connsiteX13" fmla="*/ 1663153 w 1694550"/>
                  <a:gd name="connsiteY13" fmla="*/ 169465 h 1767473"/>
                  <a:gd name="connsiteX14" fmla="*/ 1245464 w 1694550"/>
                  <a:gd name="connsiteY14" fmla="*/ 131 h 1767473"/>
                  <a:gd name="connsiteX15" fmla="*/ 964371 w 1694550"/>
                  <a:gd name="connsiteY15" fmla="*/ 193170 h 1767473"/>
                  <a:gd name="connsiteX0" fmla="*/ 738443 w 1684240"/>
                  <a:gd name="connsiteY0" fmla="*/ 225909 h 1767473"/>
                  <a:gd name="connsiteX1" fmla="*/ 482902 w 1684240"/>
                  <a:gd name="connsiteY1" fmla="*/ 150401 h 1767473"/>
                  <a:gd name="connsiteX2" fmla="*/ 332043 w 1684240"/>
                  <a:gd name="connsiteY2" fmla="*/ 214620 h 1767473"/>
                  <a:gd name="connsiteX3" fmla="*/ 4665 w 1684240"/>
                  <a:gd name="connsiteY3" fmla="*/ 496842 h 1767473"/>
                  <a:gd name="connsiteX4" fmla="*/ 151420 w 1684240"/>
                  <a:gd name="connsiteY4" fmla="*/ 1072576 h 1767473"/>
                  <a:gd name="connsiteX5" fmla="*/ 325300 w 1684240"/>
                  <a:gd name="connsiteY5" fmla="*/ 1248334 h 1767473"/>
                  <a:gd name="connsiteX6" fmla="*/ 591687 w 1684240"/>
                  <a:gd name="connsiteY6" fmla="*/ 1388665 h 1767473"/>
                  <a:gd name="connsiteX7" fmla="*/ 614265 w 1684240"/>
                  <a:gd name="connsiteY7" fmla="*/ 1693465 h 1767473"/>
                  <a:gd name="connsiteX8" fmla="*/ 986798 w 1684240"/>
                  <a:gd name="connsiteY8" fmla="*/ 1738620 h 1767473"/>
                  <a:gd name="connsiteX9" fmla="*/ 1189998 w 1684240"/>
                  <a:gd name="connsiteY9" fmla="*/ 1320931 h 1767473"/>
                  <a:gd name="connsiteX10" fmla="*/ 1325465 w 1684240"/>
                  <a:gd name="connsiteY10" fmla="*/ 1140309 h 1767473"/>
                  <a:gd name="connsiteX11" fmla="*/ 1675420 w 1684240"/>
                  <a:gd name="connsiteY11" fmla="*/ 903242 h 1767473"/>
                  <a:gd name="connsiteX12" fmla="*/ 1585109 w 1684240"/>
                  <a:gd name="connsiteY12" fmla="*/ 541998 h 1767473"/>
                  <a:gd name="connsiteX13" fmla="*/ 1652843 w 1684240"/>
                  <a:gd name="connsiteY13" fmla="*/ 169465 h 1767473"/>
                  <a:gd name="connsiteX14" fmla="*/ 1235154 w 1684240"/>
                  <a:gd name="connsiteY14" fmla="*/ 131 h 1767473"/>
                  <a:gd name="connsiteX15" fmla="*/ 954061 w 1684240"/>
                  <a:gd name="connsiteY15" fmla="*/ 193170 h 1767473"/>
                  <a:gd name="connsiteX0" fmla="*/ 738443 w 1684240"/>
                  <a:gd name="connsiteY0" fmla="*/ 225909 h 1746659"/>
                  <a:gd name="connsiteX1" fmla="*/ 482902 w 1684240"/>
                  <a:gd name="connsiteY1" fmla="*/ 150401 h 1746659"/>
                  <a:gd name="connsiteX2" fmla="*/ 332043 w 1684240"/>
                  <a:gd name="connsiteY2" fmla="*/ 214620 h 1746659"/>
                  <a:gd name="connsiteX3" fmla="*/ 4665 w 1684240"/>
                  <a:gd name="connsiteY3" fmla="*/ 496842 h 1746659"/>
                  <a:gd name="connsiteX4" fmla="*/ 151420 w 1684240"/>
                  <a:gd name="connsiteY4" fmla="*/ 1072576 h 1746659"/>
                  <a:gd name="connsiteX5" fmla="*/ 325300 w 1684240"/>
                  <a:gd name="connsiteY5" fmla="*/ 1248334 h 1746659"/>
                  <a:gd name="connsiteX6" fmla="*/ 591687 w 1684240"/>
                  <a:gd name="connsiteY6" fmla="*/ 1388665 h 1746659"/>
                  <a:gd name="connsiteX7" fmla="*/ 804269 w 1684240"/>
                  <a:gd name="connsiteY7" fmla="*/ 1580681 h 1746659"/>
                  <a:gd name="connsiteX8" fmla="*/ 986798 w 1684240"/>
                  <a:gd name="connsiteY8" fmla="*/ 1738620 h 1746659"/>
                  <a:gd name="connsiteX9" fmla="*/ 1189998 w 1684240"/>
                  <a:gd name="connsiteY9" fmla="*/ 1320931 h 1746659"/>
                  <a:gd name="connsiteX10" fmla="*/ 1325465 w 1684240"/>
                  <a:gd name="connsiteY10" fmla="*/ 1140309 h 1746659"/>
                  <a:gd name="connsiteX11" fmla="*/ 1675420 w 1684240"/>
                  <a:gd name="connsiteY11" fmla="*/ 903242 h 1746659"/>
                  <a:gd name="connsiteX12" fmla="*/ 1585109 w 1684240"/>
                  <a:gd name="connsiteY12" fmla="*/ 541998 h 1746659"/>
                  <a:gd name="connsiteX13" fmla="*/ 1652843 w 1684240"/>
                  <a:gd name="connsiteY13" fmla="*/ 169465 h 1746659"/>
                  <a:gd name="connsiteX14" fmla="*/ 1235154 w 1684240"/>
                  <a:gd name="connsiteY14" fmla="*/ 131 h 1746659"/>
                  <a:gd name="connsiteX15" fmla="*/ 954061 w 1684240"/>
                  <a:gd name="connsiteY15" fmla="*/ 193170 h 1746659"/>
                  <a:gd name="connsiteX0" fmla="*/ 738443 w 1684240"/>
                  <a:gd name="connsiteY0" fmla="*/ 225909 h 1590718"/>
                  <a:gd name="connsiteX1" fmla="*/ 482902 w 1684240"/>
                  <a:gd name="connsiteY1" fmla="*/ 150401 h 1590718"/>
                  <a:gd name="connsiteX2" fmla="*/ 332043 w 1684240"/>
                  <a:gd name="connsiteY2" fmla="*/ 214620 h 1590718"/>
                  <a:gd name="connsiteX3" fmla="*/ 4665 w 1684240"/>
                  <a:gd name="connsiteY3" fmla="*/ 496842 h 1590718"/>
                  <a:gd name="connsiteX4" fmla="*/ 151420 w 1684240"/>
                  <a:gd name="connsiteY4" fmla="*/ 1072576 h 1590718"/>
                  <a:gd name="connsiteX5" fmla="*/ 325300 w 1684240"/>
                  <a:gd name="connsiteY5" fmla="*/ 1248334 h 1590718"/>
                  <a:gd name="connsiteX6" fmla="*/ 591687 w 1684240"/>
                  <a:gd name="connsiteY6" fmla="*/ 1388665 h 1590718"/>
                  <a:gd name="connsiteX7" fmla="*/ 804269 w 1684240"/>
                  <a:gd name="connsiteY7" fmla="*/ 1580681 h 1590718"/>
                  <a:gd name="connsiteX8" fmla="*/ 927421 w 1684240"/>
                  <a:gd name="connsiteY8" fmla="*/ 1538118 h 1590718"/>
                  <a:gd name="connsiteX9" fmla="*/ 1189998 w 1684240"/>
                  <a:gd name="connsiteY9" fmla="*/ 1320931 h 1590718"/>
                  <a:gd name="connsiteX10" fmla="*/ 1325465 w 1684240"/>
                  <a:gd name="connsiteY10" fmla="*/ 1140309 h 1590718"/>
                  <a:gd name="connsiteX11" fmla="*/ 1675420 w 1684240"/>
                  <a:gd name="connsiteY11" fmla="*/ 903242 h 1590718"/>
                  <a:gd name="connsiteX12" fmla="*/ 1585109 w 1684240"/>
                  <a:gd name="connsiteY12" fmla="*/ 541998 h 1590718"/>
                  <a:gd name="connsiteX13" fmla="*/ 1652843 w 1684240"/>
                  <a:gd name="connsiteY13" fmla="*/ 169465 h 1590718"/>
                  <a:gd name="connsiteX14" fmla="*/ 1235154 w 1684240"/>
                  <a:gd name="connsiteY14" fmla="*/ 131 h 1590718"/>
                  <a:gd name="connsiteX15" fmla="*/ 954061 w 1684240"/>
                  <a:gd name="connsiteY15" fmla="*/ 193170 h 1590718"/>
                  <a:gd name="connsiteX0" fmla="*/ 774070 w 1684240"/>
                  <a:gd name="connsiteY0" fmla="*/ 113127 h 1590717"/>
                  <a:gd name="connsiteX1" fmla="*/ 482902 w 1684240"/>
                  <a:gd name="connsiteY1" fmla="*/ 150401 h 1590717"/>
                  <a:gd name="connsiteX2" fmla="*/ 332043 w 1684240"/>
                  <a:gd name="connsiteY2" fmla="*/ 214620 h 1590717"/>
                  <a:gd name="connsiteX3" fmla="*/ 4665 w 1684240"/>
                  <a:gd name="connsiteY3" fmla="*/ 496842 h 1590717"/>
                  <a:gd name="connsiteX4" fmla="*/ 151420 w 1684240"/>
                  <a:gd name="connsiteY4" fmla="*/ 1072576 h 1590717"/>
                  <a:gd name="connsiteX5" fmla="*/ 325300 w 1684240"/>
                  <a:gd name="connsiteY5" fmla="*/ 1248334 h 1590717"/>
                  <a:gd name="connsiteX6" fmla="*/ 591687 w 1684240"/>
                  <a:gd name="connsiteY6" fmla="*/ 1388665 h 1590717"/>
                  <a:gd name="connsiteX7" fmla="*/ 804269 w 1684240"/>
                  <a:gd name="connsiteY7" fmla="*/ 1580681 h 1590717"/>
                  <a:gd name="connsiteX8" fmla="*/ 927421 w 1684240"/>
                  <a:gd name="connsiteY8" fmla="*/ 1538118 h 1590717"/>
                  <a:gd name="connsiteX9" fmla="*/ 1189998 w 1684240"/>
                  <a:gd name="connsiteY9" fmla="*/ 1320931 h 1590717"/>
                  <a:gd name="connsiteX10" fmla="*/ 1325465 w 1684240"/>
                  <a:gd name="connsiteY10" fmla="*/ 1140309 h 1590717"/>
                  <a:gd name="connsiteX11" fmla="*/ 1675420 w 1684240"/>
                  <a:gd name="connsiteY11" fmla="*/ 903242 h 1590717"/>
                  <a:gd name="connsiteX12" fmla="*/ 1585109 w 1684240"/>
                  <a:gd name="connsiteY12" fmla="*/ 541998 h 1590717"/>
                  <a:gd name="connsiteX13" fmla="*/ 1652843 w 1684240"/>
                  <a:gd name="connsiteY13" fmla="*/ 169465 h 1590717"/>
                  <a:gd name="connsiteX14" fmla="*/ 1235154 w 1684240"/>
                  <a:gd name="connsiteY14" fmla="*/ 131 h 1590717"/>
                  <a:gd name="connsiteX15" fmla="*/ 954061 w 1684240"/>
                  <a:gd name="connsiteY15" fmla="*/ 193170 h 1590717"/>
                  <a:gd name="connsiteX0" fmla="*/ 528038 w 1684240"/>
                  <a:gd name="connsiteY0" fmla="*/ 1606 h 1614418"/>
                  <a:gd name="connsiteX1" fmla="*/ 482902 w 1684240"/>
                  <a:gd name="connsiteY1" fmla="*/ 174102 h 1614418"/>
                  <a:gd name="connsiteX2" fmla="*/ 332043 w 1684240"/>
                  <a:gd name="connsiteY2" fmla="*/ 238321 h 1614418"/>
                  <a:gd name="connsiteX3" fmla="*/ 4665 w 1684240"/>
                  <a:gd name="connsiteY3" fmla="*/ 520543 h 1614418"/>
                  <a:gd name="connsiteX4" fmla="*/ 151420 w 1684240"/>
                  <a:gd name="connsiteY4" fmla="*/ 1096277 h 1614418"/>
                  <a:gd name="connsiteX5" fmla="*/ 325300 w 1684240"/>
                  <a:gd name="connsiteY5" fmla="*/ 1272035 h 1614418"/>
                  <a:gd name="connsiteX6" fmla="*/ 591687 w 1684240"/>
                  <a:gd name="connsiteY6" fmla="*/ 1412366 h 1614418"/>
                  <a:gd name="connsiteX7" fmla="*/ 804269 w 1684240"/>
                  <a:gd name="connsiteY7" fmla="*/ 1604382 h 1614418"/>
                  <a:gd name="connsiteX8" fmla="*/ 927421 w 1684240"/>
                  <a:gd name="connsiteY8" fmla="*/ 1561819 h 1614418"/>
                  <a:gd name="connsiteX9" fmla="*/ 1189998 w 1684240"/>
                  <a:gd name="connsiteY9" fmla="*/ 1344632 h 1614418"/>
                  <a:gd name="connsiteX10" fmla="*/ 1325465 w 1684240"/>
                  <a:gd name="connsiteY10" fmla="*/ 1164010 h 1614418"/>
                  <a:gd name="connsiteX11" fmla="*/ 1675420 w 1684240"/>
                  <a:gd name="connsiteY11" fmla="*/ 926943 h 1614418"/>
                  <a:gd name="connsiteX12" fmla="*/ 1585109 w 1684240"/>
                  <a:gd name="connsiteY12" fmla="*/ 565699 h 1614418"/>
                  <a:gd name="connsiteX13" fmla="*/ 1652843 w 1684240"/>
                  <a:gd name="connsiteY13" fmla="*/ 193166 h 1614418"/>
                  <a:gd name="connsiteX14" fmla="*/ 1235154 w 1684240"/>
                  <a:gd name="connsiteY14" fmla="*/ 23832 h 1614418"/>
                  <a:gd name="connsiteX15" fmla="*/ 954061 w 1684240"/>
                  <a:gd name="connsiteY15" fmla="*/ 216871 h 1614418"/>
                  <a:gd name="connsiteX0" fmla="*/ 528038 w 1684240"/>
                  <a:gd name="connsiteY0" fmla="*/ 26249 h 1639061"/>
                  <a:gd name="connsiteX1" fmla="*/ 482902 w 1684240"/>
                  <a:gd name="connsiteY1" fmla="*/ 198745 h 1639061"/>
                  <a:gd name="connsiteX2" fmla="*/ 332043 w 1684240"/>
                  <a:gd name="connsiteY2" fmla="*/ 262964 h 1639061"/>
                  <a:gd name="connsiteX3" fmla="*/ 4665 w 1684240"/>
                  <a:gd name="connsiteY3" fmla="*/ 545186 h 1639061"/>
                  <a:gd name="connsiteX4" fmla="*/ 151420 w 1684240"/>
                  <a:gd name="connsiteY4" fmla="*/ 1120920 h 1639061"/>
                  <a:gd name="connsiteX5" fmla="*/ 325300 w 1684240"/>
                  <a:gd name="connsiteY5" fmla="*/ 1296678 h 1639061"/>
                  <a:gd name="connsiteX6" fmla="*/ 591687 w 1684240"/>
                  <a:gd name="connsiteY6" fmla="*/ 1437009 h 1639061"/>
                  <a:gd name="connsiteX7" fmla="*/ 804269 w 1684240"/>
                  <a:gd name="connsiteY7" fmla="*/ 1629025 h 1639061"/>
                  <a:gd name="connsiteX8" fmla="*/ 927421 w 1684240"/>
                  <a:gd name="connsiteY8" fmla="*/ 1586462 h 1639061"/>
                  <a:gd name="connsiteX9" fmla="*/ 1189998 w 1684240"/>
                  <a:gd name="connsiteY9" fmla="*/ 1369275 h 1639061"/>
                  <a:gd name="connsiteX10" fmla="*/ 1325465 w 1684240"/>
                  <a:gd name="connsiteY10" fmla="*/ 1188653 h 1639061"/>
                  <a:gd name="connsiteX11" fmla="*/ 1675420 w 1684240"/>
                  <a:gd name="connsiteY11" fmla="*/ 951586 h 1639061"/>
                  <a:gd name="connsiteX12" fmla="*/ 1585109 w 1684240"/>
                  <a:gd name="connsiteY12" fmla="*/ 590342 h 1639061"/>
                  <a:gd name="connsiteX13" fmla="*/ 1652843 w 1684240"/>
                  <a:gd name="connsiteY13" fmla="*/ 217809 h 1639061"/>
                  <a:gd name="connsiteX14" fmla="*/ 1235154 w 1684240"/>
                  <a:gd name="connsiteY14" fmla="*/ 48475 h 1639061"/>
                  <a:gd name="connsiteX15" fmla="*/ 1041198 w 1684240"/>
                  <a:gd name="connsiteY15" fmla="*/ 35978 h 1639061"/>
                  <a:gd name="connsiteX0" fmla="*/ 528038 w 1684240"/>
                  <a:gd name="connsiteY0" fmla="*/ 26249 h 1588022"/>
                  <a:gd name="connsiteX1" fmla="*/ 482902 w 1684240"/>
                  <a:gd name="connsiteY1" fmla="*/ 198745 h 1588022"/>
                  <a:gd name="connsiteX2" fmla="*/ 332043 w 1684240"/>
                  <a:gd name="connsiteY2" fmla="*/ 262964 h 1588022"/>
                  <a:gd name="connsiteX3" fmla="*/ 4665 w 1684240"/>
                  <a:gd name="connsiteY3" fmla="*/ 545186 h 1588022"/>
                  <a:gd name="connsiteX4" fmla="*/ 151420 w 1684240"/>
                  <a:gd name="connsiteY4" fmla="*/ 1120920 h 1588022"/>
                  <a:gd name="connsiteX5" fmla="*/ 325300 w 1684240"/>
                  <a:gd name="connsiteY5" fmla="*/ 1296678 h 1588022"/>
                  <a:gd name="connsiteX6" fmla="*/ 591687 w 1684240"/>
                  <a:gd name="connsiteY6" fmla="*/ 1437009 h 1588022"/>
                  <a:gd name="connsiteX7" fmla="*/ 787950 w 1684240"/>
                  <a:gd name="connsiteY7" fmla="*/ 1465434 h 1588022"/>
                  <a:gd name="connsiteX8" fmla="*/ 927421 w 1684240"/>
                  <a:gd name="connsiteY8" fmla="*/ 1586462 h 1588022"/>
                  <a:gd name="connsiteX9" fmla="*/ 1189998 w 1684240"/>
                  <a:gd name="connsiteY9" fmla="*/ 1369275 h 1588022"/>
                  <a:gd name="connsiteX10" fmla="*/ 1325465 w 1684240"/>
                  <a:gd name="connsiteY10" fmla="*/ 1188653 h 1588022"/>
                  <a:gd name="connsiteX11" fmla="*/ 1675420 w 1684240"/>
                  <a:gd name="connsiteY11" fmla="*/ 951586 h 1588022"/>
                  <a:gd name="connsiteX12" fmla="*/ 1585109 w 1684240"/>
                  <a:gd name="connsiteY12" fmla="*/ 590342 h 1588022"/>
                  <a:gd name="connsiteX13" fmla="*/ 1652843 w 1684240"/>
                  <a:gd name="connsiteY13" fmla="*/ 217809 h 1588022"/>
                  <a:gd name="connsiteX14" fmla="*/ 1235154 w 1684240"/>
                  <a:gd name="connsiteY14" fmla="*/ 48475 h 1588022"/>
                  <a:gd name="connsiteX15" fmla="*/ 1041198 w 1684240"/>
                  <a:gd name="connsiteY15" fmla="*/ 35978 h 1588022"/>
                  <a:gd name="connsiteX0" fmla="*/ 528038 w 1684240"/>
                  <a:gd name="connsiteY0" fmla="*/ 26249 h 1488258"/>
                  <a:gd name="connsiteX1" fmla="*/ 482902 w 1684240"/>
                  <a:gd name="connsiteY1" fmla="*/ 198745 h 1488258"/>
                  <a:gd name="connsiteX2" fmla="*/ 332043 w 1684240"/>
                  <a:gd name="connsiteY2" fmla="*/ 262964 h 1488258"/>
                  <a:gd name="connsiteX3" fmla="*/ 4665 w 1684240"/>
                  <a:gd name="connsiteY3" fmla="*/ 545186 h 1488258"/>
                  <a:gd name="connsiteX4" fmla="*/ 151420 w 1684240"/>
                  <a:gd name="connsiteY4" fmla="*/ 1120920 h 1488258"/>
                  <a:gd name="connsiteX5" fmla="*/ 325300 w 1684240"/>
                  <a:gd name="connsiteY5" fmla="*/ 1296678 h 1488258"/>
                  <a:gd name="connsiteX6" fmla="*/ 591687 w 1684240"/>
                  <a:gd name="connsiteY6" fmla="*/ 1437009 h 1488258"/>
                  <a:gd name="connsiteX7" fmla="*/ 787950 w 1684240"/>
                  <a:gd name="connsiteY7" fmla="*/ 1465434 h 1488258"/>
                  <a:gd name="connsiteX8" fmla="*/ 984536 w 1684240"/>
                  <a:gd name="connsiteY8" fmla="*/ 1483142 h 1488258"/>
                  <a:gd name="connsiteX9" fmla="*/ 1189998 w 1684240"/>
                  <a:gd name="connsiteY9" fmla="*/ 1369275 h 1488258"/>
                  <a:gd name="connsiteX10" fmla="*/ 1325465 w 1684240"/>
                  <a:gd name="connsiteY10" fmla="*/ 1188653 h 1488258"/>
                  <a:gd name="connsiteX11" fmla="*/ 1675420 w 1684240"/>
                  <a:gd name="connsiteY11" fmla="*/ 951586 h 1488258"/>
                  <a:gd name="connsiteX12" fmla="*/ 1585109 w 1684240"/>
                  <a:gd name="connsiteY12" fmla="*/ 590342 h 1488258"/>
                  <a:gd name="connsiteX13" fmla="*/ 1652843 w 1684240"/>
                  <a:gd name="connsiteY13" fmla="*/ 217809 h 1488258"/>
                  <a:gd name="connsiteX14" fmla="*/ 1235154 w 1684240"/>
                  <a:gd name="connsiteY14" fmla="*/ 48475 h 1488258"/>
                  <a:gd name="connsiteX15" fmla="*/ 1041198 w 1684240"/>
                  <a:gd name="connsiteY15" fmla="*/ 35978 h 148825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1684240" h="1488258">
                    <a:moveTo>
                      <a:pt x="528038" y="26249"/>
                    </a:moveTo>
                    <a:cubicBezTo>
                      <a:pt x="388808" y="7434"/>
                      <a:pt x="515568" y="159293"/>
                      <a:pt x="482902" y="198745"/>
                    </a:cubicBezTo>
                    <a:cubicBezTo>
                      <a:pt x="450236" y="238198"/>
                      <a:pt x="411749" y="205224"/>
                      <a:pt x="332043" y="262964"/>
                    </a:cubicBezTo>
                    <a:cubicBezTo>
                      <a:pt x="252337" y="320704"/>
                      <a:pt x="34769" y="402193"/>
                      <a:pt x="4665" y="545186"/>
                    </a:cubicBezTo>
                    <a:cubicBezTo>
                      <a:pt x="-25439" y="688179"/>
                      <a:pt x="97981" y="995671"/>
                      <a:pt x="151420" y="1120920"/>
                    </a:cubicBezTo>
                    <a:cubicBezTo>
                      <a:pt x="204859" y="1246169"/>
                      <a:pt x="251922" y="1243996"/>
                      <a:pt x="325300" y="1296678"/>
                    </a:cubicBezTo>
                    <a:cubicBezTo>
                      <a:pt x="398678" y="1349360"/>
                      <a:pt x="514579" y="1408883"/>
                      <a:pt x="591687" y="1437009"/>
                    </a:cubicBezTo>
                    <a:cubicBezTo>
                      <a:pt x="668795" y="1465135"/>
                      <a:pt x="722475" y="1457745"/>
                      <a:pt x="787950" y="1465434"/>
                    </a:cubicBezTo>
                    <a:cubicBezTo>
                      <a:pt x="853425" y="1473123"/>
                      <a:pt x="917528" y="1499168"/>
                      <a:pt x="984536" y="1483142"/>
                    </a:cubicBezTo>
                    <a:cubicBezTo>
                      <a:pt x="1051544" y="1467116"/>
                      <a:pt x="1133177" y="1418356"/>
                      <a:pt x="1189998" y="1369275"/>
                    </a:cubicBezTo>
                    <a:cubicBezTo>
                      <a:pt x="1246819" y="1320194"/>
                      <a:pt x="1244561" y="1258268"/>
                      <a:pt x="1325465" y="1188653"/>
                    </a:cubicBezTo>
                    <a:cubicBezTo>
                      <a:pt x="1406369" y="1119038"/>
                      <a:pt x="1632146" y="1051304"/>
                      <a:pt x="1675420" y="951586"/>
                    </a:cubicBezTo>
                    <a:cubicBezTo>
                      <a:pt x="1718694" y="851868"/>
                      <a:pt x="1588872" y="712638"/>
                      <a:pt x="1585109" y="590342"/>
                    </a:cubicBezTo>
                    <a:cubicBezTo>
                      <a:pt x="1581346" y="468046"/>
                      <a:pt x="1705524" y="304357"/>
                      <a:pt x="1652843" y="217809"/>
                    </a:cubicBezTo>
                    <a:cubicBezTo>
                      <a:pt x="1600162" y="131261"/>
                      <a:pt x="1337095" y="78780"/>
                      <a:pt x="1235154" y="48475"/>
                    </a:cubicBezTo>
                    <a:cubicBezTo>
                      <a:pt x="1133213" y="18170"/>
                      <a:pt x="1088988" y="-36647"/>
                      <a:pt x="1041198" y="35978"/>
                    </a:cubicBezTo>
                  </a:path>
                </a:pathLst>
              </a:custGeom>
              <a:solidFill>
                <a:schemeClr val="bg1">
                  <a:lumMod val="75000"/>
                  <a:alpha val="48000"/>
                </a:schemeClr>
              </a:solidFill>
              <a:ln w="6350">
                <a:solidFill>
                  <a:schemeClr val="bg1">
                    <a:lumMod val="65000"/>
                  </a:schemeClr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94" name="Forme libre 393"/>
              <p:cNvSpPr/>
              <p:nvPr/>
            </p:nvSpPr>
            <p:spPr>
              <a:xfrm flipV="1">
                <a:off x="5563801" y="1182750"/>
                <a:ext cx="635212" cy="396366"/>
              </a:xfrm>
              <a:custGeom>
                <a:avLst/>
                <a:gdLst>
                  <a:gd name="connsiteX0" fmla="*/ 599693 w 1256584"/>
                  <a:gd name="connsiteY0" fmla="*/ 3208 h 826201"/>
                  <a:gd name="connsiteX1" fmla="*/ 80404 w 1256584"/>
                  <a:gd name="connsiteY1" fmla="*/ 138675 h 826201"/>
                  <a:gd name="connsiteX2" fmla="*/ 80404 w 1256584"/>
                  <a:gd name="connsiteY2" fmla="*/ 612808 h 826201"/>
                  <a:gd name="connsiteX3" fmla="*/ 836760 w 1256584"/>
                  <a:gd name="connsiteY3" fmla="*/ 816008 h 826201"/>
                  <a:gd name="connsiteX4" fmla="*/ 1209293 w 1256584"/>
                  <a:gd name="connsiteY4" fmla="*/ 736986 h 826201"/>
                  <a:gd name="connsiteX5" fmla="*/ 1186715 w 1256584"/>
                  <a:gd name="connsiteY5" fmla="*/ 240275 h 826201"/>
                  <a:gd name="connsiteX6" fmla="*/ 599693 w 1256584"/>
                  <a:gd name="connsiteY6" fmla="*/ 3208 h 826201"/>
                  <a:gd name="connsiteX0" fmla="*/ 599693 w 1256584"/>
                  <a:gd name="connsiteY0" fmla="*/ 3208 h 826201"/>
                  <a:gd name="connsiteX1" fmla="*/ 80404 w 1256584"/>
                  <a:gd name="connsiteY1" fmla="*/ 138675 h 826201"/>
                  <a:gd name="connsiteX2" fmla="*/ 80404 w 1256584"/>
                  <a:gd name="connsiteY2" fmla="*/ 612808 h 826201"/>
                  <a:gd name="connsiteX3" fmla="*/ 836760 w 1256584"/>
                  <a:gd name="connsiteY3" fmla="*/ 816008 h 826201"/>
                  <a:gd name="connsiteX4" fmla="*/ 1209293 w 1256584"/>
                  <a:gd name="connsiteY4" fmla="*/ 736986 h 826201"/>
                  <a:gd name="connsiteX5" fmla="*/ 1186715 w 1256584"/>
                  <a:gd name="connsiteY5" fmla="*/ 240275 h 826201"/>
                  <a:gd name="connsiteX6" fmla="*/ 747724 w 1256584"/>
                  <a:gd name="connsiteY6" fmla="*/ 152847 h 826201"/>
                  <a:gd name="connsiteX0" fmla="*/ 459650 w 1249388"/>
                  <a:gd name="connsiteY0" fmla="*/ 1488 h 920403"/>
                  <a:gd name="connsiteX1" fmla="*/ 73208 w 1249388"/>
                  <a:gd name="connsiteY1" fmla="*/ 232877 h 920403"/>
                  <a:gd name="connsiteX2" fmla="*/ 73208 w 1249388"/>
                  <a:gd name="connsiteY2" fmla="*/ 707010 h 920403"/>
                  <a:gd name="connsiteX3" fmla="*/ 829564 w 1249388"/>
                  <a:gd name="connsiteY3" fmla="*/ 910210 h 920403"/>
                  <a:gd name="connsiteX4" fmla="*/ 1202097 w 1249388"/>
                  <a:gd name="connsiteY4" fmla="*/ 831188 h 920403"/>
                  <a:gd name="connsiteX5" fmla="*/ 1179519 w 1249388"/>
                  <a:gd name="connsiteY5" fmla="*/ 334477 h 920403"/>
                  <a:gd name="connsiteX6" fmla="*/ 740528 w 1249388"/>
                  <a:gd name="connsiteY6" fmla="*/ 247049 h 920403"/>
                  <a:gd name="connsiteX0" fmla="*/ 459650 w 1247912"/>
                  <a:gd name="connsiteY0" fmla="*/ 1488 h 920403"/>
                  <a:gd name="connsiteX1" fmla="*/ 73208 w 1247912"/>
                  <a:gd name="connsiteY1" fmla="*/ 232877 h 920403"/>
                  <a:gd name="connsiteX2" fmla="*/ 73208 w 1247912"/>
                  <a:gd name="connsiteY2" fmla="*/ 707010 h 920403"/>
                  <a:gd name="connsiteX3" fmla="*/ 829564 w 1247912"/>
                  <a:gd name="connsiteY3" fmla="*/ 910210 h 920403"/>
                  <a:gd name="connsiteX4" fmla="*/ 1202097 w 1247912"/>
                  <a:gd name="connsiteY4" fmla="*/ 831188 h 920403"/>
                  <a:gd name="connsiteX5" fmla="*/ 1179519 w 1247912"/>
                  <a:gd name="connsiteY5" fmla="*/ 334477 h 920403"/>
                  <a:gd name="connsiteX6" fmla="*/ 639311 w 1247912"/>
                  <a:gd name="connsiteY6" fmla="*/ 119153 h 920403"/>
                  <a:gd name="connsiteX0" fmla="*/ 459650 w 1247912"/>
                  <a:gd name="connsiteY0" fmla="*/ 1488 h 920403"/>
                  <a:gd name="connsiteX1" fmla="*/ 73208 w 1247912"/>
                  <a:gd name="connsiteY1" fmla="*/ 232877 h 920403"/>
                  <a:gd name="connsiteX2" fmla="*/ 73208 w 1247912"/>
                  <a:gd name="connsiteY2" fmla="*/ 707010 h 920403"/>
                  <a:gd name="connsiteX3" fmla="*/ 829564 w 1247912"/>
                  <a:gd name="connsiteY3" fmla="*/ 910210 h 920403"/>
                  <a:gd name="connsiteX4" fmla="*/ 1202097 w 1247912"/>
                  <a:gd name="connsiteY4" fmla="*/ 831188 h 920403"/>
                  <a:gd name="connsiteX5" fmla="*/ 1179519 w 1247912"/>
                  <a:gd name="connsiteY5" fmla="*/ 334477 h 920403"/>
                  <a:gd name="connsiteX6" fmla="*/ 639311 w 1247912"/>
                  <a:gd name="connsiteY6" fmla="*/ 74389 h 920403"/>
                  <a:gd name="connsiteX0" fmla="*/ 148590 w 1234181"/>
                  <a:gd name="connsiteY0" fmla="*/ 762 h 1085943"/>
                  <a:gd name="connsiteX1" fmla="*/ 59477 w 1234181"/>
                  <a:gd name="connsiteY1" fmla="*/ 398417 h 1085943"/>
                  <a:gd name="connsiteX2" fmla="*/ 59477 w 1234181"/>
                  <a:gd name="connsiteY2" fmla="*/ 872550 h 1085943"/>
                  <a:gd name="connsiteX3" fmla="*/ 815833 w 1234181"/>
                  <a:gd name="connsiteY3" fmla="*/ 1075750 h 1085943"/>
                  <a:gd name="connsiteX4" fmla="*/ 1188366 w 1234181"/>
                  <a:gd name="connsiteY4" fmla="*/ 996728 h 1085943"/>
                  <a:gd name="connsiteX5" fmla="*/ 1165788 w 1234181"/>
                  <a:gd name="connsiteY5" fmla="*/ 500017 h 1085943"/>
                  <a:gd name="connsiteX6" fmla="*/ 625580 w 1234181"/>
                  <a:gd name="connsiteY6" fmla="*/ 239929 h 1085943"/>
                  <a:gd name="connsiteX0" fmla="*/ 148588 w 1226891"/>
                  <a:gd name="connsiteY0" fmla="*/ 8665 h 1093846"/>
                  <a:gd name="connsiteX1" fmla="*/ 59475 w 1226891"/>
                  <a:gd name="connsiteY1" fmla="*/ 406320 h 1093846"/>
                  <a:gd name="connsiteX2" fmla="*/ 59475 w 1226891"/>
                  <a:gd name="connsiteY2" fmla="*/ 880453 h 1093846"/>
                  <a:gd name="connsiteX3" fmla="*/ 815831 w 1226891"/>
                  <a:gd name="connsiteY3" fmla="*/ 1083653 h 1093846"/>
                  <a:gd name="connsiteX4" fmla="*/ 1188364 w 1226891"/>
                  <a:gd name="connsiteY4" fmla="*/ 1004631 h 1093846"/>
                  <a:gd name="connsiteX5" fmla="*/ 1165786 w 1226891"/>
                  <a:gd name="connsiteY5" fmla="*/ 507920 h 1093846"/>
                  <a:gd name="connsiteX6" fmla="*/ 752101 w 1226891"/>
                  <a:gd name="connsiteY6" fmla="*/ 24012 h 1093846"/>
                  <a:gd name="connsiteX0" fmla="*/ 113876 w 1192177"/>
                  <a:gd name="connsiteY0" fmla="*/ 8665 h 1099563"/>
                  <a:gd name="connsiteX1" fmla="*/ 24763 w 1192177"/>
                  <a:gd name="connsiteY1" fmla="*/ 406320 h 1099563"/>
                  <a:gd name="connsiteX2" fmla="*/ 75114 w 1192177"/>
                  <a:gd name="connsiteY2" fmla="*/ 802789 h 1099563"/>
                  <a:gd name="connsiteX3" fmla="*/ 781119 w 1192177"/>
                  <a:gd name="connsiteY3" fmla="*/ 1083653 h 1099563"/>
                  <a:gd name="connsiteX4" fmla="*/ 1153652 w 1192177"/>
                  <a:gd name="connsiteY4" fmla="*/ 1004631 h 1099563"/>
                  <a:gd name="connsiteX5" fmla="*/ 1131074 w 1192177"/>
                  <a:gd name="connsiteY5" fmla="*/ 507920 h 1099563"/>
                  <a:gd name="connsiteX6" fmla="*/ 717389 w 1192177"/>
                  <a:gd name="connsiteY6" fmla="*/ 24012 h 1099563"/>
                  <a:gd name="connsiteX0" fmla="*/ 113874 w 1192177"/>
                  <a:gd name="connsiteY0" fmla="*/ 6763 h 1082787"/>
                  <a:gd name="connsiteX1" fmla="*/ 24761 w 1192177"/>
                  <a:gd name="connsiteY1" fmla="*/ 404418 h 1082787"/>
                  <a:gd name="connsiteX2" fmla="*/ 75112 w 1192177"/>
                  <a:gd name="connsiteY2" fmla="*/ 800887 h 1082787"/>
                  <a:gd name="connsiteX3" fmla="*/ 781117 w 1192177"/>
                  <a:gd name="connsiteY3" fmla="*/ 1081751 h 1082787"/>
                  <a:gd name="connsiteX4" fmla="*/ 1153650 w 1192177"/>
                  <a:gd name="connsiteY4" fmla="*/ 701779 h 1082787"/>
                  <a:gd name="connsiteX5" fmla="*/ 1131072 w 1192177"/>
                  <a:gd name="connsiteY5" fmla="*/ 506018 h 1082787"/>
                  <a:gd name="connsiteX6" fmla="*/ 717387 w 1192177"/>
                  <a:gd name="connsiteY6" fmla="*/ 22110 h 1082787"/>
                  <a:gd name="connsiteX0" fmla="*/ 113874 w 1192175"/>
                  <a:gd name="connsiteY0" fmla="*/ 6763 h 986418"/>
                  <a:gd name="connsiteX1" fmla="*/ 24761 w 1192175"/>
                  <a:gd name="connsiteY1" fmla="*/ 404418 h 986418"/>
                  <a:gd name="connsiteX2" fmla="*/ 75112 w 1192175"/>
                  <a:gd name="connsiteY2" fmla="*/ 800887 h 986418"/>
                  <a:gd name="connsiteX3" fmla="*/ 781116 w 1192175"/>
                  <a:gd name="connsiteY3" fmla="*/ 984670 h 986418"/>
                  <a:gd name="connsiteX4" fmla="*/ 1153650 w 1192175"/>
                  <a:gd name="connsiteY4" fmla="*/ 701779 h 986418"/>
                  <a:gd name="connsiteX5" fmla="*/ 1131072 w 1192175"/>
                  <a:gd name="connsiteY5" fmla="*/ 506018 h 986418"/>
                  <a:gd name="connsiteX6" fmla="*/ 717387 w 1192175"/>
                  <a:gd name="connsiteY6" fmla="*/ 22110 h 9864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192175" h="986418">
                    <a:moveTo>
                      <a:pt x="113874" y="6763"/>
                    </a:moveTo>
                    <a:cubicBezTo>
                      <a:pt x="-70511" y="-10170"/>
                      <a:pt x="31221" y="272064"/>
                      <a:pt x="24761" y="404418"/>
                    </a:cubicBezTo>
                    <a:cubicBezTo>
                      <a:pt x="18301" y="536772"/>
                      <a:pt x="-50947" y="704178"/>
                      <a:pt x="75112" y="800887"/>
                    </a:cubicBezTo>
                    <a:cubicBezTo>
                      <a:pt x="201171" y="897596"/>
                      <a:pt x="601360" y="1001188"/>
                      <a:pt x="781116" y="984670"/>
                    </a:cubicBezTo>
                    <a:cubicBezTo>
                      <a:pt x="960872" y="968152"/>
                      <a:pt x="1095324" y="797734"/>
                      <a:pt x="1153650" y="701779"/>
                    </a:cubicBezTo>
                    <a:cubicBezTo>
                      <a:pt x="1211976" y="605824"/>
                      <a:pt x="1203782" y="619296"/>
                      <a:pt x="1131072" y="506018"/>
                    </a:cubicBezTo>
                    <a:cubicBezTo>
                      <a:pt x="1058362" y="392740"/>
                      <a:pt x="753741" y="-110596"/>
                      <a:pt x="717387" y="22110"/>
                    </a:cubicBezTo>
                  </a:path>
                </a:pathLst>
              </a:custGeom>
              <a:solidFill>
                <a:schemeClr val="bg1">
                  <a:lumMod val="75000"/>
                  <a:alpha val="52000"/>
                </a:schemeClr>
              </a:solidFill>
              <a:ln w="9525">
                <a:solidFill>
                  <a:srgbClr val="548235">
                    <a:alpha val="52941"/>
                  </a:srgb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387" name="Image 38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2151359">
              <a:off x="5407082" y="1461073"/>
              <a:ext cx="91742" cy="119901"/>
            </a:xfrm>
            <a:prstGeom prst="rect">
              <a:avLst/>
            </a:prstGeom>
          </p:spPr>
        </p:pic>
        <p:pic>
          <p:nvPicPr>
            <p:cNvPr id="388" name="Image 38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318513" y="1497604"/>
              <a:ext cx="91742" cy="119901"/>
            </a:xfrm>
            <a:prstGeom prst="rect">
              <a:avLst/>
            </a:prstGeom>
          </p:spPr>
        </p:pic>
        <p:pic>
          <p:nvPicPr>
            <p:cNvPr id="389" name="Image 38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5130222">
              <a:off x="5394900" y="1854743"/>
              <a:ext cx="91742" cy="119901"/>
            </a:xfrm>
            <a:prstGeom prst="rect">
              <a:avLst/>
            </a:prstGeom>
          </p:spPr>
        </p:pic>
        <p:pic>
          <p:nvPicPr>
            <p:cNvPr id="390" name="Image 38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7210582">
              <a:off x="5543627" y="1632752"/>
              <a:ext cx="91742" cy="119901"/>
            </a:xfrm>
            <a:prstGeom prst="rect">
              <a:avLst/>
            </a:prstGeom>
          </p:spPr>
        </p:pic>
        <p:pic>
          <p:nvPicPr>
            <p:cNvPr id="391" name="Image 39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2997101">
              <a:off x="5474423" y="1884465"/>
              <a:ext cx="91742" cy="119901"/>
            </a:xfrm>
            <a:prstGeom prst="rect">
              <a:avLst/>
            </a:prstGeom>
          </p:spPr>
        </p:pic>
        <p:pic>
          <p:nvPicPr>
            <p:cNvPr id="392" name="Image 39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0800000">
              <a:off x="5531869" y="1817562"/>
              <a:ext cx="91742" cy="119901"/>
            </a:xfrm>
            <a:prstGeom prst="rect">
              <a:avLst/>
            </a:prstGeom>
          </p:spPr>
        </p:pic>
      </p:grpSp>
      <p:sp>
        <p:nvSpPr>
          <p:cNvPr id="395" name="Rectangle 394"/>
          <p:cNvSpPr/>
          <p:nvPr/>
        </p:nvSpPr>
        <p:spPr>
          <a:xfrm>
            <a:off x="5619842" y="1790158"/>
            <a:ext cx="808909" cy="438582"/>
          </a:xfrm>
          <a:prstGeom prst="rect">
            <a:avLst/>
          </a:prstGeom>
          <a:solidFill>
            <a:srgbClr val="C00000"/>
          </a:solidFill>
        </p:spPr>
        <p:style>
          <a:lnRef idx="3">
            <a:schemeClr val="lt1"/>
          </a:lnRef>
          <a:fillRef idx="1">
            <a:schemeClr val="accent4"/>
          </a:fillRef>
          <a:effectRef idx="1">
            <a:schemeClr val="accent4"/>
          </a:effectRef>
          <a:fontRef idx="minor">
            <a:schemeClr val="lt1"/>
          </a:fontRef>
        </p:style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fr-FR" sz="700" b="1" dirty="0" smtClean="0"/>
              <a:t>PRESERVATION OF AMASTIGOTE VIRULENCE</a:t>
            </a:r>
          </a:p>
        </p:txBody>
      </p:sp>
      <p:sp>
        <p:nvSpPr>
          <p:cNvPr id="396" name="ZoneTexte 395"/>
          <p:cNvSpPr txBox="1"/>
          <p:nvPr/>
        </p:nvSpPr>
        <p:spPr>
          <a:xfrm>
            <a:off x="2116038" y="1887863"/>
            <a:ext cx="27991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solidFill>
                  <a:schemeClr val="bg1">
                    <a:lumMod val="50000"/>
                  </a:schemeClr>
                </a:solidFill>
              </a:rPr>
              <a:t>Stage 1                               Stage 2                                Stage 3</a:t>
            </a:r>
            <a:endParaRPr lang="fr-FR" sz="900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397" name="Accolade fermante 396"/>
          <p:cNvSpPr/>
          <p:nvPr/>
        </p:nvSpPr>
        <p:spPr>
          <a:xfrm>
            <a:off x="5499519" y="1265720"/>
            <a:ext cx="45719" cy="1489665"/>
          </a:xfrm>
          <a:prstGeom prst="rightBrace">
            <a:avLst/>
          </a:prstGeom>
          <a:ln w="9525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98" name="ZoneTexte 397"/>
          <p:cNvSpPr txBox="1"/>
          <p:nvPr/>
        </p:nvSpPr>
        <p:spPr>
          <a:xfrm>
            <a:off x="543131" y="1901872"/>
            <a:ext cx="394659" cy="2333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100"/>
              </a:lnSpc>
            </a:pPr>
            <a:r>
              <a:rPr lang="fr-FR" sz="1000" b="1" dirty="0" smtClean="0"/>
              <a:t>ATP</a:t>
            </a:r>
          </a:p>
        </p:txBody>
      </p:sp>
      <p:grpSp>
        <p:nvGrpSpPr>
          <p:cNvPr id="399" name="Groupe 398"/>
          <p:cNvGrpSpPr/>
          <p:nvPr/>
        </p:nvGrpSpPr>
        <p:grpSpPr>
          <a:xfrm>
            <a:off x="846676" y="1740114"/>
            <a:ext cx="743595" cy="640624"/>
            <a:chOff x="519163" y="1491873"/>
            <a:chExt cx="1000234" cy="752438"/>
          </a:xfrm>
        </p:grpSpPr>
        <p:cxnSp>
          <p:nvCxnSpPr>
            <p:cNvPr id="400" name="Connecteur droit avec flèche 399"/>
            <p:cNvCxnSpPr/>
            <p:nvPr/>
          </p:nvCxnSpPr>
          <p:spPr>
            <a:xfrm>
              <a:off x="519163" y="1822971"/>
              <a:ext cx="288000" cy="62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01" name="Groupe 400"/>
            <p:cNvGrpSpPr/>
            <p:nvPr/>
          </p:nvGrpSpPr>
          <p:grpSpPr>
            <a:xfrm rot="4140921">
              <a:off x="774648" y="1499562"/>
              <a:ext cx="752438" cy="737060"/>
              <a:chOff x="304339" y="1159239"/>
              <a:chExt cx="1291883" cy="1442530"/>
            </a:xfrm>
          </p:grpSpPr>
          <p:sp>
            <p:nvSpPr>
              <p:cNvPr id="408" name="Forme libre 407"/>
              <p:cNvSpPr/>
              <p:nvPr/>
            </p:nvSpPr>
            <p:spPr>
              <a:xfrm>
                <a:off x="304339" y="1159239"/>
                <a:ext cx="1291883" cy="1442530"/>
              </a:xfrm>
              <a:custGeom>
                <a:avLst/>
                <a:gdLst>
                  <a:gd name="connsiteX0" fmla="*/ 1245464 w 1694550"/>
                  <a:gd name="connsiteY0" fmla="*/ 229341 h 1996683"/>
                  <a:gd name="connsiteX1" fmla="*/ 737464 w 1694550"/>
                  <a:gd name="connsiteY1" fmla="*/ 3563 h 1996683"/>
                  <a:gd name="connsiteX2" fmla="*/ 410086 w 1694550"/>
                  <a:gd name="connsiteY2" fmla="*/ 116452 h 1996683"/>
                  <a:gd name="connsiteX3" fmla="*/ 342353 w 1694550"/>
                  <a:gd name="connsiteY3" fmla="*/ 443830 h 1996683"/>
                  <a:gd name="connsiteX4" fmla="*/ 14975 w 1694550"/>
                  <a:gd name="connsiteY4" fmla="*/ 726052 h 1996683"/>
                  <a:gd name="connsiteX5" fmla="*/ 161730 w 1694550"/>
                  <a:gd name="connsiteY5" fmla="*/ 1301786 h 1996683"/>
                  <a:gd name="connsiteX6" fmla="*/ 14975 w 1694550"/>
                  <a:gd name="connsiteY6" fmla="*/ 1640452 h 1996683"/>
                  <a:gd name="connsiteX7" fmla="*/ 601997 w 1694550"/>
                  <a:gd name="connsiteY7" fmla="*/ 1617875 h 1996683"/>
                  <a:gd name="connsiteX8" fmla="*/ 624575 w 1694550"/>
                  <a:gd name="connsiteY8" fmla="*/ 1922675 h 1996683"/>
                  <a:gd name="connsiteX9" fmla="*/ 997108 w 1694550"/>
                  <a:gd name="connsiteY9" fmla="*/ 1967830 h 1996683"/>
                  <a:gd name="connsiteX10" fmla="*/ 1200308 w 1694550"/>
                  <a:gd name="connsiteY10" fmla="*/ 1550141 h 1996683"/>
                  <a:gd name="connsiteX11" fmla="*/ 1335775 w 1694550"/>
                  <a:gd name="connsiteY11" fmla="*/ 1369519 h 1996683"/>
                  <a:gd name="connsiteX12" fmla="*/ 1685730 w 1694550"/>
                  <a:gd name="connsiteY12" fmla="*/ 1132452 h 1996683"/>
                  <a:gd name="connsiteX13" fmla="*/ 1595419 w 1694550"/>
                  <a:gd name="connsiteY13" fmla="*/ 771208 h 1996683"/>
                  <a:gd name="connsiteX14" fmla="*/ 1663153 w 1694550"/>
                  <a:gd name="connsiteY14" fmla="*/ 398675 h 1996683"/>
                  <a:gd name="connsiteX15" fmla="*/ 1245464 w 1694550"/>
                  <a:gd name="connsiteY15" fmla="*/ 229341 h 19966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1694550" h="1996683">
                    <a:moveTo>
                      <a:pt x="1245464" y="229341"/>
                    </a:moveTo>
                    <a:cubicBezTo>
                      <a:pt x="1091183" y="163489"/>
                      <a:pt x="876694" y="22378"/>
                      <a:pt x="737464" y="3563"/>
                    </a:cubicBezTo>
                    <a:cubicBezTo>
                      <a:pt x="598234" y="-15252"/>
                      <a:pt x="475938" y="43074"/>
                      <a:pt x="410086" y="116452"/>
                    </a:cubicBezTo>
                    <a:cubicBezTo>
                      <a:pt x="344234" y="189830"/>
                      <a:pt x="408205" y="342230"/>
                      <a:pt x="342353" y="443830"/>
                    </a:cubicBezTo>
                    <a:cubicBezTo>
                      <a:pt x="276501" y="545430"/>
                      <a:pt x="45079" y="583059"/>
                      <a:pt x="14975" y="726052"/>
                    </a:cubicBezTo>
                    <a:cubicBezTo>
                      <a:pt x="-15129" y="869045"/>
                      <a:pt x="161730" y="1149386"/>
                      <a:pt x="161730" y="1301786"/>
                    </a:cubicBezTo>
                    <a:cubicBezTo>
                      <a:pt x="161730" y="1454186"/>
                      <a:pt x="-58403" y="1587770"/>
                      <a:pt x="14975" y="1640452"/>
                    </a:cubicBezTo>
                    <a:cubicBezTo>
                      <a:pt x="88353" y="1693134"/>
                      <a:pt x="500397" y="1570838"/>
                      <a:pt x="601997" y="1617875"/>
                    </a:cubicBezTo>
                    <a:cubicBezTo>
                      <a:pt x="703597" y="1664912"/>
                      <a:pt x="558723" y="1864349"/>
                      <a:pt x="624575" y="1922675"/>
                    </a:cubicBezTo>
                    <a:cubicBezTo>
                      <a:pt x="690427" y="1981001"/>
                      <a:pt x="901153" y="2029919"/>
                      <a:pt x="997108" y="1967830"/>
                    </a:cubicBezTo>
                    <a:cubicBezTo>
                      <a:pt x="1093063" y="1905741"/>
                      <a:pt x="1143864" y="1649859"/>
                      <a:pt x="1200308" y="1550141"/>
                    </a:cubicBezTo>
                    <a:cubicBezTo>
                      <a:pt x="1256752" y="1450423"/>
                      <a:pt x="1254871" y="1439134"/>
                      <a:pt x="1335775" y="1369519"/>
                    </a:cubicBezTo>
                    <a:cubicBezTo>
                      <a:pt x="1416679" y="1299904"/>
                      <a:pt x="1642456" y="1232170"/>
                      <a:pt x="1685730" y="1132452"/>
                    </a:cubicBezTo>
                    <a:cubicBezTo>
                      <a:pt x="1729004" y="1032734"/>
                      <a:pt x="1599182" y="893504"/>
                      <a:pt x="1595419" y="771208"/>
                    </a:cubicBezTo>
                    <a:cubicBezTo>
                      <a:pt x="1591656" y="648912"/>
                      <a:pt x="1715834" y="485223"/>
                      <a:pt x="1663153" y="398675"/>
                    </a:cubicBezTo>
                    <a:cubicBezTo>
                      <a:pt x="1610472" y="312127"/>
                      <a:pt x="1399745" y="295193"/>
                      <a:pt x="1245464" y="229341"/>
                    </a:cubicBez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6350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09" name="Forme libre 408"/>
              <p:cNvSpPr/>
              <p:nvPr/>
            </p:nvSpPr>
            <p:spPr>
              <a:xfrm>
                <a:off x="643434" y="1366517"/>
                <a:ext cx="775185" cy="752863"/>
              </a:xfrm>
              <a:custGeom>
                <a:avLst/>
                <a:gdLst>
                  <a:gd name="connsiteX0" fmla="*/ 599693 w 1256584"/>
                  <a:gd name="connsiteY0" fmla="*/ 3208 h 826201"/>
                  <a:gd name="connsiteX1" fmla="*/ 80404 w 1256584"/>
                  <a:gd name="connsiteY1" fmla="*/ 138675 h 826201"/>
                  <a:gd name="connsiteX2" fmla="*/ 80404 w 1256584"/>
                  <a:gd name="connsiteY2" fmla="*/ 612808 h 826201"/>
                  <a:gd name="connsiteX3" fmla="*/ 836760 w 1256584"/>
                  <a:gd name="connsiteY3" fmla="*/ 816008 h 826201"/>
                  <a:gd name="connsiteX4" fmla="*/ 1209293 w 1256584"/>
                  <a:gd name="connsiteY4" fmla="*/ 736986 h 826201"/>
                  <a:gd name="connsiteX5" fmla="*/ 1186715 w 1256584"/>
                  <a:gd name="connsiteY5" fmla="*/ 240275 h 826201"/>
                  <a:gd name="connsiteX6" fmla="*/ 599693 w 1256584"/>
                  <a:gd name="connsiteY6" fmla="*/ 3208 h 826201"/>
                  <a:gd name="connsiteX0" fmla="*/ 595273 w 1252164"/>
                  <a:gd name="connsiteY0" fmla="*/ 3208 h 1001020"/>
                  <a:gd name="connsiteX1" fmla="*/ 75984 w 1252164"/>
                  <a:gd name="connsiteY1" fmla="*/ 138675 h 1001020"/>
                  <a:gd name="connsiteX2" fmla="*/ 75984 w 1252164"/>
                  <a:gd name="connsiteY2" fmla="*/ 612808 h 1001020"/>
                  <a:gd name="connsiteX3" fmla="*/ 766437 w 1252164"/>
                  <a:gd name="connsiteY3" fmla="*/ 999436 h 1001020"/>
                  <a:gd name="connsiteX4" fmla="*/ 1204873 w 1252164"/>
                  <a:gd name="connsiteY4" fmla="*/ 736986 h 1001020"/>
                  <a:gd name="connsiteX5" fmla="*/ 1182295 w 1252164"/>
                  <a:gd name="connsiteY5" fmla="*/ 240275 h 1001020"/>
                  <a:gd name="connsiteX6" fmla="*/ 595273 w 1252164"/>
                  <a:gd name="connsiteY6" fmla="*/ 3208 h 1001020"/>
                  <a:gd name="connsiteX0" fmla="*/ 576932 w 1233823"/>
                  <a:gd name="connsiteY0" fmla="*/ 6014 h 1007843"/>
                  <a:gd name="connsiteX1" fmla="*/ 57643 w 1233823"/>
                  <a:gd name="connsiteY1" fmla="*/ 141481 h 1007843"/>
                  <a:gd name="connsiteX2" fmla="*/ 90437 w 1233823"/>
                  <a:gd name="connsiteY2" fmla="*/ 853481 h 1007843"/>
                  <a:gd name="connsiteX3" fmla="*/ 748096 w 1233823"/>
                  <a:gd name="connsiteY3" fmla="*/ 1002242 h 1007843"/>
                  <a:gd name="connsiteX4" fmla="*/ 1186532 w 1233823"/>
                  <a:gd name="connsiteY4" fmla="*/ 739792 h 1007843"/>
                  <a:gd name="connsiteX5" fmla="*/ 1163954 w 1233823"/>
                  <a:gd name="connsiteY5" fmla="*/ 243081 h 1007843"/>
                  <a:gd name="connsiteX6" fmla="*/ 576932 w 1233823"/>
                  <a:gd name="connsiteY6" fmla="*/ 6014 h 1007843"/>
                  <a:gd name="connsiteX0" fmla="*/ 577640 w 1234531"/>
                  <a:gd name="connsiteY0" fmla="*/ 6014 h 1080027"/>
                  <a:gd name="connsiteX1" fmla="*/ 58351 w 1234531"/>
                  <a:gd name="connsiteY1" fmla="*/ 141481 h 1080027"/>
                  <a:gd name="connsiteX2" fmla="*/ 91145 w 1234531"/>
                  <a:gd name="connsiteY2" fmla="*/ 853481 h 1080027"/>
                  <a:gd name="connsiteX3" fmla="*/ 761200 w 1234531"/>
                  <a:gd name="connsiteY3" fmla="*/ 1077457 h 1080027"/>
                  <a:gd name="connsiteX4" fmla="*/ 1187240 w 1234531"/>
                  <a:gd name="connsiteY4" fmla="*/ 739792 h 1080027"/>
                  <a:gd name="connsiteX5" fmla="*/ 1164662 w 1234531"/>
                  <a:gd name="connsiteY5" fmla="*/ 243081 h 1080027"/>
                  <a:gd name="connsiteX6" fmla="*/ 577640 w 1234531"/>
                  <a:gd name="connsiteY6" fmla="*/ 6014 h 10800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234531" h="1080027">
                    <a:moveTo>
                      <a:pt x="577640" y="6014"/>
                    </a:moveTo>
                    <a:cubicBezTo>
                      <a:pt x="393255" y="-10919"/>
                      <a:pt x="139433" y="237"/>
                      <a:pt x="58351" y="141481"/>
                    </a:cubicBezTo>
                    <a:cubicBezTo>
                      <a:pt x="-22731" y="282725"/>
                      <a:pt x="-25997" y="697485"/>
                      <a:pt x="91145" y="853481"/>
                    </a:cubicBezTo>
                    <a:cubicBezTo>
                      <a:pt x="208287" y="1009477"/>
                      <a:pt x="578518" y="1096405"/>
                      <a:pt x="761200" y="1077457"/>
                    </a:cubicBezTo>
                    <a:cubicBezTo>
                      <a:pt x="943883" y="1058509"/>
                      <a:pt x="1128914" y="835747"/>
                      <a:pt x="1187240" y="739792"/>
                    </a:cubicBezTo>
                    <a:cubicBezTo>
                      <a:pt x="1245566" y="643837"/>
                      <a:pt x="1262499" y="361614"/>
                      <a:pt x="1164662" y="243081"/>
                    </a:cubicBezTo>
                    <a:cubicBezTo>
                      <a:pt x="1066825" y="124548"/>
                      <a:pt x="762025" y="22947"/>
                      <a:pt x="577640" y="6014"/>
                    </a:cubicBezTo>
                    <a:close/>
                  </a:path>
                </a:pathLst>
              </a:custGeom>
              <a:solidFill>
                <a:srgbClr val="94BB61"/>
              </a:solidFill>
              <a:ln w="63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402" name="Image 40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34143" y="2000946"/>
              <a:ext cx="91742" cy="119901"/>
            </a:xfrm>
            <a:prstGeom prst="rect">
              <a:avLst/>
            </a:prstGeom>
          </p:spPr>
        </p:pic>
        <p:pic>
          <p:nvPicPr>
            <p:cNvPr id="403" name="Image 40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9697824">
              <a:off x="1315050" y="1945686"/>
              <a:ext cx="91742" cy="119901"/>
            </a:xfrm>
            <a:prstGeom prst="rect">
              <a:avLst/>
            </a:prstGeom>
          </p:spPr>
        </p:pic>
        <p:pic>
          <p:nvPicPr>
            <p:cNvPr id="404" name="Image 40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8862660">
              <a:off x="1325923" y="1872116"/>
              <a:ext cx="91742" cy="119901"/>
            </a:xfrm>
            <a:prstGeom prst="rect">
              <a:avLst/>
            </a:prstGeom>
          </p:spPr>
        </p:pic>
        <p:pic>
          <p:nvPicPr>
            <p:cNvPr id="405" name="Image 40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6413979">
              <a:off x="1293981" y="1723947"/>
              <a:ext cx="91742" cy="119901"/>
            </a:xfrm>
            <a:prstGeom prst="rect">
              <a:avLst/>
            </a:prstGeom>
          </p:spPr>
        </p:pic>
        <p:pic>
          <p:nvPicPr>
            <p:cNvPr id="406" name="Image 40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5130222">
              <a:off x="1244228" y="1632494"/>
              <a:ext cx="91742" cy="119901"/>
            </a:xfrm>
            <a:prstGeom prst="rect">
              <a:avLst/>
            </a:prstGeom>
          </p:spPr>
        </p:pic>
        <p:pic>
          <p:nvPicPr>
            <p:cNvPr id="407" name="Image 40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7210582">
              <a:off x="1052441" y="1838635"/>
              <a:ext cx="91742" cy="119901"/>
            </a:xfrm>
            <a:prstGeom prst="rect">
              <a:avLst/>
            </a:prstGeom>
          </p:spPr>
        </p:pic>
      </p:grpSp>
      <p:sp>
        <p:nvSpPr>
          <p:cNvPr id="410" name="Flèche droite 409"/>
          <p:cNvSpPr/>
          <p:nvPr/>
        </p:nvSpPr>
        <p:spPr>
          <a:xfrm>
            <a:off x="2603905" y="2421427"/>
            <a:ext cx="576000" cy="91894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11" name="Flèche droite 410"/>
          <p:cNvSpPr/>
          <p:nvPr/>
        </p:nvSpPr>
        <p:spPr>
          <a:xfrm>
            <a:off x="3853042" y="2420764"/>
            <a:ext cx="540000" cy="91894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412" name="Groupe 411"/>
          <p:cNvGrpSpPr/>
          <p:nvPr/>
        </p:nvGrpSpPr>
        <p:grpSpPr>
          <a:xfrm>
            <a:off x="4405660" y="2182612"/>
            <a:ext cx="597665" cy="523805"/>
            <a:chOff x="4811557" y="1427018"/>
            <a:chExt cx="837891" cy="681694"/>
          </a:xfrm>
        </p:grpSpPr>
        <p:grpSp>
          <p:nvGrpSpPr>
            <p:cNvPr id="413" name="Groupe 412"/>
            <p:cNvGrpSpPr/>
            <p:nvPr/>
          </p:nvGrpSpPr>
          <p:grpSpPr>
            <a:xfrm rot="4730976">
              <a:off x="4839669" y="1398906"/>
              <a:ext cx="681694" cy="737917"/>
              <a:chOff x="5174972" y="1182750"/>
              <a:chExt cx="1284023" cy="1444207"/>
            </a:xfrm>
          </p:grpSpPr>
          <p:sp>
            <p:nvSpPr>
              <p:cNvPr id="420" name="Forme libre 419"/>
              <p:cNvSpPr/>
              <p:nvPr/>
            </p:nvSpPr>
            <p:spPr>
              <a:xfrm>
                <a:off x="5174972" y="1551746"/>
                <a:ext cx="1284023" cy="1075211"/>
              </a:xfrm>
              <a:custGeom>
                <a:avLst/>
                <a:gdLst>
                  <a:gd name="connsiteX0" fmla="*/ 1245464 w 1694550"/>
                  <a:gd name="connsiteY0" fmla="*/ 229341 h 1996683"/>
                  <a:gd name="connsiteX1" fmla="*/ 737464 w 1694550"/>
                  <a:gd name="connsiteY1" fmla="*/ 3563 h 1996683"/>
                  <a:gd name="connsiteX2" fmla="*/ 410086 w 1694550"/>
                  <a:gd name="connsiteY2" fmla="*/ 116452 h 1996683"/>
                  <a:gd name="connsiteX3" fmla="*/ 342353 w 1694550"/>
                  <a:gd name="connsiteY3" fmla="*/ 443830 h 1996683"/>
                  <a:gd name="connsiteX4" fmla="*/ 14975 w 1694550"/>
                  <a:gd name="connsiteY4" fmla="*/ 726052 h 1996683"/>
                  <a:gd name="connsiteX5" fmla="*/ 161730 w 1694550"/>
                  <a:gd name="connsiteY5" fmla="*/ 1301786 h 1996683"/>
                  <a:gd name="connsiteX6" fmla="*/ 14975 w 1694550"/>
                  <a:gd name="connsiteY6" fmla="*/ 1640452 h 1996683"/>
                  <a:gd name="connsiteX7" fmla="*/ 601997 w 1694550"/>
                  <a:gd name="connsiteY7" fmla="*/ 1617875 h 1996683"/>
                  <a:gd name="connsiteX8" fmla="*/ 624575 w 1694550"/>
                  <a:gd name="connsiteY8" fmla="*/ 1922675 h 1996683"/>
                  <a:gd name="connsiteX9" fmla="*/ 997108 w 1694550"/>
                  <a:gd name="connsiteY9" fmla="*/ 1967830 h 1996683"/>
                  <a:gd name="connsiteX10" fmla="*/ 1200308 w 1694550"/>
                  <a:gd name="connsiteY10" fmla="*/ 1550141 h 1996683"/>
                  <a:gd name="connsiteX11" fmla="*/ 1335775 w 1694550"/>
                  <a:gd name="connsiteY11" fmla="*/ 1369519 h 1996683"/>
                  <a:gd name="connsiteX12" fmla="*/ 1685730 w 1694550"/>
                  <a:gd name="connsiteY12" fmla="*/ 1132452 h 1996683"/>
                  <a:gd name="connsiteX13" fmla="*/ 1595419 w 1694550"/>
                  <a:gd name="connsiteY13" fmla="*/ 771208 h 1996683"/>
                  <a:gd name="connsiteX14" fmla="*/ 1663153 w 1694550"/>
                  <a:gd name="connsiteY14" fmla="*/ 398675 h 1996683"/>
                  <a:gd name="connsiteX15" fmla="*/ 1245464 w 1694550"/>
                  <a:gd name="connsiteY15" fmla="*/ 229341 h 1996683"/>
                  <a:gd name="connsiteX0" fmla="*/ 1245464 w 1694550"/>
                  <a:gd name="connsiteY0" fmla="*/ 124321 h 1891663"/>
                  <a:gd name="connsiteX1" fmla="*/ 782620 w 1694550"/>
                  <a:gd name="connsiteY1" fmla="*/ 79165 h 1891663"/>
                  <a:gd name="connsiteX2" fmla="*/ 410086 w 1694550"/>
                  <a:gd name="connsiteY2" fmla="*/ 11432 h 1891663"/>
                  <a:gd name="connsiteX3" fmla="*/ 342353 w 1694550"/>
                  <a:gd name="connsiteY3" fmla="*/ 338810 h 1891663"/>
                  <a:gd name="connsiteX4" fmla="*/ 14975 w 1694550"/>
                  <a:gd name="connsiteY4" fmla="*/ 621032 h 1891663"/>
                  <a:gd name="connsiteX5" fmla="*/ 161730 w 1694550"/>
                  <a:gd name="connsiteY5" fmla="*/ 1196766 h 1891663"/>
                  <a:gd name="connsiteX6" fmla="*/ 14975 w 1694550"/>
                  <a:gd name="connsiteY6" fmla="*/ 1535432 h 1891663"/>
                  <a:gd name="connsiteX7" fmla="*/ 601997 w 1694550"/>
                  <a:gd name="connsiteY7" fmla="*/ 1512855 h 1891663"/>
                  <a:gd name="connsiteX8" fmla="*/ 624575 w 1694550"/>
                  <a:gd name="connsiteY8" fmla="*/ 1817655 h 1891663"/>
                  <a:gd name="connsiteX9" fmla="*/ 997108 w 1694550"/>
                  <a:gd name="connsiteY9" fmla="*/ 1862810 h 1891663"/>
                  <a:gd name="connsiteX10" fmla="*/ 1200308 w 1694550"/>
                  <a:gd name="connsiteY10" fmla="*/ 1445121 h 1891663"/>
                  <a:gd name="connsiteX11" fmla="*/ 1335775 w 1694550"/>
                  <a:gd name="connsiteY11" fmla="*/ 1264499 h 1891663"/>
                  <a:gd name="connsiteX12" fmla="*/ 1685730 w 1694550"/>
                  <a:gd name="connsiteY12" fmla="*/ 1027432 h 1891663"/>
                  <a:gd name="connsiteX13" fmla="*/ 1595419 w 1694550"/>
                  <a:gd name="connsiteY13" fmla="*/ 666188 h 1891663"/>
                  <a:gd name="connsiteX14" fmla="*/ 1663153 w 1694550"/>
                  <a:gd name="connsiteY14" fmla="*/ 293655 h 1891663"/>
                  <a:gd name="connsiteX15" fmla="*/ 1245464 w 1694550"/>
                  <a:gd name="connsiteY15" fmla="*/ 124321 h 1891663"/>
                  <a:gd name="connsiteX0" fmla="*/ 782620 w 1694550"/>
                  <a:gd name="connsiteY0" fmla="*/ 79165 h 1891663"/>
                  <a:gd name="connsiteX1" fmla="*/ 410086 w 1694550"/>
                  <a:gd name="connsiteY1" fmla="*/ 11432 h 1891663"/>
                  <a:gd name="connsiteX2" fmla="*/ 342353 w 1694550"/>
                  <a:gd name="connsiteY2" fmla="*/ 338810 h 1891663"/>
                  <a:gd name="connsiteX3" fmla="*/ 14975 w 1694550"/>
                  <a:gd name="connsiteY3" fmla="*/ 621032 h 1891663"/>
                  <a:gd name="connsiteX4" fmla="*/ 161730 w 1694550"/>
                  <a:gd name="connsiteY4" fmla="*/ 1196766 h 1891663"/>
                  <a:gd name="connsiteX5" fmla="*/ 14975 w 1694550"/>
                  <a:gd name="connsiteY5" fmla="*/ 1535432 h 1891663"/>
                  <a:gd name="connsiteX6" fmla="*/ 601997 w 1694550"/>
                  <a:gd name="connsiteY6" fmla="*/ 1512855 h 1891663"/>
                  <a:gd name="connsiteX7" fmla="*/ 624575 w 1694550"/>
                  <a:gd name="connsiteY7" fmla="*/ 1817655 h 1891663"/>
                  <a:gd name="connsiteX8" fmla="*/ 997108 w 1694550"/>
                  <a:gd name="connsiteY8" fmla="*/ 1862810 h 1891663"/>
                  <a:gd name="connsiteX9" fmla="*/ 1200308 w 1694550"/>
                  <a:gd name="connsiteY9" fmla="*/ 1445121 h 1891663"/>
                  <a:gd name="connsiteX10" fmla="*/ 1335775 w 1694550"/>
                  <a:gd name="connsiteY10" fmla="*/ 1264499 h 1891663"/>
                  <a:gd name="connsiteX11" fmla="*/ 1685730 w 1694550"/>
                  <a:gd name="connsiteY11" fmla="*/ 1027432 h 1891663"/>
                  <a:gd name="connsiteX12" fmla="*/ 1595419 w 1694550"/>
                  <a:gd name="connsiteY12" fmla="*/ 666188 h 1891663"/>
                  <a:gd name="connsiteX13" fmla="*/ 1663153 w 1694550"/>
                  <a:gd name="connsiteY13" fmla="*/ 293655 h 1891663"/>
                  <a:gd name="connsiteX14" fmla="*/ 1245464 w 1694550"/>
                  <a:gd name="connsiteY14" fmla="*/ 124321 h 1891663"/>
                  <a:gd name="connsiteX15" fmla="*/ 874060 w 1694550"/>
                  <a:gd name="connsiteY15" fmla="*/ 170605 h 1891663"/>
                  <a:gd name="connsiteX0" fmla="*/ 816486 w 1694550"/>
                  <a:gd name="connsiteY0" fmla="*/ 150556 h 1884032"/>
                  <a:gd name="connsiteX1" fmla="*/ 410086 w 1694550"/>
                  <a:gd name="connsiteY1" fmla="*/ 3801 h 1884032"/>
                  <a:gd name="connsiteX2" fmla="*/ 342353 w 1694550"/>
                  <a:gd name="connsiteY2" fmla="*/ 331179 h 1884032"/>
                  <a:gd name="connsiteX3" fmla="*/ 14975 w 1694550"/>
                  <a:gd name="connsiteY3" fmla="*/ 613401 h 1884032"/>
                  <a:gd name="connsiteX4" fmla="*/ 161730 w 1694550"/>
                  <a:gd name="connsiteY4" fmla="*/ 1189135 h 1884032"/>
                  <a:gd name="connsiteX5" fmla="*/ 14975 w 1694550"/>
                  <a:gd name="connsiteY5" fmla="*/ 1527801 h 1884032"/>
                  <a:gd name="connsiteX6" fmla="*/ 601997 w 1694550"/>
                  <a:gd name="connsiteY6" fmla="*/ 1505224 h 1884032"/>
                  <a:gd name="connsiteX7" fmla="*/ 624575 w 1694550"/>
                  <a:gd name="connsiteY7" fmla="*/ 1810024 h 1884032"/>
                  <a:gd name="connsiteX8" fmla="*/ 997108 w 1694550"/>
                  <a:gd name="connsiteY8" fmla="*/ 1855179 h 1884032"/>
                  <a:gd name="connsiteX9" fmla="*/ 1200308 w 1694550"/>
                  <a:gd name="connsiteY9" fmla="*/ 1437490 h 1884032"/>
                  <a:gd name="connsiteX10" fmla="*/ 1335775 w 1694550"/>
                  <a:gd name="connsiteY10" fmla="*/ 1256868 h 1884032"/>
                  <a:gd name="connsiteX11" fmla="*/ 1685730 w 1694550"/>
                  <a:gd name="connsiteY11" fmla="*/ 1019801 h 1884032"/>
                  <a:gd name="connsiteX12" fmla="*/ 1595419 w 1694550"/>
                  <a:gd name="connsiteY12" fmla="*/ 658557 h 1884032"/>
                  <a:gd name="connsiteX13" fmla="*/ 1663153 w 1694550"/>
                  <a:gd name="connsiteY13" fmla="*/ 286024 h 1884032"/>
                  <a:gd name="connsiteX14" fmla="*/ 1245464 w 1694550"/>
                  <a:gd name="connsiteY14" fmla="*/ 116690 h 1884032"/>
                  <a:gd name="connsiteX15" fmla="*/ 874060 w 1694550"/>
                  <a:gd name="connsiteY15" fmla="*/ 162974 h 1884032"/>
                  <a:gd name="connsiteX0" fmla="*/ 816486 w 1694550"/>
                  <a:gd name="connsiteY0" fmla="*/ 150556 h 1884032"/>
                  <a:gd name="connsiteX1" fmla="*/ 410086 w 1694550"/>
                  <a:gd name="connsiteY1" fmla="*/ 3801 h 1884032"/>
                  <a:gd name="connsiteX2" fmla="*/ 342353 w 1694550"/>
                  <a:gd name="connsiteY2" fmla="*/ 331179 h 1884032"/>
                  <a:gd name="connsiteX3" fmla="*/ 14975 w 1694550"/>
                  <a:gd name="connsiteY3" fmla="*/ 613401 h 1884032"/>
                  <a:gd name="connsiteX4" fmla="*/ 161730 w 1694550"/>
                  <a:gd name="connsiteY4" fmla="*/ 1189135 h 1884032"/>
                  <a:gd name="connsiteX5" fmla="*/ 14975 w 1694550"/>
                  <a:gd name="connsiteY5" fmla="*/ 1527801 h 1884032"/>
                  <a:gd name="connsiteX6" fmla="*/ 601997 w 1694550"/>
                  <a:gd name="connsiteY6" fmla="*/ 1505224 h 1884032"/>
                  <a:gd name="connsiteX7" fmla="*/ 624575 w 1694550"/>
                  <a:gd name="connsiteY7" fmla="*/ 1810024 h 1884032"/>
                  <a:gd name="connsiteX8" fmla="*/ 997108 w 1694550"/>
                  <a:gd name="connsiteY8" fmla="*/ 1855179 h 1884032"/>
                  <a:gd name="connsiteX9" fmla="*/ 1200308 w 1694550"/>
                  <a:gd name="connsiteY9" fmla="*/ 1437490 h 1884032"/>
                  <a:gd name="connsiteX10" fmla="*/ 1335775 w 1694550"/>
                  <a:gd name="connsiteY10" fmla="*/ 1256868 h 1884032"/>
                  <a:gd name="connsiteX11" fmla="*/ 1685730 w 1694550"/>
                  <a:gd name="connsiteY11" fmla="*/ 1019801 h 1884032"/>
                  <a:gd name="connsiteX12" fmla="*/ 1595419 w 1694550"/>
                  <a:gd name="connsiteY12" fmla="*/ 658557 h 1884032"/>
                  <a:gd name="connsiteX13" fmla="*/ 1663153 w 1694550"/>
                  <a:gd name="connsiteY13" fmla="*/ 286024 h 1884032"/>
                  <a:gd name="connsiteX14" fmla="*/ 1245464 w 1694550"/>
                  <a:gd name="connsiteY14" fmla="*/ 116690 h 1884032"/>
                  <a:gd name="connsiteX15" fmla="*/ 964371 w 1694550"/>
                  <a:gd name="connsiteY15" fmla="*/ 309729 h 1884032"/>
                  <a:gd name="connsiteX0" fmla="*/ 748753 w 1694550"/>
                  <a:gd name="connsiteY0" fmla="*/ 282376 h 1880385"/>
                  <a:gd name="connsiteX1" fmla="*/ 410086 w 1694550"/>
                  <a:gd name="connsiteY1" fmla="*/ 154 h 1880385"/>
                  <a:gd name="connsiteX2" fmla="*/ 342353 w 1694550"/>
                  <a:gd name="connsiteY2" fmla="*/ 327532 h 1880385"/>
                  <a:gd name="connsiteX3" fmla="*/ 14975 w 1694550"/>
                  <a:gd name="connsiteY3" fmla="*/ 609754 h 1880385"/>
                  <a:gd name="connsiteX4" fmla="*/ 161730 w 1694550"/>
                  <a:gd name="connsiteY4" fmla="*/ 1185488 h 1880385"/>
                  <a:gd name="connsiteX5" fmla="*/ 14975 w 1694550"/>
                  <a:gd name="connsiteY5" fmla="*/ 1524154 h 1880385"/>
                  <a:gd name="connsiteX6" fmla="*/ 601997 w 1694550"/>
                  <a:gd name="connsiteY6" fmla="*/ 1501577 h 1880385"/>
                  <a:gd name="connsiteX7" fmla="*/ 624575 w 1694550"/>
                  <a:gd name="connsiteY7" fmla="*/ 1806377 h 1880385"/>
                  <a:gd name="connsiteX8" fmla="*/ 997108 w 1694550"/>
                  <a:gd name="connsiteY8" fmla="*/ 1851532 h 1880385"/>
                  <a:gd name="connsiteX9" fmla="*/ 1200308 w 1694550"/>
                  <a:gd name="connsiteY9" fmla="*/ 1433843 h 1880385"/>
                  <a:gd name="connsiteX10" fmla="*/ 1335775 w 1694550"/>
                  <a:gd name="connsiteY10" fmla="*/ 1253221 h 1880385"/>
                  <a:gd name="connsiteX11" fmla="*/ 1685730 w 1694550"/>
                  <a:gd name="connsiteY11" fmla="*/ 1016154 h 1880385"/>
                  <a:gd name="connsiteX12" fmla="*/ 1595419 w 1694550"/>
                  <a:gd name="connsiteY12" fmla="*/ 654910 h 1880385"/>
                  <a:gd name="connsiteX13" fmla="*/ 1663153 w 1694550"/>
                  <a:gd name="connsiteY13" fmla="*/ 282377 h 1880385"/>
                  <a:gd name="connsiteX14" fmla="*/ 1245464 w 1694550"/>
                  <a:gd name="connsiteY14" fmla="*/ 113043 h 1880385"/>
                  <a:gd name="connsiteX15" fmla="*/ 964371 w 1694550"/>
                  <a:gd name="connsiteY15" fmla="*/ 306082 h 1880385"/>
                  <a:gd name="connsiteX0" fmla="*/ 748753 w 1694550"/>
                  <a:gd name="connsiteY0" fmla="*/ 338679 h 1880243"/>
                  <a:gd name="connsiteX1" fmla="*/ 410086 w 1694550"/>
                  <a:gd name="connsiteY1" fmla="*/ 12 h 1880243"/>
                  <a:gd name="connsiteX2" fmla="*/ 342353 w 1694550"/>
                  <a:gd name="connsiteY2" fmla="*/ 327390 h 1880243"/>
                  <a:gd name="connsiteX3" fmla="*/ 14975 w 1694550"/>
                  <a:gd name="connsiteY3" fmla="*/ 609612 h 1880243"/>
                  <a:gd name="connsiteX4" fmla="*/ 161730 w 1694550"/>
                  <a:gd name="connsiteY4" fmla="*/ 1185346 h 1880243"/>
                  <a:gd name="connsiteX5" fmla="*/ 14975 w 1694550"/>
                  <a:gd name="connsiteY5" fmla="*/ 1524012 h 1880243"/>
                  <a:gd name="connsiteX6" fmla="*/ 601997 w 1694550"/>
                  <a:gd name="connsiteY6" fmla="*/ 1501435 h 1880243"/>
                  <a:gd name="connsiteX7" fmla="*/ 624575 w 1694550"/>
                  <a:gd name="connsiteY7" fmla="*/ 1806235 h 1880243"/>
                  <a:gd name="connsiteX8" fmla="*/ 997108 w 1694550"/>
                  <a:gd name="connsiteY8" fmla="*/ 1851390 h 1880243"/>
                  <a:gd name="connsiteX9" fmla="*/ 1200308 w 1694550"/>
                  <a:gd name="connsiteY9" fmla="*/ 1433701 h 1880243"/>
                  <a:gd name="connsiteX10" fmla="*/ 1335775 w 1694550"/>
                  <a:gd name="connsiteY10" fmla="*/ 1253079 h 1880243"/>
                  <a:gd name="connsiteX11" fmla="*/ 1685730 w 1694550"/>
                  <a:gd name="connsiteY11" fmla="*/ 1016012 h 1880243"/>
                  <a:gd name="connsiteX12" fmla="*/ 1595419 w 1694550"/>
                  <a:gd name="connsiteY12" fmla="*/ 654768 h 1880243"/>
                  <a:gd name="connsiteX13" fmla="*/ 1663153 w 1694550"/>
                  <a:gd name="connsiteY13" fmla="*/ 282235 h 1880243"/>
                  <a:gd name="connsiteX14" fmla="*/ 1245464 w 1694550"/>
                  <a:gd name="connsiteY14" fmla="*/ 112901 h 1880243"/>
                  <a:gd name="connsiteX15" fmla="*/ 964371 w 1694550"/>
                  <a:gd name="connsiteY15" fmla="*/ 305940 h 1880243"/>
                  <a:gd name="connsiteX0" fmla="*/ 748753 w 1694550"/>
                  <a:gd name="connsiteY0" fmla="*/ 225909 h 1767473"/>
                  <a:gd name="connsiteX1" fmla="*/ 493212 w 1694550"/>
                  <a:gd name="connsiteY1" fmla="*/ 150401 h 1767473"/>
                  <a:gd name="connsiteX2" fmla="*/ 342353 w 1694550"/>
                  <a:gd name="connsiteY2" fmla="*/ 214620 h 1767473"/>
                  <a:gd name="connsiteX3" fmla="*/ 14975 w 1694550"/>
                  <a:gd name="connsiteY3" fmla="*/ 496842 h 1767473"/>
                  <a:gd name="connsiteX4" fmla="*/ 161730 w 1694550"/>
                  <a:gd name="connsiteY4" fmla="*/ 1072576 h 1767473"/>
                  <a:gd name="connsiteX5" fmla="*/ 14975 w 1694550"/>
                  <a:gd name="connsiteY5" fmla="*/ 1411242 h 1767473"/>
                  <a:gd name="connsiteX6" fmla="*/ 601997 w 1694550"/>
                  <a:gd name="connsiteY6" fmla="*/ 1388665 h 1767473"/>
                  <a:gd name="connsiteX7" fmla="*/ 624575 w 1694550"/>
                  <a:gd name="connsiteY7" fmla="*/ 1693465 h 1767473"/>
                  <a:gd name="connsiteX8" fmla="*/ 997108 w 1694550"/>
                  <a:gd name="connsiteY8" fmla="*/ 1738620 h 1767473"/>
                  <a:gd name="connsiteX9" fmla="*/ 1200308 w 1694550"/>
                  <a:gd name="connsiteY9" fmla="*/ 1320931 h 1767473"/>
                  <a:gd name="connsiteX10" fmla="*/ 1335775 w 1694550"/>
                  <a:gd name="connsiteY10" fmla="*/ 1140309 h 1767473"/>
                  <a:gd name="connsiteX11" fmla="*/ 1685730 w 1694550"/>
                  <a:gd name="connsiteY11" fmla="*/ 903242 h 1767473"/>
                  <a:gd name="connsiteX12" fmla="*/ 1595419 w 1694550"/>
                  <a:gd name="connsiteY12" fmla="*/ 541998 h 1767473"/>
                  <a:gd name="connsiteX13" fmla="*/ 1663153 w 1694550"/>
                  <a:gd name="connsiteY13" fmla="*/ 169465 h 1767473"/>
                  <a:gd name="connsiteX14" fmla="*/ 1245464 w 1694550"/>
                  <a:gd name="connsiteY14" fmla="*/ 131 h 1767473"/>
                  <a:gd name="connsiteX15" fmla="*/ 964371 w 1694550"/>
                  <a:gd name="connsiteY15" fmla="*/ 193170 h 1767473"/>
                  <a:gd name="connsiteX0" fmla="*/ 738443 w 1684240"/>
                  <a:gd name="connsiteY0" fmla="*/ 225909 h 1767473"/>
                  <a:gd name="connsiteX1" fmla="*/ 482902 w 1684240"/>
                  <a:gd name="connsiteY1" fmla="*/ 150401 h 1767473"/>
                  <a:gd name="connsiteX2" fmla="*/ 332043 w 1684240"/>
                  <a:gd name="connsiteY2" fmla="*/ 214620 h 1767473"/>
                  <a:gd name="connsiteX3" fmla="*/ 4665 w 1684240"/>
                  <a:gd name="connsiteY3" fmla="*/ 496842 h 1767473"/>
                  <a:gd name="connsiteX4" fmla="*/ 151420 w 1684240"/>
                  <a:gd name="connsiteY4" fmla="*/ 1072576 h 1767473"/>
                  <a:gd name="connsiteX5" fmla="*/ 325300 w 1684240"/>
                  <a:gd name="connsiteY5" fmla="*/ 1248334 h 1767473"/>
                  <a:gd name="connsiteX6" fmla="*/ 591687 w 1684240"/>
                  <a:gd name="connsiteY6" fmla="*/ 1388665 h 1767473"/>
                  <a:gd name="connsiteX7" fmla="*/ 614265 w 1684240"/>
                  <a:gd name="connsiteY7" fmla="*/ 1693465 h 1767473"/>
                  <a:gd name="connsiteX8" fmla="*/ 986798 w 1684240"/>
                  <a:gd name="connsiteY8" fmla="*/ 1738620 h 1767473"/>
                  <a:gd name="connsiteX9" fmla="*/ 1189998 w 1684240"/>
                  <a:gd name="connsiteY9" fmla="*/ 1320931 h 1767473"/>
                  <a:gd name="connsiteX10" fmla="*/ 1325465 w 1684240"/>
                  <a:gd name="connsiteY10" fmla="*/ 1140309 h 1767473"/>
                  <a:gd name="connsiteX11" fmla="*/ 1675420 w 1684240"/>
                  <a:gd name="connsiteY11" fmla="*/ 903242 h 1767473"/>
                  <a:gd name="connsiteX12" fmla="*/ 1585109 w 1684240"/>
                  <a:gd name="connsiteY12" fmla="*/ 541998 h 1767473"/>
                  <a:gd name="connsiteX13" fmla="*/ 1652843 w 1684240"/>
                  <a:gd name="connsiteY13" fmla="*/ 169465 h 1767473"/>
                  <a:gd name="connsiteX14" fmla="*/ 1235154 w 1684240"/>
                  <a:gd name="connsiteY14" fmla="*/ 131 h 1767473"/>
                  <a:gd name="connsiteX15" fmla="*/ 954061 w 1684240"/>
                  <a:gd name="connsiteY15" fmla="*/ 193170 h 1767473"/>
                  <a:gd name="connsiteX0" fmla="*/ 738443 w 1684240"/>
                  <a:gd name="connsiteY0" fmla="*/ 225909 h 1746659"/>
                  <a:gd name="connsiteX1" fmla="*/ 482902 w 1684240"/>
                  <a:gd name="connsiteY1" fmla="*/ 150401 h 1746659"/>
                  <a:gd name="connsiteX2" fmla="*/ 332043 w 1684240"/>
                  <a:gd name="connsiteY2" fmla="*/ 214620 h 1746659"/>
                  <a:gd name="connsiteX3" fmla="*/ 4665 w 1684240"/>
                  <a:gd name="connsiteY3" fmla="*/ 496842 h 1746659"/>
                  <a:gd name="connsiteX4" fmla="*/ 151420 w 1684240"/>
                  <a:gd name="connsiteY4" fmla="*/ 1072576 h 1746659"/>
                  <a:gd name="connsiteX5" fmla="*/ 325300 w 1684240"/>
                  <a:gd name="connsiteY5" fmla="*/ 1248334 h 1746659"/>
                  <a:gd name="connsiteX6" fmla="*/ 591687 w 1684240"/>
                  <a:gd name="connsiteY6" fmla="*/ 1388665 h 1746659"/>
                  <a:gd name="connsiteX7" fmla="*/ 804269 w 1684240"/>
                  <a:gd name="connsiteY7" fmla="*/ 1580681 h 1746659"/>
                  <a:gd name="connsiteX8" fmla="*/ 986798 w 1684240"/>
                  <a:gd name="connsiteY8" fmla="*/ 1738620 h 1746659"/>
                  <a:gd name="connsiteX9" fmla="*/ 1189998 w 1684240"/>
                  <a:gd name="connsiteY9" fmla="*/ 1320931 h 1746659"/>
                  <a:gd name="connsiteX10" fmla="*/ 1325465 w 1684240"/>
                  <a:gd name="connsiteY10" fmla="*/ 1140309 h 1746659"/>
                  <a:gd name="connsiteX11" fmla="*/ 1675420 w 1684240"/>
                  <a:gd name="connsiteY11" fmla="*/ 903242 h 1746659"/>
                  <a:gd name="connsiteX12" fmla="*/ 1585109 w 1684240"/>
                  <a:gd name="connsiteY12" fmla="*/ 541998 h 1746659"/>
                  <a:gd name="connsiteX13" fmla="*/ 1652843 w 1684240"/>
                  <a:gd name="connsiteY13" fmla="*/ 169465 h 1746659"/>
                  <a:gd name="connsiteX14" fmla="*/ 1235154 w 1684240"/>
                  <a:gd name="connsiteY14" fmla="*/ 131 h 1746659"/>
                  <a:gd name="connsiteX15" fmla="*/ 954061 w 1684240"/>
                  <a:gd name="connsiteY15" fmla="*/ 193170 h 1746659"/>
                  <a:gd name="connsiteX0" fmla="*/ 738443 w 1684240"/>
                  <a:gd name="connsiteY0" fmla="*/ 225909 h 1590718"/>
                  <a:gd name="connsiteX1" fmla="*/ 482902 w 1684240"/>
                  <a:gd name="connsiteY1" fmla="*/ 150401 h 1590718"/>
                  <a:gd name="connsiteX2" fmla="*/ 332043 w 1684240"/>
                  <a:gd name="connsiteY2" fmla="*/ 214620 h 1590718"/>
                  <a:gd name="connsiteX3" fmla="*/ 4665 w 1684240"/>
                  <a:gd name="connsiteY3" fmla="*/ 496842 h 1590718"/>
                  <a:gd name="connsiteX4" fmla="*/ 151420 w 1684240"/>
                  <a:gd name="connsiteY4" fmla="*/ 1072576 h 1590718"/>
                  <a:gd name="connsiteX5" fmla="*/ 325300 w 1684240"/>
                  <a:gd name="connsiteY5" fmla="*/ 1248334 h 1590718"/>
                  <a:gd name="connsiteX6" fmla="*/ 591687 w 1684240"/>
                  <a:gd name="connsiteY6" fmla="*/ 1388665 h 1590718"/>
                  <a:gd name="connsiteX7" fmla="*/ 804269 w 1684240"/>
                  <a:gd name="connsiteY7" fmla="*/ 1580681 h 1590718"/>
                  <a:gd name="connsiteX8" fmla="*/ 927421 w 1684240"/>
                  <a:gd name="connsiteY8" fmla="*/ 1538118 h 1590718"/>
                  <a:gd name="connsiteX9" fmla="*/ 1189998 w 1684240"/>
                  <a:gd name="connsiteY9" fmla="*/ 1320931 h 1590718"/>
                  <a:gd name="connsiteX10" fmla="*/ 1325465 w 1684240"/>
                  <a:gd name="connsiteY10" fmla="*/ 1140309 h 1590718"/>
                  <a:gd name="connsiteX11" fmla="*/ 1675420 w 1684240"/>
                  <a:gd name="connsiteY11" fmla="*/ 903242 h 1590718"/>
                  <a:gd name="connsiteX12" fmla="*/ 1585109 w 1684240"/>
                  <a:gd name="connsiteY12" fmla="*/ 541998 h 1590718"/>
                  <a:gd name="connsiteX13" fmla="*/ 1652843 w 1684240"/>
                  <a:gd name="connsiteY13" fmla="*/ 169465 h 1590718"/>
                  <a:gd name="connsiteX14" fmla="*/ 1235154 w 1684240"/>
                  <a:gd name="connsiteY14" fmla="*/ 131 h 1590718"/>
                  <a:gd name="connsiteX15" fmla="*/ 954061 w 1684240"/>
                  <a:gd name="connsiteY15" fmla="*/ 193170 h 1590718"/>
                  <a:gd name="connsiteX0" fmla="*/ 774070 w 1684240"/>
                  <a:gd name="connsiteY0" fmla="*/ 113127 h 1590717"/>
                  <a:gd name="connsiteX1" fmla="*/ 482902 w 1684240"/>
                  <a:gd name="connsiteY1" fmla="*/ 150401 h 1590717"/>
                  <a:gd name="connsiteX2" fmla="*/ 332043 w 1684240"/>
                  <a:gd name="connsiteY2" fmla="*/ 214620 h 1590717"/>
                  <a:gd name="connsiteX3" fmla="*/ 4665 w 1684240"/>
                  <a:gd name="connsiteY3" fmla="*/ 496842 h 1590717"/>
                  <a:gd name="connsiteX4" fmla="*/ 151420 w 1684240"/>
                  <a:gd name="connsiteY4" fmla="*/ 1072576 h 1590717"/>
                  <a:gd name="connsiteX5" fmla="*/ 325300 w 1684240"/>
                  <a:gd name="connsiteY5" fmla="*/ 1248334 h 1590717"/>
                  <a:gd name="connsiteX6" fmla="*/ 591687 w 1684240"/>
                  <a:gd name="connsiteY6" fmla="*/ 1388665 h 1590717"/>
                  <a:gd name="connsiteX7" fmla="*/ 804269 w 1684240"/>
                  <a:gd name="connsiteY7" fmla="*/ 1580681 h 1590717"/>
                  <a:gd name="connsiteX8" fmla="*/ 927421 w 1684240"/>
                  <a:gd name="connsiteY8" fmla="*/ 1538118 h 1590717"/>
                  <a:gd name="connsiteX9" fmla="*/ 1189998 w 1684240"/>
                  <a:gd name="connsiteY9" fmla="*/ 1320931 h 1590717"/>
                  <a:gd name="connsiteX10" fmla="*/ 1325465 w 1684240"/>
                  <a:gd name="connsiteY10" fmla="*/ 1140309 h 1590717"/>
                  <a:gd name="connsiteX11" fmla="*/ 1675420 w 1684240"/>
                  <a:gd name="connsiteY11" fmla="*/ 903242 h 1590717"/>
                  <a:gd name="connsiteX12" fmla="*/ 1585109 w 1684240"/>
                  <a:gd name="connsiteY12" fmla="*/ 541998 h 1590717"/>
                  <a:gd name="connsiteX13" fmla="*/ 1652843 w 1684240"/>
                  <a:gd name="connsiteY13" fmla="*/ 169465 h 1590717"/>
                  <a:gd name="connsiteX14" fmla="*/ 1235154 w 1684240"/>
                  <a:gd name="connsiteY14" fmla="*/ 131 h 1590717"/>
                  <a:gd name="connsiteX15" fmla="*/ 954061 w 1684240"/>
                  <a:gd name="connsiteY15" fmla="*/ 193170 h 1590717"/>
                  <a:gd name="connsiteX0" fmla="*/ 528038 w 1684240"/>
                  <a:gd name="connsiteY0" fmla="*/ 1606 h 1614418"/>
                  <a:gd name="connsiteX1" fmla="*/ 482902 w 1684240"/>
                  <a:gd name="connsiteY1" fmla="*/ 174102 h 1614418"/>
                  <a:gd name="connsiteX2" fmla="*/ 332043 w 1684240"/>
                  <a:gd name="connsiteY2" fmla="*/ 238321 h 1614418"/>
                  <a:gd name="connsiteX3" fmla="*/ 4665 w 1684240"/>
                  <a:gd name="connsiteY3" fmla="*/ 520543 h 1614418"/>
                  <a:gd name="connsiteX4" fmla="*/ 151420 w 1684240"/>
                  <a:gd name="connsiteY4" fmla="*/ 1096277 h 1614418"/>
                  <a:gd name="connsiteX5" fmla="*/ 325300 w 1684240"/>
                  <a:gd name="connsiteY5" fmla="*/ 1272035 h 1614418"/>
                  <a:gd name="connsiteX6" fmla="*/ 591687 w 1684240"/>
                  <a:gd name="connsiteY6" fmla="*/ 1412366 h 1614418"/>
                  <a:gd name="connsiteX7" fmla="*/ 804269 w 1684240"/>
                  <a:gd name="connsiteY7" fmla="*/ 1604382 h 1614418"/>
                  <a:gd name="connsiteX8" fmla="*/ 927421 w 1684240"/>
                  <a:gd name="connsiteY8" fmla="*/ 1561819 h 1614418"/>
                  <a:gd name="connsiteX9" fmla="*/ 1189998 w 1684240"/>
                  <a:gd name="connsiteY9" fmla="*/ 1344632 h 1614418"/>
                  <a:gd name="connsiteX10" fmla="*/ 1325465 w 1684240"/>
                  <a:gd name="connsiteY10" fmla="*/ 1164010 h 1614418"/>
                  <a:gd name="connsiteX11" fmla="*/ 1675420 w 1684240"/>
                  <a:gd name="connsiteY11" fmla="*/ 926943 h 1614418"/>
                  <a:gd name="connsiteX12" fmla="*/ 1585109 w 1684240"/>
                  <a:gd name="connsiteY12" fmla="*/ 565699 h 1614418"/>
                  <a:gd name="connsiteX13" fmla="*/ 1652843 w 1684240"/>
                  <a:gd name="connsiteY13" fmla="*/ 193166 h 1614418"/>
                  <a:gd name="connsiteX14" fmla="*/ 1235154 w 1684240"/>
                  <a:gd name="connsiteY14" fmla="*/ 23832 h 1614418"/>
                  <a:gd name="connsiteX15" fmla="*/ 954061 w 1684240"/>
                  <a:gd name="connsiteY15" fmla="*/ 216871 h 1614418"/>
                  <a:gd name="connsiteX0" fmla="*/ 528038 w 1684240"/>
                  <a:gd name="connsiteY0" fmla="*/ 26249 h 1639061"/>
                  <a:gd name="connsiteX1" fmla="*/ 482902 w 1684240"/>
                  <a:gd name="connsiteY1" fmla="*/ 198745 h 1639061"/>
                  <a:gd name="connsiteX2" fmla="*/ 332043 w 1684240"/>
                  <a:gd name="connsiteY2" fmla="*/ 262964 h 1639061"/>
                  <a:gd name="connsiteX3" fmla="*/ 4665 w 1684240"/>
                  <a:gd name="connsiteY3" fmla="*/ 545186 h 1639061"/>
                  <a:gd name="connsiteX4" fmla="*/ 151420 w 1684240"/>
                  <a:gd name="connsiteY4" fmla="*/ 1120920 h 1639061"/>
                  <a:gd name="connsiteX5" fmla="*/ 325300 w 1684240"/>
                  <a:gd name="connsiteY5" fmla="*/ 1296678 h 1639061"/>
                  <a:gd name="connsiteX6" fmla="*/ 591687 w 1684240"/>
                  <a:gd name="connsiteY6" fmla="*/ 1437009 h 1639061"/>
                  <a:gd name="connsiteX7" fmla="*/ 804269 w 1684240"/>
                  <a:gd name="connsiteY7" fmla="*/ 1629025 h 1639061"/>
                  <a:gd name="connsiteX8" fmla="*/ 927421 w 1684240"/>
                  <a:gd name="connsiteY8" fmla="*/ 1586462 h 1639061"/>
                  <a:gd name="connsiteX9" fmla="*/ 1189998 w 1684240"/>
                  <a:gd name="connsiteY9" fmla="*/ 1369275 h 1639061"/>
                  <a:gd name="connsiteX10" fmla="*/ 1325465 w 1684240"/>
                  <a:gd name="connsiteY10" fmla="*/ 1188653 h 1639061"/>
                  <a:gd name="connsiteX11" fmla="*/ 1675420 w 1684240"/>
                  <a:gd name="connsiteY11" fmla="*/ 951586 h 1639061"/>
                  <a:gd name="connsiteX12" fmla="*/ 1585109 w 1684240"/>
                  <a:gd name="connsiteY12" fmla="*/ 590342 h 1639061"/>
                  <a:gd name="connsiteX13" fmla="*/ 1652843 w 1684240"/>
                  <a:gd name="connsiteY13" fmla="*/ 217809 h 1639061"/>
                  <a:gd name="connsiteX14" fmla="*/ 1235154 w 1684240"/>
                  <a:gd name="connsiteY14" fmla="*/ 48475 h 1639061"/>
                  <a:gd name="connsiteX15" fmla="*/ 1041198 w 1684240"/>
                  <a:gd name="connsiteY15" fmla="*/ 35978 h 1639061"/>
                  <a:gd name="connsiteX0" fmla="*/ 528038 w 1684240"/>
                  <a:gd name="connsiteY0" fmla="*/ 26249 h 1588022"/>
                  <a:gd name="connsiteX1" fmla="*/ 482902 w 1684240"/>
                  <a:gd name="connsiteY1" fmla="*/ 198745 h 1588022"/>
                  <a:gd name="connsiteX2" fmla="*/ 332043 w 1684240"/>
                  <a:gd name="connsiteY2" fmla="*/ 262964 h 1588022"/>
                  <a:gd name="connsiteX3" fmla="*/ 4665 w 1684240"/>
                  <a:gd name="connsiteY3" fmla="*/ 545186 h 1588022"/>
                  <a:gd name="connsiteX4" fmla="*/ 151420 w 1684240"/>
                  <a:gd name="connsiteY4" fmla="*/ 1120920 h 1588022"/>
                  <a:gd name="connsiteX5" fmla="*/ 325300 w 1684240"/>
                  <a:gd name="connsiteY5" fmla="*/ 1296678 h 1588022"/>
                  <a:gd name="connsiteX6" fmla="*/ 591687 w 1684240"/>
                  <a:gd name="connsiteY6" fmla="*/ 1437009 h 1588022"/>
                  <a:gd name="connsiteX7" fmla="*/ 787950 w 1684240"/>
                  <a:gd name="connsiteY7" fmla="*/ 1465434 h 1588022"/>
                  <a:gd name="connsiteX8" fmla="*/ 927421 w 1684240"/>
                  <a:gd name="connsiteY8" fmla="*/ 1586462 h 1588022"/>
                  <a:gd name="connsiteX9" fmla="*/ 1189998 w 1684240"/>
                  <a:gd name="connsiteY9" fmla="*/ 1369275 h 1588022"/>
                  <a:gd name="connsiteX10" fmla="*/ 1325465 w 1684240"/>
                  <a:gd name="connsiteY10" fmla="*/ 1188653 h 1588022"/>
                  <a:gd name="connsiteX11" fmla="*/ 1675420 w 1684240"/>
                  <a:gd name="connsiteY11" fmla="*/ 951586 h 1588022"/>
                  <a:gd name="connsiteX12" fmla="*/ 1585109 w 1684240"/>
                  <a:gd name="connsiteY12" fmla="*/ 590342 h 1588022"/>
                  <a:gd name="connsiteX13" fmla="*/ 1652843 w 1684240"/>
                  <a:gd name="connsiteY13" fmla="*/ 217809 h 1588022"/>
                  <a:gd name="connsiteX14" fmla="*/ 1235154 w 1684240"/>
                  <a:gd name="connsiteY14" fmla="*/ 48475 h 1588022"/>
                  <a:gd name="connsiteX15" fmla="*/ 1041198 w 1684240"/>
                  <a:gd name="connsiteY15" fmla="*/ 35978 h 1588022"/>
                  <a:gd name="connsiteX0" fmla="*/ 528038 w 1684240"/>
                  <a:gd name="connsiteY0" fmla="*/ 26249 h 1488258"/>
                  <a:gd name="connsiteX1" fmla="*/ 482902 w 1684240"/>
                  <a:gd name="connsiteY1" fmla="*/ 198745 h 1488258"/>
                  <a:gd name="connsiteX2" fmla="*/ 332043 w 1684240"/>
                  <a:gd name="connsiteY2" fmla="*/ 262964 h 1488258"/>
                  <a:gd name="connsiteX3" fmla="*/ 4665 w 1684240"/>
                  <a:gd name="connsiteY3" fmla="*/ 545186 h 1488258"/>
                  <a:gd name="connsiteX4" fmla="*/ 151420 w 1684240"/>
                  <a:gd name="connsiteY4" fmla="*/ 1120920 h 1488258"/>
                  <a:gd name="connsiteX5" fmla="*/ 325300 w 1684240"/>
                  <a:gd name="connsiteY5" fmla="*/ 1296678 h 1488258"/>
                  <a:gd name="connsiteX6" fmla="*/ 591687 w 1684240"/>
                  <a:gd name="connsiteY6" fmla="*/ 1437009 h 1488258"/>
                  <a:gd name="connsiteX7" fmla="*/ 787950 w 1684240"/>
                  <a:gd name="connsiteY7" fmla="*/ 1465434 h 1488258"/>
                  <a:gd name="connsiteX8" fmla="*/ 984536 w 1684240"/>
                  <a:gd name="connsiteY8" fmla="*/ 1483142 h 1488258"/>
                  <a:gd name="connsiteX9" fmla="*/ 1189998 w 1684240"/>
                  <a:gd name="connsiteY9" fmla="*/ 1369275 h 1488258"/>
                  <a:gd name="connsiteX10" fmla="*/ 1325465 w 1684240"/>
                  <a:gd name="connsiteY10" fmla="*/ 1188653 h 1488258"/>
                  <a:gd name="connsiteX11" fmla="*/ 1675420 w 1684240"/>
                  <a:gd name="connsiteY11" fmla="*/ 951586 h 1488258"/>
                  <a:gd name="connsiteX12" fmla="*/ 1585109 w 1684240"/>
                  <a:gd name="connsiteY12" fmla="*/ 590342 h 1488258"/>
                  <a:gd name="connsiteX13" fmla="*/ 1652843 w 1684240"/>
                  <a:gd name="connsiteY13" fmla="*/ 217809 h 1488258"/>
                  <a:gd name="connsiteX14" fmla="*/ 1235154 w 1684240"/>
                  <a:gd name="connsiteY14" fmla="*/ 48475 h 1488258"/>
                  <a:gd name="connsiteX15" fmla="*/ 1041198 w 1684240"/>
                  <a:gd name="connsiteY15" fmla="*/ 35978 h 148825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1684240" h="1488258">
                    <a:moveTo>
                      <a:pt x="528038" y="26249"/>
                    </a:moveTo>
                    <a:cubicBezTo>
                      <a:pt x="388808" y="7434"/>
                      <a:pt x="515568" y="159293"/>
                      <a:pt x="482902" y="198745"/>
                    </a:cubicBezTo>
                    <a:cubicBezTo>
                      <a:pt x="450236" y="238198"/>
                      <a:pt x="411749" y="205224"/>
                      <a:pt x="332043" y="262964"/>
                    </a:cubicBezTo>
                    <a:cubicBezTo>
                      <a:pt x="252337" y="320704"/>
                      <a:pt x="34769" y="402193"/>
                      <a:pt x="4665" y="545186"/>
                    </a:cubicBezTo>
                    <a:cubicBezTo>
                      <a:pt x="-25439" y="688179"/>
                      <a:pt x="97981" y="995671"/>
                      <a:pt x="151420" y="1120920"/>
                    </a:cubicBezTo>
                    <a:cubicBezTo>
                      <a:pt x="204859" y="1246169"/>
                      <a:pt x="251922" y="1243996"/>
                      <a:pt x="325300" y="1296678"/>
                    </a:cubicBezTo>
                    <a:cubicBezTo>
                      <a:pt x="398678" y="1349360"/>
                      <a:pt x="514579" y="1408883"/>
                      <a:pt x="591687" y="1437009"/>
                    </a:cubicBezTo>
                    <a:cubicBezTo>
                      <a:pt x="668795" y="1465135"/>
                      <a:pt x="722475" y="1457745"/>
                      <a:pt x="787950" y="1465434"/>
                    </a:cubicBezTo>
                    <a:cubicBezTo>
                      <a:pt x="853425" y="1473123"/>
                      <a:pt x="917528" y="1499168"/>
                      <a:pt x="984536" y="1483142"/>
                    </a:cubicBezTo>
                    <a:cubicBezTo>
                      <a:pt x="1051544" y="1467116"/>
                      <a:pt x="1133177" y="1418356"/>
                      <a:pt x="1189998" y="1369275"/>
                    </a:cubicBezTo>
                    <a:cubicBezTo>
                      <a:pt x="1246819" y="1320194"/>
                      <a:pt x="1244561" y="1258268"/>
                      <a:pt x="1325465" y="1188653"/>
                    </a:cubicBezTo>
                    <a:cubicBezTo>
                      <a:pt x="1406369" y="1119038"/>
                      <a:pt x="1632146" y="1051304"/>
                      <a:pt x="1675420" y="951586"/>
                    </a:cubicBezTo>
                    <a:cubicBezTo>
                      <a:pt x="1718694" y="851868"/>
                      <a:pt x="1588872" y="712638"/>
                      <a:pt x="1585109" y="590342"/>
                    </a:cubicBezTo>
                    <a:cubicBezTo>
                      <a:pt x="1581346" y="468046"/>
                      <a:pt x="1705524" y="304357"/>
                      <a:pt x="1652843" y="217809"/>
                    </a:cubicBezTo>
                    <a:cubicBezTo>
                      <a:pt x="1600162" y="131261"/>
                      <a:pt x="1337095" y="78780"/>
                      <a:pt x="1235154" y="48475"/>
                    </a:cubicBezTo>
                    <a:cubicBezTo>
                      <a:pt x="1133213" y="18170"/>
                      <a:pt x="1088988" y="-36647"/>
                      <a:pt x="1041198" y="35978"/>
                    </a:cubicBezTo>
                  </a:path>
                </a:pathLst>
              </a:custGeom>
              <a:solidFill>
                <a:schemeClr val="bg1">
                  <a:lumMod val="85000"/>
                  <a:alpha val="48000"/>
                </a:schemeClr>
              </a:solidFill>
              <a:ln w="6350">
                <a:solidFill>
                  <a:schemeClr val="bg1">
                    <a:lumMod val="65000"/>
                  </a:schemeClr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21" name="Forme libre 420"/>
              <p:cNvSpPr/>
              <p:nvPr/>
            </p:nvSpPr>
            <p:spPr>
              <a:xfrm flipV="1">
                <a:off x="5563801" y="1182750"/>
                <a:ext cx="635212" cy="396366"/>
              </a:xfrm>
              <a:custGeom>
                <a:avLst/>
                <a:gdLst>
                  <a:gd name="connsiteX0" fmla="*/ 599693 w 1256584"/>
                  <a:gd name="connsiteY0" fmla="*/ 3208 h 826201"/>
                  <a:gd name="connsiteX1" fmla="*/ 80404 w 1256584"/>
                  <a:gd name="connsiteY1" fmla="*/ 138675 h 826201"/>
                  <a:gd name="connsiteX2" fmla="*/ 80404 w 1256584"/>
                  <a:gd name="connsiteY2" fmla="*/ 612808 h 826201"/>
                  <a:gd name="connsiteX3" fmla="*/ 836760 w 1256584"/>
                  <a:gd name="connsiteY3" fmla="*/ 816008 h 826201"/>
                  <a:gd name="connsiteX4" fmla="*/ 1209293 w 1256584"/>
                  <a:gd name="connsiteY4" fmla="*/ 736986 h 826201"/>
                  <a:gd name="connsiteX5" fmla="*/ 1186715 w 1256584"/>
                  <a:gd name="connsiteY5" fmla="*/ 240275 h 826201"/>
                  <a:gd name="connsiteX6" fmla="*/ 599693 w 1256584"/>
                  <a:gd name="connsiteY6" fmla="*/ 3208 h 826201"/>
                  <a:gd name="connsiteX0" fmla="*/ 599693 w 1256584"/>
                  <a:gd name="connsiteY0" fmla="*/ 3208 h 826201"/>
                  <a:gd name="connsiteX1" fmla="*/ 80404 w 1256584"/>
                  <a:gd name="connsiteY1" fmla="*/ 138675 h 826201"/>
                  <a:gd name="connsiteX2" fmla="*/ 80404 w 1256584"/>
                  <a:gd name="connsiteY2" fmla="*/ 612808 h 826201"/>
                  <a:gd name="connsiteX3" fmla="*/ 836760 w 1256584"/>
                  <a:gd name="connsiteY3" fmla="*/ 816008 h 826201"/>
                  <a:gd name="connsiteX4" fmla="*/ 1209293 w 1256584"/>
                  <a:gd name="connsiteY4" fmla="*/ 736986 h 826201"/>
                  <a:gd name="connsiteX5" fmla="*/ 1186715 w 1256584"/>
                  <a:gd name="connsiteY5" fmla="*/ 240275 h 826201"/>
                  <a:gd name="connsiteX6" fmla="*/ 747724 w 1256584"/>
                  <a:gd name="connsiteY6" fmla="*/ 152847 h 826201"/>
                  <a:gd name="connsiteX0" fmla="*/ 459650 w 1249388"/>
                  <a:gd name="connsiteY0" fmla="*/ 1488 h 920403"/>
                  <a:gd name="connsiteX1" fmla="*/ 73208 w 1249388"/>
                  <a:gd name="connsiteY1" fmla="*/ 232877 h 920403"/>
                  <a:gd name="connsiteX2" fmla="*/ 73208 w 1249388"/>
                  <a:gd name="connsiteY2" fmla="*/ 707010 h 920403"/>
                  <a:gd name="connsiteX3" fmla="*/ 829564 w 1249388"/>
                  <a:gd name="connsiteY3" fmla="*/ 910210 h 920403"/>
                  <a:gd name="connsiteX4" fmla="*/ 1202097 w 1249388"/>
                  <a:gd name="connsiteY4" fmla="*/ 831188 h 920403"/>
                  <a:gd name="connsiteX5" fmla="*/ 1179519 w 1249388"/>
                  <a:gd name="connsiteY5" fmla="*/ 334477 h 920403"/>
                  <a:gd name="connsiteX6" fmla="*/ 740528 w 1249388"/>
                  <a:gd name="connsiteY6" fmla="*/ 247049 h 920403"/>
                  <a:gd name="connsiteX0" fmla="*/ 459650 w 1247912"/>
                  <a:gd name="connsiteY0" fmla="*/ 1488 h 920403"/>
                  <a:gd name="connsiteX1" fmla="*/ 73208 w 1247912"/>
                  <a:gd name="connsiteY1" fmla="*/ 232877 h 920403"/>
                  <a:gd name="connsiteX2" fmla="*/ 73208 w 1247912"/>
                  <a:gd name="connsiteY2" fmla="*/ 707010 h 920403"/>
                  <a:gd name="connsiteX3" fmla="*/ 829564 w 1247912"/>
                  <a:gd name="connsiteY3" fmla="*/ 910210 h 920403"/>
                  <a:gd name="connsiteX4" fmla="*/ 1202097 w 1247912"/>
                  <a:gd name="connsiteY4" fmla="*/ 831188 h 920403"/>
                  <a:gd name="connsiteX5" fmla="*/ 1179519 w 1247912"/>
                  <a:gd name="connsiteY5" fmla="*/ 334477 h 920403"/>
                  <a:gd name="connsiteX6" fmla="*/ 639311 w 1247912"/>
                  <a:gd name="connsiteY6" fmla="*/ 119153 h 920403"/>
                  <a:gd name="connsiteX0" fmla="*/ 459650 w 1247912"/>
                  <a:gd name="connsiteY0" fmla="*/ 1488 h 920403"/>
                  <a:gd name="connsiteX1" fmla="*/ 73208 w 1247912"/>
                  <a:gd name="connsiteY1" fmla="*/ 232877 h 920403"/>
                  <a:gd name="connsiteX2" fmla="*/ 73208 w 1247912"/>
                  <a:gd name="connsiteY2" fmla="*/ 707010 h 920403"/>
                  <a:gd name="connsiteX3" fmla="*/ 829564 w 1247912"/>
                  <a:gd name="connsiteY3" fmla="*/ 910210 h 920403"/>
                  <a:gd name="connsiteX4" fmla="*/ 1202097 w 1247912"/>
                  <a:gd name="connsiteY4" fmla="*/ 831188 h 920403"/>
                  <a:gd name="connsiteX5" fmla="*/ 1179519 w 1247912"/>
                  <a:gd name="connsiteY5" fmla="*/ 334477 h 920403"/>
                  <a:gd name="connsiteX6" fmla="*/ 639311 w 1247912"/>
                  <a:gd name="connsiteY6" fmla="*/ 74389 h 920403"/>
                  <a:gd name="connsiteX0" fmla="*/ 148590 w 1234181"/>
                  <a:gd name="connsiteY0" fmla="*/ 762 h 1085943"/>
                  <a:gd name="connsiteX1" fmla="*/ 59477 w 1234181"/>
                  <a:gd name="connsiteY1" fmla="*/ 398417 h 1085943"/>
                  <a:gd name="connsiteX2" fmla="*/ 59477 w 1234181"/>
                  <a:gd name="connsiteY2" fmla="*/ 872550 h 1085943"/>
                  <a:gd name="connsiteX3" fmla="*/ 815833 w 1234181"/>
                  <a:gd name="connsiteY3" fmla="*/ 1075750 h 1085943"/>
                  <a:gd name="connsiteX4" fmla="*/ 1188366 w 1234181"/>
                  <a:gd name="connsiteY4" fmla="*/ 996728 h 1085943"/>
                  <a:gd name="connsiteX5" fmla="*/ 1165788 w 1234181"/>
                  <a:gd name="connsiteY5" fmla="*/ 500017 h 1085943"/>
                  <a:gd name="connsiteX6" fmla="*/ 625580 w 1234181"/>
                  <a:gd name="connsiteY6" fmla="*/ 239929 h 1085943"/>
                  <a:gd name="connsiteX0" fmla="*/ 148588 w 1226891"/>
                  <a:gd name="connsiteY0" fmla="*/ 8665 h 1093846"/>
                  <a:gd name="connsiteX1" fmla="*/ 59475 w 1226891"/>
                  <a:gd name="connsiteY1" fmla="*/ 406320 h 1093846"/>
                  <a:gd name="connsiteX2" fmla="*/ 59475 w 1226891"/>
                  <a:gd name="connsiteY2" fmla="*/ 880453 h 1093846"/>
                  <a:gd name="connsiteX3" fmla="*/ 815831 w 1226891"/>
                  <a:gd name="connsiteY3" fmla="*/ 1083653 h 1093846"/>
                  <a:gd name="connsiteX4" fmla="*/ 1188364 w 1226891"/>
                  <a:gd name="connsiteY4" fmla="*/ 1004631 h 1093846"/>
                  <a:gd name="connsiteX5" fmla="*/ 1165786 w 1226891"/>
                  <a:gd name="connsiteY5" fmla="*/ 507920 h 1093846"/>
                  <a:gd name="connsiteX6" fmla="*/ 752101 w 1226891"/>
                  <a:gd name="connsiteY6" fmla="*/ 24012 h 1093846"/>
                  <a:gd name="connsiteX0" fmla="*/ 113876 w 1192177"/>
                  <a:gd name="connsiteY0" fmla="*/ 8665 h 1099563"/>
                  <a:gd name="connsiteX1" fmla="*/ 24763 w 1192177"/>
                  <a:gd name="connsiteY1" fmla="*/ 406320 h 1099563"/>
                  <a:gd name="connsiteX2" fmla="*/ 75114 w 1192177"/>
                  <a:gd name="connsiteY2" fmla="*/ 802789 h 1099563"/>
                  <a:gd name="connsiteX3" fmla="*/ 781119 w 1192177"/>
                  <a:gd name="connsiteY3" fmla="*/ 1083653 h 1099563"/>
                  <a:gd name="connsiteX4" fmla="*/ 1153652 w 1192177"/>
                  <a:gd name="connsiteY4" fmla="*/ 1004631 h 1099563"/>
                  <a:gd name="connsiteX5" fmla="*/ 1131074 w 1192177"/>
                  <a:gd name="connsiteY5" fmla="*/ 507920 h 1099563"/>
                  <a:gd name="connsiteX6" fmla="*/ 717389 w 1192177"/>
                  <a:gd name="connsiteY6" fmla="*/ 24012 h 1099563"/>
                  <a:gd name="connsiteX0" fmla="*/ 113874 w 1192177"/>
                  <a:gd name="connsiteY0" fmla="*/ 6763 h 1082787"/>
                  <a:gd name="connsiteX1" fmla="*/ 24761 w 1192177"/>
                  <a:gd name="connsiteY1" fmla="*/ 404418 h 1082787"/>
                  <a:gd name="connsiteX2" fmla="*/ 75112 w 1192177"/>
                  <a:gd name="connsiteY2" fmla="*/ 800887 h 1082787"/>
                  <a:gd name="connsiteX3" fmla="*/ 781117 w 1192177"/>
                  <a:gd name="connsiteY3" fmla="*/ 1081751 h 1082787"/>
                  <a:gd name="connsiteX4" fmla="*/ 1153650 w 1192177"/>
                  <a:gd name="connsiteY4" fmla="*/ 701779 h 1082787"/>
                  <a:gd name="connsiteX5" fmla="*/ 1131072 w 1192177"/>
                  <a:gd name="connsiteY5" fmla="*/ 506018 h 1082787"/>
                  <a:gd name="connsiteX6" fmla="*/ 717387 w 1192177"/>
                  <a:gd name="connsiteY6" fmla="*/ 22110 h 1082787"/>
                  <a:gd name="connsiteX0" fmla="*/ 113874 w 1192175"/>
                  <a:gd name="connsiteY0" fmla="*/ 6763 h 986418"/>
                  <a:gd name="connsiteX1" fmla="*/ 24761 w 1192175"/>
                  <a:gd name="connsiteY1" fmla="*/ 404418 h 986418"/>
                  <a:gd name="connsiteX2" fmla="*/ 75112 w 1192175"/>
                  <a:gd name="connsiteY2" fmla="*/ 800887 h 986418"/>
                  <a:gd name="connsiteX3" fmla="*/ 781116 w 1192175"/>
                  <a:gd name="connsiteY3" fmla="*/ 984670 h 986418"/>
                  <a:gd name="connsiteX4" fmla="*/ 1153650 w 1192175"/>
                  <a:gd name="connsiteY4" fmla="*/ 701779 h 986418"/>
                  <a:gd name="connsiteX5" fmla="*/ 1131072 w 1192175"/>
                  <a:gd name="connsiteY5" fmla="*/ 506018 h 986418"/>
                  <a:gd name="connsiteX6" fmla="*/ 717387 w 1192175"/>
                  <a:gd name="connsiteY6" fmla="*/ 22110 h 9864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192175" h="986418">
                    <a:moveTo>
                      <a:pt x="113874" y="6763"/>
                    </a:moveTo>
                    <a:cubicBezTo>
                      <a:pt x="-70511" y="-10170"/>
                      <a:pt x="31221" y="272064"/>
                      <a:pt x="24761" y="404418"/>
                    </a:cubicBezTo>
                    <a:cubicBezTo>
                      <a:pt x="18301" y="536772"/>
                      <a:pt x="-50947" y="704178"/>
                      <a:pt x="75112" y="800887"/>
                    </a:cubicBezTo>
                    <a:cubicBezTo>
                      <a:pt x="201171" y="897596"/>
                      <a:pt x="601360" y="1001188"/>
                      <a:pt x="781116" y="984670"/>
                    </a:cubicBezTo>
                    <a:cubicBezTo>
                      <a:pt x="960872" y="968152"/>
                      <a:pt x="1095324" y="797734"/>
                      <a:pt x="1153650" y="701779"/>
                    </a:cubicBezTo>
                    <a:cubicBezTo>
                      <a:pt x="1211976" y="605824"/>
                      <a:pt x="1203782" y="619296"/>
                      <a:pt x="1131072" y="506018"/>
                    </a:cubicBezTo>
                    <a:cubicBezTo>
                      <a:pt x="1058362" y="392740"/>
                      <a:pt x="753741" y="-110596"/>
                      <a:pt x="717387" y="22110"/>
                    </a:cubicBezTo>
                  </a:path>
                </a:pathLst>
              </a:custGeom>
              <a:solidFill>
                <a:schemeClr val="bg1">
                  <a:lumMod val="85000"/>
                  <a:alpha val="52000"/>
                </a:schemeClr>
              </a:solidFill>
              <a:ln w="9525">
                <a:solidFill>
                  <a:srgbClr val="548235">
                    <a:alpha val="50980"/>
                  </a:srgb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414" name="Image 41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2151359">
              <a:off x="5407082" y="1461073"/>
              <a:ext cx="91742" cy="119901"/>
            </a:xfrm>
            <a:prstGeom prst="rect">
              <a:avLst/>
            </a:prstGeom>
          </p:spPr>
        </p:pic>
        <p:pic>
          <p:nvPicPr>
            <p:cNvPr id="415" name="Image 41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318513" y="1497604"/>
              <a:ext cx="91742" cy="119901"/>
            </a:xfrm>
            <a:prstGeom prst="rect">
              <a:avLst/>
            </a:prstGeom>
          </p:spPr>
        </p:pic>
        <p:pic>
          <p:nvPicPr>
            <p:cNvPr id="416" name="Image 41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5130222">
              <a:off x="5394900" y="1854743"/>
              <a:ext cx="91742" cy="119901"/>
            </a:xfrm>
            <a:prstGeom prst="rect">
              <a:avLst/>
            </a:prstGeom>
          </p:spPr>
        </p:pic>
        <p:pic>
          <p:nvPicPr>
            <p:cNvPr id="417" name="Image 41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7210582">
              <a:off x="5543627" y="1632752"/>
              <a:ext cx="91742" cy="119901"/>
            </a:xfrm>
            <a:prstGeom prst="rect">
              <a:avLst/>
            </a:prstGeom>
          </p:spPr>
        </p:pic>
        <p:pic>
          <p:nvPicPr>
            <p:cNvPr id="418" name="Image 41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2997101">
              <a:off x="5474423" y="1884465"/>
              <a:ext cx="91742" cy="119901"/>
            </a:xfrm>
            <a:prstGeom prst="rect">
              <a:avLst/>
            </a:prstGeom>
          </p:spPr>
        </p:pic>
        <p:pic>
          <p:nvPicPr>
            <p:cNvPr id="419" name="Image 41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0800000">
              <a:off x="5531869" y="1817562"/>
              <a:ext cx="91742" cy="119901"/>
            </a:xfrm>
            <a:prstGeom prst="rect">
              <a:avLst/>
            </a:prstGeom>
          </p:spPr>
        </p:pic>
      </p:grpSp>
      <p:sp>
        <p:nvSpPr>
          <p:cNvPr id="104" name="ZoneTexte 103"/>
          <p:cNvSpPr txBox="1"/>
          <p:nvPr/>
        </p:nvSpPr>
        <p:spPr>
          <a:xfrm>
            <a:off x="0" y="9652084"/>
            <a:ext cx="13340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/>
              <a:t>Fig. S4. Rosazza et al.</a:t>
            </a:r>
            <a:endParaRPr lang="fr-FR" sz="1050" dirty="0"/>
          </a:p>
        </p:txBody>
      </p:sp>
      <p:cxnSp>
        <p:nvCxnSpPr>
          <p:cNvPr id="105" name="Connecteur droit 104"/>
          <p:cNvCxnSpPr/>
          <p:nvPr/>
        </p:nvCxnSpPr>
        <p:spPr>
          <a:xfrm>
            <a:off x="4308682" y="3309204"/>
            <a:ext cx="180000" cy="0"/>
          </a:xfrm>
          <a:prstGeom prst="line">
            <a:avLst/>
          </a:prstGeom>
          <a:ln w="12700">
            <a:solidFill>
              <a:srgbClr val="548235">
                <a:alpha val="50196"/>
              </a:srgb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526284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25400">
          <a:solidFill>
            <a:schemeClr val="bg1">
              <a:lumMod val="65000"/>
            </a:schemeClr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27</TotalTime>
  <Words>46</Words>
  <Application>Microsoft Office PowerPoint</Application>
  <PresentationFormat>Format A4 (210 x 297 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ibault</dc:creator>
  <cp:lastModifiedBy>parsig</cp:lastModifiedBy>
  <cp:revision>780</cp:revision>
  <cp:lastPrinted>2019-11-25T10:06:23Z</cp:lastPrinted>
  <dcterms:created xsi:type="dcterms:W3CDTF">2018-10-17T14:04:28Z</dcterms:created>
  <dcterms:modified xsi:type="dcterms:W3CDTF">2019-12-10T12:21:21Z</dcterms:modified>
</cp:coreProperties>
</file>